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1600" y="744120"/>
            <a:ext cx="2793960" cy="3724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2F9F90-F732-4D2E-8B35-D56A460D9355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PlaceHolder 1"/>
          <p:cNvSpPr>
            <a:spLocks noGrp="1"/>
          </p:cNvSpPr>
          <p:nvPr>
            <p:ph type="sldImg"/>
          </p:nvPr>
        </p:nvSpPr>
        <p:spPr>
          <a:xfrm>
            <a:off x="2001960" y="744480"/>
            <a:ext cx="2793960" cy="3724200"/>
          </a:xfrm>
          <a:prstGeom prst="rect">
            <a:avLst/>
          </a:prstGeom>
          <a:ln w="0">
            <a:noFill/>
          </a:ln>
        </p:spPr>
      </p:sp>
      <p:sp>
        <p:nvSpPr>
          <p:cNvPr id="223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Slide Number Placehold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342008-BDF9-4071-BA1D-1CDFA5B906D8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7DBD4-3A52-4443-836F-363402CBCF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C4576-1896-475B-92C4-C321844855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D43ED-7D41-44F8-ABD5-D6E2B502BE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DAA21-DF0F-4E23-8A4D-83B96F5187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8BE65-6A61-43F7-B731-5877B80D97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D3C36-D35D-4D09-8FCC-75A908F058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D07BE-E229-4FC9-9650-BFEFD1CE11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F83DF7-47F2-4EFC-A71F-D75329FF9A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C23B3-D919-4A69-9CFF-27F63DA7E7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DBE09-B794-416C-ACEF-532383AC5A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A1A364-24E8-44F9-B39E-4A77BDBE0F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0F6F0E-89EB-4E43-A6CD-6480995D92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7FB0EB-19BC-4BE0-8E7B-DB7043F3B867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75"/>
          <p:cNvGrpSpPr/>
          <p:nvPr/>
        </p:nvGrpSpPr>
        <p:grpSpPr>
          <a:xfrm>
            <a:off x="1557360" y="3203640"/>
            <a:ext cx="3924360" cy="5115240"/>
            <a:chOff x="1557360" y="3203640"/>
            <a:chExt cx="3924360" cy="5115240"/>
          </a:xfrm>
        </p:grpSpPr>
        <p:grpSp>
          <p:nvGrpSpPr>
            <p:cNvPr id="49" name="Group 322"/>
            <p:cNvGrpSpPr/>
            <p:nvPr/>
          </p:nvGrpSpPr>
          <p:grpSpPr>
            <a:xfrm>
              <a:off x="1557360" y="3203640"/>
              <a:ext cx="3924360" cy="5115240"/>
              <a:chOff x="1557360" y="3203640"/>
              <a:chExt cx="3924360" cy="5115240"/>
            </a:xfrm>
          </p:grpSpPr>
          <p:grpSp>
            <p:nvGrpSpPr>
              <p:cNvPr id="50" name="Group 320"/>
              <p:cNvGrpSpPr/>
              <p:nvPr/>
            </p:nvGrpSpPr>
            <p:grpSpPr>
              <a:xfrm>
                <a:off x="1716120" y="3203640"/>
                <a:ext cx="3765600" cy="2042280"/>
                <a:chOff x="1716120" y="3203640"/>
                <a:chExt cx="3765600" cy="2042280"/>
              </a:xfrm>
            </p:grpSpPr>
            <p:grpSp>
              <p:nvGrpSpPr>
                <p:cNvPr id="51" name="Group 5"/>
                <p:cNvGrpSpPr/>
                <p:nvPr/>
              </p:nvGrpSpPr>
              <p:grpSpPr>
                <a:xfrm>
                  <a:off x="3761640" y="3521160"/>
                  <a:ext cx="1720080" cy="1712880"/>
                  <a:chOff x="3761640" y="3521160"/>
                  <a:chExt cx="1720080" cy="1712880"/>
                </a:xfrm>
              </p:grpSpPr>
              <p:sp>
                <p:nvSpPr>
                  <p:cNvPr id="52" name="Rectangle 6"/>
                  <p:cNvSpPr/>
                  <p:nvPr/>
                </p:nvSpPr>
                <p:spPr>
                  <a:xfrm>
                    <a:off x="3771720" y="3521160"/>
                    <a:ext cx="1710000" cy="152604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53" name="Group 7"/>
                  <p:cNvGrpSpPr/>
                  <p:nvPr/>
                </p:nvGrpSpPr>
                <p:grpSpPr>
                  <a:xfrm>
                    <a:off x="3771720" y="4358160"/>
                    <a:ext cx="1406520" cy="700200"/>
                    <a:chOff x="3771720" y="4358160"/>
                    <a:chExt cx="1406520" cy="700200"/>
                  </a:xfrm>
                </p:grpSpPr>
                <p:sp>
                  <p:nvSpPr>
                    <p:cNvPr id="54" name="Line 8"/>
                    <p:cNvSpPr/>
                    <p:nvPr/>
                  </p:nvSpPr>
                  <p:spPr>
                    <a:xfrm>
                      <a:off x="3771720" y="4358160"/>
                      <a:ext cx="720" cy="3528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520" bIns="-11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" name="Line 9"/>
                    <p:cNvSpPr/>
                    <p:nvPr/>
                  </p:nvSpPr>
                  <p:spPr>
                    <a:xfrm>
                      <a:off x="3837960" y="438768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" name="Line 10"/>
                    <p:cNvSpPr/>
                    <p:nvPr/>
                  </p:nvSpPr>
                  <p:spPr>
                    <a:xfrm>
                      <a:off x="3909960" y="442332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" name="Line 11"/>
                    <p:cNvSpPr/>
                    <p:nvPr/>
                  </p:nvSpPr>
                  <p:spPr>
                    <a:xfrm>
                      <a:off x="3983040" y="4457880"/>
                      <a:ext cx="720" cy="122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560" bIns="-345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" name="Line 12"/>
                    <p:cNvSpPr/>
                    <p:nvPr/>
                  </p:nvSpPr>
                  <p:spPr>
                    <a:xfrm>
                      <a:off x="4048560" y="4487400"/>
                      <a:ext cx="720" cy="3528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520" bIns="-11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" name="Line 13"/>
                    <p:cNvSpPr/>
                    <p:nvPr/>
                  </p:nvSpPr>
                  <p:spPr>
                    <a:xfrm>
                      <a:off x="4121640" y="452304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" name="Line 14"/>
                    <p:cNvSpPr/>
                    <p:nvPr/>
                  </p:nvSpPr>
                  <p:spPr>
                    <a:xfrm>
                      <a:off x="4194720" y="455832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" name="Line 15"/>
                    <p:cNvSpPr/>
                    <p:nvPr/>
                  </p:nvSpPr>
                  <p:spPr>
                    <a:xfrm>
                      <a:off x="4260240" y="458820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" name="Line 16"/>
                    <p:cNvSpPr/>
                    <p:nvPr/>
                  </p:nvSpPr>
                  <p:spPr>
                    <a:xfrm>
                      <a:off x="4333320" y="4623480"/>
                      <a:ext cx="1080" cy="342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2600" bIns="-12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" name="Line 17"/>
                    <p:cNvSpPr/>
                    <p:nvPr/>
                  </p:nvSpPr>
                  <p:spPr>
                    <a:xfrm>
                      <a:off x="4405320" y="4658040"/>
                      <a:ext cx="720" cy="122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560" bIns="-345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" name="Line 18"/>
                    <p:cNvSpPr/>
                    <p:nvPr/>
                  </p:nvSpPr>
                  <p:spPr>
                    <a:xfrm>
                      <a:off x="4471920" y="468756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" name="Line 19"/>
                    <p:cNvSpPr/>
                    <p:nvPr/>
                  </p:nvSpPr>
                  <p:spPr>
                    <a:xfrm>
                      <a:off x="4543920" y="472320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" name="Line 20"/>
                    <p:cNvSpPr/>
                    <p:nvPr/>
                  </p:nvSpPr>
                  <p:spPr>
                    <a:xfrm>
                      <a:off x="4616640" y="4758840"/>
                      <a:ext cx="1080" cy="3528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520" bIns="-11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" name="Line 21"/>
                    <p:cNvSpPr/>
                    <p:nvPr/>
                  </p:nvSpPr>
                  <p:spPr>
                    <a:xfrm>
                      <a:off x="4689720" y="479412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" name="Line 22"/>
                    <p:cNvSpPr/>
                    <p:nvPr/>
                  </p:nvSpPr>
                  <p:spPr>
                    <a:xfrm>
                      <a:off x="4755240" y="482364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" name="Line 23"/>
                    <p:cNvSpPr/>
                    <p:nvPr/>
                  </p:nvSpPr>
                  <p:spPr>
                    <a:xfrm>
                      <a:off x="4828320" y="4858200"/>
                      <a:ext cx="1080" cy="126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200" bIns="-342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" name="Line 24"/>
                    <p:cNvSpPr/>
                    <p:nvPr/>
                  </p:nvSpPr>
                  <p:spPr>
                    <a:xfrm>
                      <a:off x="4900320" y="4893840"/>
                      <a:ext cx="720" cy="356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160" bIns="-111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1" name="Line 25"/>
                    <p:cNvSpPr/>
                    <p:nvPr/>
                  </p:nvSpPr>
                  <p:spPr>
                    <a:xfrm>
                      <a:off x="4966920" y="492336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2" name="Line 26"/>
                    <p:cNvSpPr/>
                    <p:nvPr/>
                  </p:nvSpPr>
                  <p:spPr>
                    <a:xfrm>
                      <a:off x="5038560" y="495900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" name="Line 27"/>
                    <p:cNvSpPr/>
                    <p:nvPr/>
                  </p:nvSpPr>
                  <p:spPr>
                    <a:xfrm>
                      <a:off x="5111640" y="499428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" name="Line 28"/>
                    <p:cNvSpPr/>
                    <p:nvPr/>
                  </p:nvSpPr>
                  <p:spPr>
                    <a:xfrm>
                      <a:off x="5177160" y="5024160"/>
                      <a:ext cx="1080" cy="342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2600" bIns="-12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75" name="Group 29"/>
                  <p:cNvGrpSpPr/>
                  <p:nvPr/>
                </p:nvGrpSpPr>
                <p:grpSpPr>
                  <a:xfrm>
                    <a:off x="3761640" y="4427640"/>
                    <a:ext cx="1621440" cy="806400"/>
                    <a:chOff x="3761640" y="4427640"/>
                    <a:chExt cx="1621440" cy="806400"/>
                  </a:xfrm>
                </p:grpSpPr>
                <p:sp>
                  <p:nvSpPr>
                    <p:cNvPr id="76" name="Rectangle 30"/>
                    <p:cNvSpPr/>
                    <p:nvPr/>
                  </p:nvSpPr>
                  <p:spPr>
                    <a:xfrm>
                      <a:off x="3761640" y="4427640"/>
                      <a:ext cx="648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" name="Rectangle 31"/>
                    <p:cNvSpPr/>
                    <p:nvPr/>
                  </p:nvSpPr>
                  <p:spPr>
                    <a:xfrm>
                      <a:off x="4014000" y="4556880"/>
                      <a:ext cx="1926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" name="Rectangle 32"/>
                    <p:cNvSpPr/>
                    <p:nvPr/>
                  </p:nvSpPr>
                  <p:spPr>
                    <a:xfrm>
                      <a:off x="4296600" y="4691880"/>
                      <a:ext cx="1926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" name="Rectangle 33"/>
                    <p:cNvSpPr/>
                    <p:nvPr/>
                  </p:nvSpPr>
                  <p:spPr>
                    <a:xfrm>
                      <a:off x="4581000" y="4827240"/>
                      <a:ext cx="1926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" name="Rectangle 34"/>
                    <p:cNvSpPr/>
                    <p:nvPr/>
                  </p:nvSpPr>
                  <p:spPr>
                    <a:xfrm>
                      <a:off x="4865760" y="4964400"/>
                      <a:ext cx="1926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1" name="Rectangle 35"/>
                    <p:cNvSpPr/>
                    <p:nvPr/>
                  </p:nvSpPr>
                  <p:spPr>
                    <a:xfrm>
                      <a:off x="5126400" y="5096520"/>
                      <a:ext cx="25668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82" name="Group 36"/>
                  <p:cNvGrpSpPr/>
                  <p:nvPr/>
                </p:nvGrpSpPr>
                <p:grpSpPr>
                  <a:xfrm>
                    <a:off x="3784320" y="4127760"/>
                    <a:ext cx="1637280" cy="889200"/>
                    <a:chOff x="3784320" y="4127760"/>
                    <a:chExt cx="1637280" cy="889200"/>
                  </a:xfrm>
                </p:grpSpPr>
                <p:sp>
                  <p:nvSpPr>
                    <p:cNvPr id="83" name="Line 37"/>
                    <p:cNvSpPr/>
                    <p:nvPr/>
                  </p:nvSpPr>
                  <p:spPr>
                    <a:xfrm flipV="1">
                      <a:off x="3784320" y="412776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" name="Line 38"/>
                    <p:cNvSpPr/>
                    <p:nvPr/>
                  </p:nvSpPr>
                  <p:spPr>
                    <a:xfrm flipV="1">
                      <a:off x="3850560" y="4157280"/>
                      <a:ext cx="25776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" name="Line 39"/>
                    <p:cNvSpPr/>
                    <p:nvPr/>
                  </p:nvSpPr>
                  <p:spPr>
                    <a:xfrm flipV="1">
                      <a:off x="3916080" y="4186800"/>
                      <a:ext cx="25776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" name="Line 40"/>
                    <p:cNvSpPr/>
                    <p:nvPr/>
                  </p:nvSpPr>
                  <p:spPr>
                    <a:xfrm flipV="1">
                      <a:off x="3989160" y="4221360"/>
                      <a:ext cx="25776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" name="Line 41"/>
                    <p:cNvSpPr/>
                    <p:nvPr/>
                  </p:nvSpPr>
                  <p:spPr>
                    <a:xfrm flipV="1">
                      <a:off x="4054680" y="4256640"/>
                      <a:ext cx="257400" cy="23004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" name="Line 42"/>
                    <p:cNvSpPr/>
                    <p:nvPr/>
                  </p:nvSpPr>
                  <p:spPr>
                    <a:xfrm flipV="1">
                      <a:off x="4127760" y="428688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" name="Line 43"/>
                    <p:cNvSpPr/>
                    <p:nvPr/>
                  </p:nvSpPr>
                  <p:spPr>
                    <a:xfrm flipV="1">
                      <a:off x="4194360" y="4321800"/>
                      <a:ext cx="256680" cy="23004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0" name="Line 44"/>
                    <p:cNvSpPr/>
                    <p:nvPr/>
                  </p:nvSpPr>
                  <p:spPr>
                    <a:xfrm flipV="1">
                      <a:off x="4266360" y="4357080"/>
                      <a:ext cx="257400" cy="23004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" name="Line 45"/>
                    <p:cNvSpPr/>
                    <p:nvPr/>
                  </p:nvSpPr>
                  <p:spPr>
                    <a:xfrm flipV="1">
                      <a:off x="4332960" y="4387320"/>
                      <a:ext cx="256680" cy="22896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" name="Line 46"/>
                    <p:cNvSpPr/>
                    <p:nvPr/>
                  </p:nvSpPr>
                  <p:spPr>
                    <a:xfrm flipV="1">
                      <a:off x="4404960" y="4422960"/>
                      <a:ext cx="25740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" name="Line 47"/>
                    <p:cNvSpPr/>
                    <p:nvPr/>
                  </p:nvSpPr>
                  <p:spPr>
                    <a:xfrm flipV="1">
                      <a:off x="4471560" y="4451040"/>
                      <a:ext cx="256680" cy="23004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" name="Line 48"/>
                    <p:cNvSpPr/>
                    <p:nvPr/>
                  </p:nvSpPr>
                  <p:spPr>
                    <a:xfrm flipV="1">
                      <a:off x="4543560" y="448704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" name="Line 49"/>
                    <p:cNvSpPr/>
                    <p:nvPr/>
                  </p:nvSpPr>
                  <p:spPr>
                    <a:xfrm flipV="1">
                      <a:off x="4609800" y="452268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" name="Line 50"/>
                    <p:cNvSpPr/>
                    <p:nvPr/>
                  </p:nvSpPr>
                  <p:spPr>
                    <a:xfrm flipV="1">
                      <a:off x="4681800" y="4557960"/>
                      <a:ext cx="25776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" name="Line 51"/>
                    <p:cNvSpPr/>
                    <p:nvPr/>
                  </p:nvSpPr>
                  <p:spPr>
                    <a:xfrm flipV="1">
                      <a:off x="4748400" y="4587840"/>
                      <a:ext cx="25740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" name="Line 52"/>
                    <p:cNvSpPr/>
                    <p:nvPr/>
                  </p:nvSpPr>
                  <p:spPr>
                    <a:xfrm flipV="1">
                      <a:off x="4821480" y="4623480"/>
                      <a:ext cx="25668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" name="Line 53"/>
                    <p:cNvSpPr/>
                    <p:nvPr/>
                  </p:nvSpPr>
                  <p:spPr>
                    <a:xfrm flipV="1">
                      <a:off x="4887000" y="465192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0" name="Line 54"/>
                    <p:cNvSpPr/>
                    <p:nvPr/>
                  </p:nvSpPr>
                  <p:spPr>
                    <a:xfrm flipV="1">
                      <a:off x="4960080" y="4687200"/>
                      <a:ext cx="256320" cy="23004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" name="Line 55"/>
                    <p:cNvSpPr/>
                    <p:nvPr/>
                  </p:nvSpPr>
                  <p:spPr>
                    <a:xfrm flipV="1">
                      <a:off x="5025600" y="471708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" name="Line 56"/>
                    <p:cNvSpPr/>
                    <p:nvPr/>
                  </p:nvSpPr>
                  <p:spPr>
                    <a:xfrm flipV="1">
                      <a:off x="5098320" y="4752720"/>
                      <a:ext cx="25668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" name="Line 57"/>
                    <p:cNvSpPr/>
                    <p:nvPr/>
                  </p:nvSpPr>
                  <p:spPr>
                    <a:xfrm flipV="1">
                      <a:off x="5163840" y="4788000"/>
                      <a:ext cx="257760" cy="22896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04" name="Group 58"/>
                  <p:cNvGrpSpPr/>
                  <p:nvPr/>
                </p:nvGrpSpPr>
                <p:grpSpPr>
                  <a:xfrm>
                    <a:off x="4042080" y="3685680"/>
                    <a:ext cx="1419840" cy="1119600"/>
                    <a:chOff x="4042080" y="3685680"/>
                    <a:chExt cx="1419840" cy="1119600"/>
                  </a:xfrm>
                </p:grpSpPr>
                <p:sp>
                  <p:nvSpPr>
                    <p:cNvPr id="105" name="Line 59"/>
                    <p:cNvSpPr/>
                    <p:nvPr/>
                  </p:nvSpPr>
                  <p:spPr>
                    <a:xfrm>
                      <a:off x="4042080" y="4127400"/>
                      <a:ext cx="1419840" cy="677520"/>
                    </a:xfrm>
                    <a:prstGeom prst="line">
                      <a:avLst/>
                    </a:prstGeom>
                    <a:ln w="9360">
                      <a:solidFill>
                        <a:srgbClr val="88888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106" name="Group 60"/>
                    <p:cNvGrpSpPr/>
                    <p:nvPr/>
                  </p:nvGrpSpPr>
                  <p:grpSpPr>
                    <a:xfrm>
                      <a:off x="4042080" y="3685680"/>
                      <a:ext cx="1419840" cy="1119600"/>
                      <a:chOff x="4042080" y="3685680"/>
                      <a:chExt cx="1419840" cy="1119600"/>
                    </a:xfrm>
                  </p:grpSpPr>
                  <p:sp>
                    <p:nvSpPr>
                      <p:cNvPr id="107" name="Freeform 61"/>
                      <p:cNvSpPr/>
                      <p:nvPr/>
                    </p:nvSpPr>
                    <p:spPr>
                      <a:xfrm>
                        <a:off x="4042080" y="3685680"/>
                        <a:ext cx="1419840" cy="1119600"/>
                      </a:xfrm>
                      <a:custGeom>
                        <a:avLst/>
                        <a:gdLst>
                          <a:gd name="textAreaLeft" fmla="*/ 0 w 1419840"/>
                          <a:gd name="textAreaRight" fmla="*/ 1420200 w 1419840"/>
                          <a:gd name="textAreaTop" fmla="*/ 0 h 1119600"/>
                          <a:gd name="textAreaBottom" fmla="*/ 1119600 h 1119600"/>
                        </a:gdLst>
                        <a:ahLst/>
                        <a:rect l="textAreaLeft" t="textAreaTop" r="textAreaRight" b="textAreaBottom"/>
                        <a:pathLst>
                          <a:path w="1322" h="1168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2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80"/>
                            </a:lnTo>
                            <a:lnTo>
                              <a:pt x="37" y="480"/>
                            </a:lnTo>
                            <a:lnTo>
                              <a:pt x="43" y="486"/>
                            </a:lnTo>
                            <a:lnTo>
                              <a:pt x="49" y="486"/>
                            </a:lnTo>
                            <a:lnTo>
                              <a:pt x="56" y="486"/>
                            </a:lnTo>
                            <a:lnTo>
                              <a:pt x="62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9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3"/>
                            </a:lnTo>
                            <a:lnTo>
                              <a:pt x="123" y="523"/>
                            </a:lnTo>
                            <a:lnTo>
                              <a:pt x="123" y="529"/>
                            </a:lnTo>
                            <a:lnTo>
                              <a:pt x="129" y="529"/>
                            </a:lnTo>
                            <a:lnTo>
                              <a:pt x="135" y="535"/>
                            </a:lnTo>
                            <a:lnTo>
                              <a:pt x="142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53"/>
                            </a:lnTo>
                            <a:lnTo>
                              <a:pt x="178" y="553"/>
                            </a:lnTo>
                            <a:lnTo>
                              <a:pt x="185" y="553"/>
                            </a:lnTo>
                            <a:lnTo>
                              <a:pt x="191" y="559"/>
                            </a:lnTo>
                            <a:lnTo>
                              <a:pt x="197" y="566"/>
                            </a:lnTo>
                            <a:lnTo>
                              <a:pt x="203" y="566"/>
                            </a:lnTo>
                            <a:lnTo>
                              <a:pt x="209" y="566"/>
                            </a:lnTo>
                            <a:lnTo>
                              <a:pt x="215" y="572"/>
                            </a:lnTo>
                            <a:lnTo>
                              <a:pt x="221" y="572"/>
                            </a:lnTo>
                            <a:lnTo>
                              <a:pt x="228" y="578"/>
                            </a:lnTo>
                            <a:lnTo>
                              <a:pt x="234" y="578"/>
                            </a:lnTo>
                            <a:lnTo>
                              <a:pt x="240" y="584"/>
                            </a:lnTo>
                            <a:lnTo>
                              <a:pt x="246" y="584"/>
                            </a:lnTo>
                            <a:lnTo>
                              <a:pt x="252" y="584"/>
                            </a:lnTo>
                            <a:lnTo>
                              <a:pt x="252" y="590"/>
                            </a:lnTo>
                            <a:lnTo>
                              <a:pt x="258" y="590"/>
                            </a:lnTo>
                            <a:lnTo>
                              <a:pt x="265" y="584"/>
                            </a:lnTo>
                            <a:lnTo>
                              <a:pt x="271" y="584"/>
                            </a:lnTo>
                            <a:lnTo>
                              <a:pt x="277" y="578"/>
                            </a:lnTo>
                            <a:lnTo>
                              <a:pt x="283" y="566"/>
                            </a:lnTo>
                            <a:lnTo>
                              <a:pt x="289" y="553"/>
                            </a:lnTo>
                            <a:lnTo>
                              <a:pt x="289" y="516"/>
                            </a:lnTo>
                            <a:lnTo>
                              <a:pt x="295" y="467"/>
                            </a:lnTo>
                            <a:lnTo>
                              <a:pt x="301" y="406"/>
                            </a:lnTo>
                            <a:lnTo>
                              <a:pt x="308" y="344"/>
                            </a:lnTo>
                            <a:lnTo>
                              <a:pt x="314" y="258"/>
                            </a:lnTo>
                            <a:lnTo>
                              <a:pt x="320" y="141"/>
                            </a:lnTo>
                            <a:lnTo>
                              <a:pt x="320" y="37"/>
                            </a:lnTo>
                            <a:lnTo>
                              <a:pt x="326" y="6"/>
                            </a:lnTo>
                            <a:lnTo>
                              <a:pt x="332" y="6"/>
                            </a:lnTo>
                            <a:lnTo>
                              <a:pt x="338" y="0"/>
                            </a:lnTo>
                            <a:lnTo>
                              <a:pt x="344" y="43"/>
                            </a:lnTo>
                            <a:lnTo>
                              <a:pt x="351" y="148"/>
                            </a:lnTo>
                            <a:lnTo>
                              <a:pt x="351" y="264"/>
                            </a:lnTo>
                            <a:lnTo>
                              <a:pt x="357" y="357"/>
                            </a:lnTo>
                            <a:lnTo>
                              <a:pt x="363" y="430"/>
                            </a:lnTo>
                            <a:lnTo>
                              <a:pt x="369" y="486"/>
                            </a:lnTo>
                            <a:lnTo>
                              <a:pt x="375" y="535"/>
                            </a:lnTo>
                            <a:lnTo>
                              <a:pt x="381" y="572"/>
                            </a:lnTo>
                            <a:lnTo>
                              <a:pt x="381" y="596"/>
                            </a:lnTo>
                            <a:lnTo>
                              <a:pt x="387" y="621"/>
                            </a:lnTo>
                            <a:lnTo>
                              <a:pt x="394" y="639"/>
                            </a:lnTo>
                            <a:lnTo>
                              <a:pt x="400" y="652"/>
                            </a:lnTo>
                            <a:lnTo>
                              <a:pt x="406" y="658"/>
                            </a:lnTo>
                            <a:lnTo>
                              <a:pt x="412" y="664"/>
                            </a:lnTo>
                            <a:lnTo>
                              <a:pt x="418" y="670"/>
                            </a:lnTo>
                            <a:lnTo>
                              <a:pt x="418" y="676"/>
                            </a:lnTo>
                            <a:lnTo>
                              <a:pt x="424" y="682"/>
                            </a:lnTo>
                            <a:lnTo>
                              <a:pt x="430" y="682"/>
                            </a:lnTo>
                            <a:lnTo>
                              <a:pt x="437" y="689"/>
                            </a:lnTo>
                            <a:lnTo>
                              <a:pt x="443" y="689"/>
                            </a:lnTo>
                            <a:lnTo>
                              <a:pt x="449" y="695"/>
                            </a:lnTo>
                            <a:lnTo>
                              <a:pt x="455" y="701"/>
                            </a:lnTo>
                            <a:lnTo>
                              <a:pt x="461" y="701"/>
                            </a:lnTo>
                            <a:lnTo>
                              <a:pt x="467" y="707"/>
                            </a:lnTo>
                            <a:lnTo>
                              <a:pt x="474" y="707"/>
                            </a:lnTo>
                            <a:lnTo>
                              <a:pt x="480" y="707"/>
                            </a:lnTo>
                            <a:lnTo>
                              <a:pt x="480" y="713"/>
                            </a:lnTo>
                            <a:lnTo>
                              <a:pt x="486" y="713"/>
                            </a:lnTo>
                            <a:lnTo>
                              <a:pt x="492" y="713"/>
                            </a:lnTo>
                            <a:lnTo>
                              <a:pt x="498" y="713"/>
                            </a:lnTo>
                            <a:lnTo>
                              <a:pt x="504" y="719"/>
                            </a:lnTo>
                            <a:lnTo>
                              <a:pt x="510" y="719"/>
                            </a:lnTo>
                            <a:lnTo>
                              <a:pt x="517" y="719"/>
                            </a:lnTo>
                            <a:lnTo>
                              <a:pt x="523" y="719"/>
                            </a:lnTo>
                            <a:lnTo>
                              <a:pt x="529" y="719"/>
                            </a:lnTo>
                            <a:lnTo>
                              <a:pt x="535" y="719"/>
                            </a:lnTo>
                            <a:lnTo>
                              <a:pt x="541" y="719"/>
                            </a:lnTo>
                            <a:lnTo>
                              <a:pt x="547" y="719"/>
                            </a:lnTo>
                            <a:lnTo>
                              <a:pt x="553" y="707"/>
                            </a:lnTo>
                            <a:lnTo>
                              <a:pt x="560" y="689"/>
                            </a:lnTo>
                            <a:lnTo>
                              <a:pt x="566" y="670"/>
                            </a:lnTo>
                            <a:lnTo>
                              <a:pt x="572" y="652"/>
                            </a:lnTo>
                            <a:lnTo>
                              <a:pt x="578" y="621"/>
                            </a:lnTo>
                            <a:lnTo>
                              <a:pt x="578" y="578"/>
                            </a:lnTo>
                            <a:lnTo>
                              <a:pt x="584" y="535"/>
                            </a:lnTo>
                            <a:lnTo>
                              <a:pt x="590" y="498"/>
                            </a:lnTo>
                            <a:lnTo>
                              <a:pt x="596" y="467"/>
                            </a:lnTo>
                            <a:lnTo>
                              <a:pt x="603" y="449"/>
                            </a:lnTo>
                            <a:lnTo>
                              <a:pt x="609" y="424"/>
                            </a:lnTo>
                            <a:lnTo>
                              <a:pt x="609" y="412"/>
                            </a:lnTo>
                            <a:lnTo>
                              <a:pt x="615" y="430"/>
                            </a:lnTo>
                            <a:lnTo>
                              <a:pt x="621" y="455"/>
                            </a:lnTo>
                            <a:lnTo>
                              <a:pt x="627" y="473"/>
                            </a:lnTo>
                            <a:lnTo>
                              <a:pt x="633" y="516"/>
                            </a:lnTo>
                            <a:lnTo>
                              <a:pt x="639" y="559"/>
                            </a:lnTo>
                            <a:lnTo>
                              <a:pt x="639" y="590"/>
                            </a:lnTo>
                            <a:lnTo>
                              <a:pt x="646" y="615"/>
                            </a:lnTo>
                            <a:lnTo>
                              <a:pt x="652" y="639"/>
                            </a:lnTo>
                            <a:lnTo>
                              <a:pt x="658" y="670"/>
                            </a:lnTo>
                            <a:lnTo>
                              <a:pt x="664" y="695"/>
                            </a:lnTo>
                            <a:lnTo>
                              <a:pt x="670" y="719"/>
                            </a:lnTo>
                            <a:lnTo>
                              <a:pt x="676" y="744"/>
                            </a:lnTo>
                            <a:lnTo>
                              <a:pt x="676" y="762"/>
                            </a:lnTo>
                            <a:lnTo>
                              <a:pt x="682" y="775"/>
                            </a:lnTo>
                            <a:lnTo>
                              <a:pt x="689" y="787"/>
                            </a:lnTo>
                            <a:lnTo>
                              <a:pt x="695" y="793"/>
                            </a:lnTo>
                            <a:lnTo>
                              <a:pt x="701" y="805"/>
                            </a:lnTo>
                            <a:lnTo>
                              <a:pt x="707" y="812"/>
                            </a:lnTo>
                            <a:lnTo>
                              <a:pt x="707" y="818"/>
                            </a:lnTo>
                            <a:lnTo>
                              <a:pt x="713" y="824"/>
                            </a:lnTo>
                            <a:lnTo>
                              <a:pt x="719" y="830"/>
                            </a:lnTo>
                            <a:lnTo>
                              <a:pt x="726" y="836"/>
                            </a:lnTo>
                            <a:lnTo>
                              <a:pt x="732" y="842"/>
                            </a:lnTo>
                            <a:lnTo>
                              <a:pt x="738" y="848"/>
                            </a:lnTo>
                            <a:lnTo>
                              <a:pt x="738" y="855"/>
                            </a:lnTo>
                            <a:lnTo>
                              <a:pt x="744" y="861"/>
                            </a:lnTo>
                            <a:lnTo>
                              <a:pt x="750" y="861"/>
                            </a:lnTo>
                            <a:lnTo>
                              <a:pt x="756" y="867"/>
                            </a:lnTo>
                            <a:lnTo>
                              <a:pt x="762" y="867"/>
                            </a:lnTo>
                            <a:lnTo>
                              <a:pt x="769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5" y="891"/>
                            </a:lnTo>
                            <a:lnTo>
                              <a:pt x="812" y="898"/>
                            </a:lnTo>
                            <a:lnTo>
                              <a:pt x="818" y="898"/>
                            </a:lnTo>
                            <a:lnTo>
                              <a:pt x="824" y="904"/>
                            </a:lnTo>
                            <a:lnTo>
                              <a:pt x="830" y="904"/>
                            </a:lnTo>
                            <a:lnTo>
                              <a:pt x="836" y="904"/>
                            </a:lnTo>
                            <a:lnTo>
                              <a:pt x="836" y="910"/>
                            </a:lnTo>
                            <a:lnTo>
                              <a:pt x="842" y="910"/>
                            </a:lnTo>
                            <a:lnTo>
                              <a:pt x="848" y="916"/>
                            </a:lnTo>
                            <a:lnTo>
                              <a:pt x="855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1" y="934"/>
                            </a:lnTo>
                            <a:lnTo>
                              <a:pt x="898" y="941"/>
                            </a:lnTo>
                            <a:lnTo>
                              <a:pt x="904" y="947"/>
                            </a:lnTo>
                            <a:lnTo>
                              <a:pt x="910" y="947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8" y="959"/>
                            </a:lnTo>
                            <a:lnTo>
                              <a:pt x="935" y="959"/>
                            </a:lnTo>
                            <a:lnTo>
                              <a:pt x="935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8"/>
                            </a:lnTo>
                            <a:lnTo>
                              <a:pt x="971" y="984"/>
                            </a:lnTo>
                            <a:lnTo>
                              <a:pt x="978" y="984"/>
                            </a:lnTo>
                            <a:lnTo>
                              <a:pt x="984" y="990"/>
                            </a:lnTo>
                            <a:lnTo>
                              <a:pt x="990" y="990"/>
                            </a:lnTo>
                            <a:lnTo>
                              <a:pt x="996" y="990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8" y="1002"/>
                            </a:lnTo>
                            <a:lnTo>
                              <a:pt x="1014" y="1002"/>
                            </a:lnTo>
                            <a:lnTo>
                              <a:pt x="1021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1"/>
                            </a:lnTo>
                            <a:lnTo>
                              <a:pt x="1045" y="1021"/>
                            </a:lnTo>
                            <a:lnTo>
                              <a:pt x="1051" y="1021"/>
                            </a:lnTo>
                            <a:lnTo>
                              <a:pt x="1057" y="1027"/>
                            </a:lnTo>
                            <a:lnTo>
                              <a:pt x="1064" y="1027"/>
                            </a:lnTo>
                            <a:lnTo>
                              <a:pt x="1064" y="1033"/>
                            </a:lnTo>
                            <a:lnTo>
                              <a:pt x="1070" y="1033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0" y="1051"/>
                            </a:lnTo>
                            <a:lnTo>
                              <a:pt x="1107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4"/>
                            </a:lnTo>
                            <a:lnTo>
                              <a:pt x="1131" y="1070"/>
                            </a:lnTo>
                            <a:lnTo>
                              <a:pt x="1137" y="1070"/>
                            </a:lnTo>
                            <a:lnTo>
                              <a:pt x="1143" y="1076"/>
                            </a:lnTo>
                            <a:lnTo>
                              <a:pt x="1150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7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7"/>
                            </a:lnTo>
                            <a:lnTo>
                              <a:pt x="1211" y="1107"/>
                            </a:lnTo>
                            <a:lnTo>
                              <a:pt x="1217" y="1113"/>
                            </a:lnTo>
                            <a:lnTo>
                              <a:pt x="1223" y="1113"/>
                            </a:lnTo>
                            <a:lnTo>
                              <a:pt x="1223" y="1119"/>
                            </a:lnTo>
                            <a:lnTo>
                              <a:pt x="1230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6" y="1137"/>
                            </a:lnTo>
                            <a:lnTo>
                              <a:pt x="1273" y="1143"/>
                            </a:lnTo>
                            <a:lnTo>
                              <a:pt x="1279" y="1143"/>
                            </a:lnTo>
                            <a:lnTo>
                              <a:pt x="1285" y="1150"/>
                            </a:lnTo>
                            <a:lnTo>
                              <a:pt x="1291" y="1156"/>
                            </a:lnTo>
                            <a:lnTo>
                              <a:pt x="1297" y="1156"/>
                            </a:lnTo>
                            <a:lnTo>
                              <a:pt x="1303" y="1156"/>
                            </a:lnTo>
                            <a:lnTo>
                              <a:pt x="1309" y="1162"/>
                            </a:lnTo>
                            <a:lnTo>
                              <a:pt x="1316" y="1162"/>
                            </a:lnTo>
                            <a:lnTo>
                              <a:pt x="1322" y="1168"/>
                            </a:lnTo>
                            <a:lnTo>
                              <a:pt x="0" y="461"/>
                            </a:lnTo>
                            <a:close/>
                          </a:path>
                        </a:pathLst>
                      </a:custGeom>
                      <a:solidFill>
                        <a:srgbClr val="ffffff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8" name="Freeform 62"/>
                      <p:cNvSpPr/>
                      <p:nvPr/>
                    </p:nvSpPr>
                    <p:spPr>
                      <a:xfrm>
                        <a:off x="4042080" y="3685680"/>
                        <a:ext cx="1413360" cy="1113840"/>
                      </a:xfrm>
                      <a:custGeom>
                        <a:avLst/>
                        <a:gdLst>
                          <a:gd name="textAreaLeft" fmla="*/ 0 w 1413360"/>
                          <a:gd name="textAreaRight" fmla="*/ 1413360 w 1413360"/>
                          <a:gd name="textAreaTop" fmla="*/ 0 h 1113840"/>
                          <a:gd name="textAreaBottom" fmla="*/ 1114200 h 1113840"/>
                        </a:gdLst>
                        <a:ahLst/>
                        <a:rect l="textAreaLeft" t="textAreaTop" r="textAreaRight" b="textAreaBottom"/>
                        <a:pathLst>
                          <a:path w="1316" h="1162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2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80"/>
                            </a:lnTo>
                            <a:lnTo>
                              <a:pt x="37" y="480"/>
                            </a:lnTo>
                            <a:lnTo>
                              <a:pt x="43" y="486"/>
                            </a:lnTo>
                            <a:lnTo>
                              <a:pt x="49" y="486"/>
                            </a:lnTo>
                            <a:lnTo>
                              <a:pt x="56" y="486"/>
                            </a:lnTo>
                            <a:lnTo>
                              <a:pt x="62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9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3"/>
                            </a:lnTo>
                            <a:lnTo>
                              <a:pt x="123" y="523"/>
                            </a:lnTo>
                            <a:lnTo>
                              <a:pt x="123" y="529"/>
                            </a:lnTo>
                            <a:lnTo>
                              <a:pt x="129" y="529"/>
                            </a:lnTo>
                            <a:lnTo>
                              <a:pt x="135" y="535"/>
                            </a:lnTo>
                            <a:lnTo>
                              <a:pt x="142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53"/>
                            </a:lnTo>
                            <a:lnTo>
                              <a:pt x="178" y="553"/>
                            </a:lnTo>
                            <a:lnTo>
                              <a:pt x="185" y="553"/>
                            </a:lnTo>
                            <a:lnTo>
                              <a:pt x="191" y="559"/>
                            </a:lnTo>
                            <a:lnTo>
                              <a:pt x="197" y="566"/>
                            </a:lnTo>
                            <a:lnTo>
                              <a:pt x="203" y="566"/>
                            </a:lnTo>
                            <a:lnTo>
                              <a:pt x="209" y="566"/>
                            </a:lnTo>
                            <a:lnTo>
                              <a:pt x="215" y="572"/>
                            </a:lnTo>
                            <a:lnTo>
                              <a:pt x="221" y="572"/>
                            </a:lnTo>
                            <a:lnTo>
                              <a:pt x="228" y="578"/>
                            </a:lnTo>
                            <a:lnTo>
                              <a:pt x="234" y="578"/>
                            </a:lnTo>
                            <a:lnTo>
                              <a:pt x="240" y="584"/>
                            </a:lnTo>
                            <a:lnTo>
                              <a:pt x="246" y="584"/>
                            </a:lnTo>
                            <a:lnTo>
                              <a:pt x="252" y="584"/>
                            </a:lnTo>
                            <a:lnTo>
                              <a:pt x="252" y="590"/>
                            </a:lnTo>
                            <a:lnTo>
                              <a:pt x="258" y="590"/>
                            </a:lnTo>
                            <a:lnTo>
                              <a:pt x="265" y="584"/>
                            </a:lnTo>
                            <a:lnTo>
                              <a:pt x="271" y="584"/>
                            </a:lnTo>
                            <a:lnTo>
                              <a:pt x="277" y="578"/>
                            </a:lnTo>
                            <a:lnTo>
                              <a:pt x="283" y="566"/>
                            </a:lnTo>
                            <a:lnTo>
                              <a:pt x="289" y="553"/>
                            </a:lnTo>
                            <a:lnTo>
                              <a:pt x="289" y="516"/>
                            </a:lnTo>
                            <a:lnTo>
                              <a:pt x="295" y="467"/>
                            </a:lnTo>
                            <a:lnTo>
                              <a:pt x="301" y="406"/>
                            </a:lnTo>
                            <a:lnTo>
                              <a:pt x="308" y="344"/>
                            </a:lnTo>
                            <a:lnTo>
                              <a:pt x="314" y="258"/>
                            </a:lnTo>
                            <a:lnTo>
                              <a:pt x="320" y="141"/>
                            </a:lnTo>
                            <a:lnTo>
                              <a:pt x="320" y="37"/>
                            </a:lnTo>
                            <a:lnTo>
                              <a:pt x="326" y="6"/>
                            </a:lnTo>
                            <a:lnTo>
                              <a:pt x="332" y="6"/>
                            </a:lnTo>
                            <a:lnTo>
                              <a:pt x="338" y="0"/>
                            </a:lnTo>
                            <a:lnTo>
                              <a:pt x="344" y="43"/>
                            </a:lnTo>
                            <a:lnTo>
                              <a:pt x="351" y="148"/>
                            </a:lnTo>
                            <a:lnTo>
                              <a:pt x="351" y="264"/>
                            </a:lnTo>
                            <a:lnTo>
                              <a:pt x="357" y="357"/>
                            </a:lnTo>
                            <a:lnTo>
                              <a:pt x="363" y="430"/>
                            </a:lnTo>
                            <a:lnTo>
                              <a:pt x="369" y="486"/>
                            </a:lnTo>
                            <a:lnTo>
                              <a:pt x="375" y="535"/>
                            </a:lnTo>
                            <a:lnTo>
                              <a:pt x="381" y="572"/>
                            </a:lnTo>
                            <a:lnTo>
                              <a:pt x="381" y="596"/>
                            </a:lnTo>
                            <a:lnTo>
                              <a:pt x="387" y="621"/>
                            </a:lnTo>
                            <a:lnTo>
                              <a:pt x="394" y="639"/>
                            </a:lnTo>
                            <a:lnTo>
                              <a:pt x="400" y="652"/>
                            </a:lnTo>
                            <a:lnTo>
                              <a:pt x="406" y="658"/>
                            </a:lnTo>
                            <a:lnTo>
                              <a:pt x="412" y="664"/>
                            </a:lnTo>
                            <a:lnTo>
                              <a:pt x="418" y="670"/>
                            </a:lnTo>
                            <a:lnTo>
                              <a:pt x="418" y="676"/>
                            </a:lnTo>
                            <a:lnTo>
                              <a:pt x="424" y="682"/>
                            </a:lnTo>
                            <a:lnTo>
                              <a:pt x="430" y="682"/>
                            </a:lnTo>
                            <a:lnTo>
                              <a:pt x="437" y="689"/>
                            </a:lnTo>
                            <a:lnTo>
                              <a:pt x="443" y="689"/>
                            </a:lnTo>
                            <a:lnTo>
                              <a:pt x="449" y="695"/>
                            </a:lnTo>
                            <a:lnTo>
                              <a:pt x="455" y="701"/>
                            </a:lnTo>
                            <a:lnTo>
                              <a:pt x="461" y="701"/>
                            </a:lnTo>
                            <a:lnTo>
                              <a:pt x="467" y="707"/>
                            </a:lnTo>
                            <a:lnTo>
                              <a:pt x="474" y="707"/>
                            </a:lnTo>
                            <a:lnTo>
                              <a:pt x="480" y="707"/>
                            </a:lnTo>
                            <a:lnTo>
                              <a:pt x="480" y="713"/>
                            </a:lnTo>
                            <a:lnTo>
                              <a:pt x="486" y="713"/>
                            </a:lnTo>
                            <a:lnTo>
                              <a:pt x="492" y="713"/>
                            </a:lnTo>
                            <a:lnTo>
                              <a:pt x="498" y="713"/>
                            </a:lnTo>
                            <a:lnTo>
                              <a:pt x="504" y="719"/>
                            </a:lnTo>
                            <a:lnTo>
                              <a:pt x="510" y="719"/>
                            </a:lnTo>
                            <a:lnTo>
                              <a:pt x="517" y="719"/>
                            </a:lnTo>
                            <a:lnTo>
                              <a:pt x="523" y="719"/>
                            </a:lnTo>
                            <a:lnTo>
                              <a:pt x="529" y="719"/>
                            </a:lnTo>
                            <a:lnTo>
                              <a:pt x="535" y="719"/>
                            </a:lnTo>
                            <a:lnTo>
                              <a:pt x="541" y="719"/>
                            </a:lnTo>
                            <a:lnTo>
                              <a:pt x="547" y="719"/>
                            </a:lnTo>
                            <a:lnTo>
                              <a:pt x="553" y="707"/>
                            </a:lnTo>
                            <a:lnTo>
                              <a:pt x="560" y="689"/>
                            </a:lnTo>
                            <a:lnTo>
                              <a:pt x="566" y="670"/>
                            </a:lnTo>
                            <a:lnTo>
                              <a:pt x="572" y="652"/>
                            </a:lnTo>
                            <a:lnTo>
                              <a:pt x="578" y="621"/>
                            </a:lnTo>
                            <a:lnTo>
                              <a:pt x="578" y="578"/>
                            </a:lnTo>
                            <a:lnTo>
                              <a:pt x="584" y="535"/>
                            </a:lnTo>
                            <a:lnTo>
                              <a:pt x="590" y="498"/>
                            </a:lnTo>
                            <a:lnTo>
                              <a:pt x="596" y="467"/>
                            </a:lnTo>
                            <a:lnTo>
                              <a:pt x="603" y="449"/>
                            </a:lnTo>
                            <a:lnTo>
                              <a:pt x="609" y="424"/>
                            </a:lnTo>
                            <a:lnTo>
                              <a:pt x="609" y="412"/>
                            </a:lnTo>
                            <a:lnTo>
                              <a:pt x="615" y="430"/>
                            </a:lnTo>
                            <a:lnTo>
                              <a:pt x="621" y="455"/>
                            </a:lnTo>
                            <a:lnTo>
                              <a:pt x="627" y="473"/>
                            </a:lnTo>
                            <a:lnTo>
                              <a:pt x="633" y="516"/>
                            </a:lnTo>
                            <a:lnTo>
                              <a:pt x="639" y="559"/>
                            </a:lnTo>
                            <a:lnTo>
                              <a:pt x="639" y="590"/>
                            </a:lnTo>
                            <a:lnTo>
                              <a:pt x="646" y="615"/>
                            </a:lnTo>
                            <a:lnTo>
                              <a:pt x="652" y="639"/>
                            </a:lnTo>
                            <a:lnTo>
                              <a:pt x="658" y="670"/>
                            </a:lnTo>
                            <a:lnTo>
                              <a:pt x="664" y="695"/>
                            </a:lnTo>
                            <a:lnTo>
                              <a:pt x="670" y="719"/>
                            </a:lnTo>
                            <a:lnTo>
                              <a:pt x="676" y="744"/>
                            </a:lnTo>
                            <a:lnTo>
                              <a:pt x="676" y="762"/>
                            </a:lnTo>
                            <a:lnTo>
                              <a:pt x="682" y="775"/>
                            </a:lnTo>
                            <a:lnTo>
                              <a:pt x="689" y="787"/>
                            </a:lnTo>
                            <a:lnTo>
                              <a:pt x="695" y="793"/>
                            </a:lnTo>
                            <a:lnTo>
                              <a:pt x="701" y="805"/>
                            </a:lnTo>
                            <a:lnTo>
                              <a:pt x="707" y="812"/>
                            </a:lnTo>
                            <a:lnTo>
                              <a:pt x="707" y="818"/>
                            </a:lnTo>
                            <a:lnTo>
                              <a:pt x="713" y="824"/>
                            </a:lnTo>
                            <a:lnTo>
                              <a:pt x="719" y="830"/>
                            </a:lnTo>
                            <a:lnTo>
                              <a:pt x="726" y="836"/>
                            </a:lnTo>
                            <a:lnTo>
                              <a:pt x="732" y="842"/>
                            </a:lnTo>
                            <a:lnTo>
                              <a:pt x="738" y="848"/>
                            </a:lnTo>
                            <a:lnTo>
                              <a:pt x="738" y="855"/>
                            </a:lnTo>
                            <a:lnTo>
                              <a:pt x="744" y="861"/>
                            </a:lnTo>
                            <a:lnTo>
                              <a:pt x="750" y="861"/>
                            </a:lnTo>
                            <a:lnTo>
                              <a:pt x="756" y="867"/>
                            </a:lnTo>
                            <a:lnTo>
                              <a:pt x="762" y="867"/>
                            </a:lnTo>
                            <a:lnTo>
                              <a:pt x="769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5" y="891"/>
                            </a:lnTo>
                            <a:lnTo>
                              <a:pt x="812" y="898"/>
                            </a:lnTo>
                            <a:lnTo>
                              <a:pt x="818" y="898"/>
                            </a:lnTo>
                            <a:lnTo>
                              <a:pt x="824" y="904"/>
                            </a:lnTo>
                            <a:lnTo>
                              <a:pt x="830" y="904"/>
                            </a:lnTo>
                            <a:lnTo>
                              <a:pt x="836" y="904"/>
                            </a:lnTo>
                            <a:lnTo>
                              <a:pt x="836" y="910"/>
                            </a:lnTo>
                            <a:lnTo>
                              <a:pt x="842" y="910"/>
                            </a:lnTo>
                            <a:lnTo>
                              <a:pt x="848" y="916"/>
                            </a:lnTo>
                            <a:lnTo>
                              <a:pt x="855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1" y="934"/>
                            </a:lnTo>
                            <a:lnTo>
                              <a:pt x="898" y="941"/>
                            </a:lnTo>
                            <a:lnTo>
                              <a:pt x="904" y="947"/>
                            </a:lnTo>
                            <a:lnTo>
                              <a:pt x="910" y="947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8" y="959"/>
                            </a:lnTo>
                            <a:lnTo>
                              <a:pt x="935" y="959"/>
                            </a:lnTo>
                            <a:lnTo>
                              <a:pt x="935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8"/>
                            </a:lnTo>
                            <a:lnTo>
                              <a:pt x="971" y="984"/>
                            </a:lnTo>
                            <a:lnTo>
                              <a:pt x="978" y="984"/>
                            </a:lnTo>
                            <a:lnTo>
                              <a:pt x="984" y="990"/>
                            </a:lnTo>
                            <a:lnTo>
                              <a:pt x="990" y="990"/>
                            </a:lnTo>
                            <a:lnTo>
                              <a:pt x="996" y="990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8" y="1002"/>
                            </a:lnTo>
                            <a:lnTo>
                              <a:pt x="1014" y="1002"/>
                            </a:lnTo>
                            <a:lnTo>
                              <a:pt x="1021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1"/>
                            </a:lnTo>
                            <a:lnTo>
                              <a:pt x="1045" y="1021"/>
                            </a:lnTo>
                            <a:lnTo>
                              <a:pt x="1051" y="1021"/>
                            </a:lnTo>
                            <a:lnTo>
                              <a:pt x="1057" y="1027"/>
                            </a:lnTo>
                            <a:lnTo>
                              <a:pt x="1064" y="1027"/>
                            </a:lnTo>
                            <a:lnTo>
                              <a:pt x="1064" y="1033"/>
                            </a:lnTo>
                            <a:lnTo>
                              <a:pt x="1070" y="1033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0" y="1051"/>
                            </a:lnTo>
                            <a:lnTo>
                              <a:pt x="1107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4"/>
                            </a:lnTo>
                            <a:lnTo>
                              <a:pt x="1131" y="1070"/>
                            </a:lnTo>
                            <a:lnTo>
                              <a:pt x="1137" y="1070"/>
                            </a:lnTo>
                            <a:lnTo>
                              <a:pt x="1143" y="1076"/>
                            </a:lnTo>
                            <a:lnTo>
                              <a:pt x="1150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7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7"/>
                            </a:lnTo>
                            <a:lnTo>
                              <a:pt x="1211" y="1107"/>
                            </a:lnTo>
                            <a:lnTo>
                              <a:pt x="1217" y="1113"/>
                            </a:lnTo>
                            <a:lnTo>
                              <a:pt x="1223" y="1113"/>
                            </a:lnTo>
                            <a:lnTo>
                              <a:pt x="1223" y="1119"/>
                            </a:lnTo>
                            <a:lnTo>
                              <a:pt x="1230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6" y="1137"/>
                            </a:lnTo>
                            <a:lnTo>
                              <a:pt x="1273" y="1143"/>
                            </a:lnTo>
                            <a:lnTo>
                              <a:pt x="1279" y="1143"/>
                            </a:lnTo>
                            <a:lnTo>
                              <a:pt x="1285" y="1150"/>
                            </a:lnTo>
                            <a:lnTo>
                              <a:pt x="1291" y="1156"/>
                            </a:lnTo>
                            <a:lnTo>
                              <a:pt x="1297" y="1156"/>
                            </a:lnTo>
                            <a:lnTo>
                              <a:pt x="1303" y="1156"/>
                            </a:lnTo>
                            <a:lnTo>
                              <a:pt x="1309" y="1162"/>
                            </a:lnTo>
                            <a:lnTo>
                              <a:pt x="1316" y="1162"/>
                            </a:lnTo>
                          </a:path>
                        </a:pathLst>
                      </a:custGeom>
                      <a:noFill/>
                      <a:ln w="9360">
                        <a:solidFill>
                          <a:srgbClr val="00ff00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  <p:grpSp>
                <p:nvGrpSpPr>
                  <p:cNvPr id="109" name="Group 63"/>
                  <p:cNvGrpSpPr/>
                  <p:nvPr/>
                </p:nvGrpSpPr>
                <p:grpSpPr>
                  <a:xfrm>
                    <a:off x="3909960" y="3803760"/>
                    <a:ext cx="1419840" cy="1119600"/>
                    <a:chOff x="3909960" y="3803760"/>
                    <a:chExt cx="1419840" cy="1119600"/>
                  </a:xfrm>
                </p:grpSpPr>
                <p:sp>
                  <p:nvSpPr>
                    <p:cNvPr id="110" name="Line 64"/>
                    <p:cNvSpPr/>
                    <p:nvPr/>
                  </p:nvSpPr>
                  <p:spPr>
                    <a:xfrm>
                      <a:off x="3909960" y="4245480"/>
                      <a:ext cx="1419840" cy="677880"/>
                    </a:xfrm>
                    <a:prstGeom prst="line">
                      <a:avLst/>
                    </a:prstGeom>
                    <a:ln w="9360">
                      <a:solidFill>
                        <a:srgbClr val="88888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111" name="Group 65"/>
                    <p:cNvGrpSpPr/>
                    <p:nvPr/>
                  </p:nvGrpSpPr>
                  <p:grpSpPr>
                    <a:xfrm>
                      <a:off x="3909960" y="3803760"/>
                      <a:ext cx="1419840" cy="1119600"/>
                      <a:chOff x="3909960" y="3803760"/>
                      <a:chExt cx="1419840" cy="1119600"/>
                    </a:xfrm>
                  </p:grpSpPr>
                  <p:sp>
                    <p:nvSpPr>
                      <p:cNvPr id="112" name="Freeform 66"/>
                      <p:cNvSpPr/>
                      <p:nvPr/>
                    </p:nvSpPr>
                    <p:spPr>
                      <a:xfrm>
                        <a:off x="3909960" y="3803760"/>
                        <a:ext cx="1419840" cy="1119600"/>
                      </a:xfrm>
                      <a:custGeom>
                        <a:avLst/>
                        <a:gdLst>
                          <a:gd name="textAreaLeft" fmla="*/ 0 w 1419840"/>
                          <a:gd name="textAreaRight" fmla="*/ 1420200 w 1419840"/>
                          <a:gd name="textAreaTop" fmla="*/ 0 h 1119600"/>
                          <a:gd name="textAreaBottom" fmla="*/ 1119600 h 1119600"/>
                        </a:gdLst>
                        <a:ahLst/>
                        <a:rect l="textAreaLeft" t="textAreaTop" r="textAreaRight" b="textAreaBottom"/>
                        <a:pathLst>
                          <a:path w="1322" h="1168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3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80"/>
                            </a:lnTo>
                            <a:lnTo>
                              <a:pt x="37" y="480"/>
                            </a:lnTo>
                            <a:lnTo>
                              <a:pt x="43" y="486"/>
                            </a:lnTo>
                            <a:lnTo>
                              <a:pt x="49" y="486"/>
                            </a:lnTo>
                            <a:lnTo>
                              <a:pt x="56" y="486"/>
                            </a:lnTo>
                            <a:lnTo>
                              <a:pt x="62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9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3"/>
                            </a:lnTo>
                            <a:lnTo>
                              <a:pt x="123" y="523"/>
                            </a:lnTo>
                            <a:lnTo>
                              <a:pt x="123" y="529"/>
                            </a:lnTo>
                            <a:lnTo>
                              <a:pt x="129" y="529"/>
                            </a:lnTo>
                            <a:lnTo>
                              <a:pt x="135" y="535"/>
                            </a:lnTo>
                            <a:lnTo>
                              <a:pt x="142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53"/>
                            </a:lnTo>
                            <a:lnTo>
                              <a:pt x="179" y="553"/>
                            </a:lnTo>
                            <a:lnTo>
                              <a:pt x="185" y="559"/>
                            </a:lnTo>
                            <a:lnTo>
                              <a:pt x="191" y="559"/>
                            </a:lnTo>
                            <a:lnTo>
                              <a:pt x="197" y="566"/>
                            </a:lnTo>
                            <a:lnTo>
                              <a:pt x="203" y="566"/>
                            </a:lnTo>
                            <a:lnTo>
                              <a:pt x="209" y="572"/>
                            </a:lnTo>
                            <a:lnTo>
                              <a:pt x="215" y="572"/>
                            </a:lnTo>
                            <a:lnTo>
                              <a:pt x="222" y="572"/>
                            </a:lnTo>
                            <a:lnTo>
                              <a:pt x="222" y="578"/>
                            </a:lnTo>
                            <a:lnTo>
                              <a:pt x="228" y="578"/>
                            </a:lnTo>
                            <a:lnTo>
                              <a:pt x="234" y="578"/>
                            </a:lnTo>
                            <a:lnTo>
                              <a:pt x="240" y="584"/>
                            </a:lnTo>
                            <a:lnTo>
                              <a:pt x="246" y="584"/>
                            </a:lnTo>
                            <a:lnTo>
                              <a:pt x="252" y="584"/>
                            </a:lnTo>
                            <a:lnTo>
                              <a:pt x="258" y="578"/>
                            </a:lnTo>
                            <a:lnTo>
                              <a:pt x="265" y="566"/>
                            </a:lnTo>
                            <a:lnTo>
                              <a:pt x="271" y="553"/>
                            </a:lnTo>
                            <a:lnTo>
                              <a:pt x="277" y="535"/>
                            </a:lnTo>
                            <a:lnTo>
                              <a:pt x="283" y="510"/>
                            </a:lnTo>
                            <a:lnTo>
                              <a:pt x="289" y="461"/>
                            </a:lnTo>
                            <a:lnTo>
                              <a:pt x="289" y="387"/>
                            </a:lnTo>
                            <a:lnTo>
                              <a:pt x="295" y="295"/>
                            </a:lnTo>
                            <a:lnTo>
                              <a:pt x="301" y="191"/>
                            </a:lnTo>
                            <a:lnTo>
                              <a:pt x="308" y="74"/>
                            </a:lnTo>
                            <a:lnTo>
                              <a:pt x="314" y="0"/>
                            </a:lnTo>
                            <a:lnTo>
                              <a:pt x="320" y="0"/>
                            </a:lnTo>
                            <a:lnTo>
                              <a:pt x="320" y="25"/>
                            </a:lnTo>
                            <a:lnTo>
                              <a:pt x="326" y="80"/>
                            </a:lnTo>
                            <a:lnTo>
                              <a:pt x="332" y="166"/>
                            </a:lnTo>
                            <a:lnTo>
                              <a:pt x="338" y="258"/>
                            </a:lnTo>
                            <a:lnTo>
                              <a:pt x="344" y="350"/>
                            </a:lnTo>
                            <a:lnTo>
                              <a:pt x="351" y="406"/>
                            </a:lnTo>
                            <a:lnTo>
                              <a:pt x="351" y="461"/>
                            </a:lnTo>
                            <a:lnTo>
                              <a:pt x="357" y="510"/>
                            </a:lnTo>
                            <a:lnTo>
                              <a:pt x="363" y="559"/>
                            </a:lnTo>
                            <a:lnTo>
                              <a:pt x="369" y="590"/>
                            </a:lnTo>
                            <a:lnTo>
                              <a:pt x="375" y="602"/>
                            </a:lnTo>
                            <a:lnTo>
                              <a:pt x="381" y="621"/>
                            </a:lnTo>
                            <a:lnTo>
                              <a:pt x="381" y="633"/>
                            </a:lnTo>
                            <a:lnTo>
                              <a:pt x="388" y="646"/>
                            </a:lnTo>
                            <a:lnTo>
                              <a:pt x="394" y="652"/>
                            </a:lnTo>
                            <a:lnTo>
                              <a:pt x="400" y="658"/>
                            </a:lnTo>
                            <a:lnTo>
                              <a:pt x="406" y="664"/>
                            </a:lnTo>
                            <a:lnTo>
                              <a:pt x="412" y="670"/>
                            </a:lnTo>
                            <a:lnTo>
                              <a:pt x="418" y="676"/>
                            </a:lnTo>
                            <a:lnTo>
                              <a:pt x="418" y="682"/>
                            </a:lnTo>
                            <a:lnTo>
                              <a:pt x="424" y="682"/>
                            </a:lnTo>
                            <a:lnTo>
                              <a:pt x="431" y="689"/>
                            </a:lnTo>
                            <a:lnTo>
                              <a:pt x="437" y="689"/>
                            </a:lnTo>
                            <a:lnTo>
                              <a:pt x="443" y="695"/>
                            </a:lnTo>
                            <a:lnTo>
                              <a:pt x="449" y="695"/>
                            </a:lnTo>
                            <a:lnTo>
                              <a:pt x="449" y="701"/>
                            </a:lnTo>
                            <a:lnTo>
                              <a:pt x="455" y="701"/>
                            </a:lnTo>
                            <a:lnTo>
                              <a:pt x="461" y="701"/>
                            </a:lnTo>
                            <a:lnTo>
                              <a:pt x="467" y="707"/>
                            </a:lnTo>
                            <a:lnTo>
                              <a:pt x="474" y="707"/>
                            </a:lnTo>
                            <a:lnTo>
                              <a:pt x="480" y="707"/>
                            </a:lnTo>
                            <a:lnTo>
                              <a:pt x="480" y="713"/>
                            </a:lnTo>
                            <a:lnTo>
                              <a:pt x="486" y="713"/>
                            </a:lnTo>
                            <a:lnTo>
                              <a:pt x="492" y="713"/>
                            </a:lnTo>
                            <a:lnTo>
                              <a:pt x="498" y="719"/>
                            </a:lnTo>
                            <a:lnTo>
                              <a:pt x="504" y="719"/>
                            </a:lnTo>
                            <a:lnTo>
                              <a:pt x="510" y="719"/>
                            </a:lnTo>
                            <a:lnTo>
                              <a:pt x="517" y="719"/>
                            </a:lnTo>
                            <a:lnTo>
                              <a:pt x="523" y="713"/>
                            </a:lnTo>
                            <a:lnTo>
                              <a:pt x="529" y="713"/>
                            </a:lnTo>
                            <a:lnTo>
                              <a:pt x="535" y="707"/>
                            </a:lnTo>
                            <a:lnTo>
                              <a:pt x="541" y="695"/>
                            </a:lnTo>
                            <a:lnTo>
                              <a:pt x="547" y="676"/>
                            </a:lnTo>
                            <a:lnTo>
                              <a:pt x="547" y="658"/>
                            </a:lnTo>
                            <a:lnTo>
                              <a:pt x="553" y="627"/>
                            </a:lnTo>
                            <a:lnTo>
                              <a:pt x="560" y="596"/>
                            </a:lnTo>
                            <a:lnTo>
                              <a:pt x="566" y="566"/>
                            </a:lnTo>
                            <a:lnTo>
                              <a:pt x="572" y="541"/>
                            </a:lnTo>
                            <a:lnTo>
                              <a:pt x="578" y="504"/>
                            </a:lnTo>
                            <a:lnTo>
                              <a:pt x="578" y="461"/>
                            </a:lnTo>
                            <a:lnTo>
                              <a:pt x="584" y="418"/>
                            </a:lnTo>
                            <a:lnTo>
                              <a:pt x="590" y="406"/>
                            </a:lnTo>
                            <a:lnTo>
                              <a:pt x="597" y="424"/>
                            </a:lnTo>
                            <a:lnTo>
                              <a:pt x="603" y="467"/>
                            </a:lnTo>
                            <a:lnTo>
                              <a:pt x="609" y="516"/>
                            </a:lnTo>
                            <a:lnTo>
                              <a:pt x="609" y="553"/>
                            </a:lnTo>
                            <a:lnTo>
                              <a:pt x="615" y="590"/>
                            </a:lnTo>
                            <a:lnTo>
                              <a:pt x="621" y="621"/>
                            </a:lnTo>
                            <a:lnTo>
                              <a:pt x="627" y="652"/>
                            </a:lnTo>
                            <a:lnTo>
                              <a:pt x="633" y="676"/>
                            </a:lnTo>
                            <a:lnTo>
                              <a:pt x="640" y="695"/>
                            </a:lnTo>
                            <a:lnTo>
                              <a:pt x="640" y="719"/>
                            </a:lnTo>
                            <a:lnTo>
                              <a:pt x="646" y="738"/>
                            </a:lnTo>
                            <a:lnTo>
                              <a:pt x="652" y="750"/>
                            </a:lnTo>
                            <a:lnTo>
                              <a:pt x="658" y="762"/>
                            </a:lnTo>
                            <a:lnTo>
                              <a:pt x="664" y="768"/>
                            </a:lnTo>
                            <a:lnTo>
                              <a:pt x="670" y="775"/>
                            </a:lnTo>
                            <a:lnTo>
                              <a:pt x="676" y="781"/>
                            </a:lnTo>
                            <a:lnTo>
                              <a:pt x="676" y="793"/>
                            </a:lnTo>
                            <a:lnTo>
                              <a:pt x="683" y="799"/>
                            </a:lnTo>
                            <a:lnTo>
                              <a:pt x="689" y="811"/>
                            </a:lnTo>
                            <a:lnTo>
                              <a:pt x="695" y="818"/>
                            </a:lnTo>
                            <a:lnTo>
                              <a:pt x="701" y="824"/>
                            </a:lnTo>
                            <a:lnTo>
                              <a:pt x="707" y="830"/>
                            </a:lnTo>
                            <a:lnTo>
                              <a:pt x="713" y="836"/>
                            </a:lnTo>
                            <a:lnTo>
                              <a:pt x="719" y="836"/>
                            </a:lnTo>
                            <a:lnTo>
                              <a:pt x="726" y="842"/>
                            </a:lnTo>
                            <a:lnTo>
                              <a:pt x="732" y="848"/>
                            </a:lnTo>
                            <a:lnTo>
                              <a:pt x="738" y="848"/>
                            </a:lnTo>
                            <a:lnTo>
                              <a:pt x="738" y="855"/>
                            </a:lnTo>
                            <a:lnTo>
                              <a:pt x="744" y="861"/>
                            </a:lnTo>
                            <a:lnTo>
                              <a:pt x="750" y="861"/>
                            </a:lnTo>
                            <a:lnTo>
                              <a:pt x="756" y="867"/>
                            </a:lnTo>
                            <a:lnTo>
                              <a:pt x="762" y="867"/>
                            </a:lnTo>
                            <a:lnTo>
                              <a:pt x="769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5" y="891"/>
                            </a:lnTo>
                            <a:lnTo>
                              <a:pt x="812" y="898"/>
                            </a:lnTo>
                            <a:lnTo>
                              <a:pt x="818" y="898"/>
                            </a:lnTo>
                            <a:lnTo>
                              <a:pt x="824" y="904"/>
                            </a:lnTo>
                            <a:lnTo>
                              <a:pt x="830" y="904"/>
                            </a:lnTo>
                            <a:lnTo>
                              <a:pt x="836" y="904"/>
                            </a:lnTo>
                            <a:lnTo>
                              <a:pt x="836" y="910"/>
                            </a:lnTo>
                            <a:lnTo>
                              <a:pt x="842" y="910"/>
                            </a:lnTo>
                            <a:lnTo>
                              <a:pt x="849" y="916"/>
                            </a:lnTo>
                            <a:lnTo>
                              <a:pt x="855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2" y="934"/>
                            </a:lnTo>
                            <a:lnTo>
                              <a:pt x="898" y="941"/>
                            </a:lnTo>
                            <a:lnTo>
                              <a:pt x="904" y="947"/>
                            </a:lnTo>
                            <a:lnTo>
                              <a:pt x="910" y="947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8" y="959"/>
                            </a:lnTo>
                            <a:lnTo>
                              <a:pt x="935" y="959"/>
                            </a:lnTo>
                            <a:lnTo>
                              <a:pt x="935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7"/>
                            </a:lnTo>
                            <a:lnTo>
                              <a:pt x="971" y="984"/>
                            </a:lnTo>
                            <a:lnTo>
                              <a:pt x="978" y="984"/>
                            </a:lnTo>
                            <a:lnTo>
                              <a:pt x="984" y="990"/>
                            </a:lnTo>
                            <a:lnTo>
                              <a:pt x="990" y="990"/>
                            </a:lnTo>
                            <a:lnTo>
                              <a:pt x="996" y="990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8" y="1002"/>
                            </a:lnTo>
                            <a:lnTo>
                              <a:pt x="1014" y="1002"/>
                            </a:lnTo>
                            <a:lnTo>
                              <a:pt x="1021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1" y="1020"/>
                            </a:lnTo>
                            <a:lnTo>
                              <a:pt x="1058" y="1027"/>
                            </a:lnTo>
                            <a:lnTo>
                              <a:pt x="1064" y="1027"/>
                            </a:lnTo>
                            <a:lnTo>
                              <a:pt x="1064" y="1033"/>
                            </a:lnTo>
                            <a:lnTo>
                              <a:pt x="1070" y="1033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1" y="1051"/>
                            </a:lnTo>
                            <a:lnTo>
                              <a:pt x="1107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4"/>
                            </a:lnTo>
                            <a:lnTo>
                              <a:pt x="1131" y="1070"/>
                            </a:lnTo>
                            <a:lnTo>
                              <a:pt x="1137" y="1070"/>
                            </a:lnTo>
                            <a:lnTo>
                              <a:pt x="1144" y="1076"/>
                            </a:lnTo>
                            <a:lnTo>
                              <a:pt x="1150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7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7"/>
                            </a:lnTo>
                            <a:lnTo>
                              <a:pt x="1211" y="1107"/>
                            </a:lnTo>
                            <a:lnTo>
                              <a:pt x="1217" y="1113"/>
                            </a:lnTo>
                            <a:lnTo>
                              <a:pt x="1223" y="1113"/>
                            </a:lnTo>
                            <a:lnTo>
                              <a:pt x="1223" y="1119"/>
                            </a:lnTo>
                            <a:lnTo>
                              <a:pt x="1230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6" y="1137"/>
                            </a:lnTo>
                            <a:lnTo>
                              <a:pt x="1273" y="1143"/>
                            </a:lnTo>
                            <a:lnTo>
                              <a:pt x="1279" y="1143"/>
                            </a:lnTo>
                            <a:lnTo>
                              <a:pt x="1285" y="1150"/>
                            </a:lnTo>
                            <a:lnTo>
                              <a:pt x="1291" y="1156"/>
                            </a:lnTo>
                            <a:lnTo>
                              <a:pt x="1297" y="1156"/>
                            </a:lnTo>
                            <a:lnTo>
                              <a:pt x="1303" y="1156"/>
                            </a:lnTo>
                            <a:lnTo>
                              <a:pt x="1310" y="1162"/>
                            </a:lnTo>
                            <a:lnTo>
                              <a:pt x="1316" y="1162"/>
                            </a:lnTo>
                            <a:lnTo>
                              <a:pt x="1322" y="1168"/>
                            </a:lnTo>
                            <a:lnTo>
                              <a:pt x="0" y="461"/>
                            </a:lnTo>
                            <a:close/>
                          </a:path>
                        </a:pathLst>
                      </a:custGeom>
                      <a:solidFill>
                        <a:srgbClr val="ffffff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3" name="Freeform 67"/>
                      <p:cNvSpPr/>
                      <p:nvPr/>
                    </p:nvSpPr>
                    <p:spPr>
                      <a:xfrm>
                        <a:off x="3909960" y="3803760"/>
                        <a:ext cx="1413360" cy="1113840"/>
                      </a:xfrm>
                      <a:custGeom>
                        <a:avLst/>
                        <a:gdLst>
                          <a:gd name="textAreaLeft" fmla="*/ 0 w 1413360"/>
                          <a:gd name="textAreaRight" fmla="*/ 1413360 w 1413360"/>
                          <a:gd name="textAreaTop" fmla="*/ 0 h 1113840"/>
                          <a:gd name="textAreaBottom" fmla="*/ 1114200 h 1113840"/>
                        </a:gdLst>
                        <a:ahLst/>
                        <a:rect l="textAreaLeft" t="textAreaTop" r="textAreaRight" b="textAreaBottom"/>
                        <a:pathLst>
                          <a:path w="1316" h="1162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3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80"/>
                            </a:lnTo>
                            <a:lnTo>
                              <a:pt x="37" y="480"/>
                            </a:lnTo>
                            <a:lnTo>
                              <a:pt x="43" y="486"/>
                            </a:lnTo>
                            <a:lnTo>
                              <a:pt x="49" y="486"/>
                            </a:lnTo>
                            <a:lnTo>
                              <a:pt x="56" y="486"/>
                            </a:lnTo>
                            <a:lnTo>
                              <a:pt x="62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9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3"/>
                            </a:lnTo>
                            <a:lnTo>
                              <a:pt x="123" y="523"/>
                            </a:lnTo>
                            <a:lnTo>
                              <a:pt x="123" y="529"/>
                            </a:lnTo>
                            <a:lnTo>
                              <a:pt x="129" y="529"/>
                            </a:lnTo>
                            <a:lnTo>
                              <a:pt x="135" y="535"/>
                            </a:lnTo>
                            <a:lnTo>
                              <a:pt x="142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53"/>
                            </a:lnTo>
                            <a:lnTo>
                              <a:pt x="179" y="553"/>
                            </a:lnTo>
                            <a:lnTo>
                              <a:pt x="185" y="559"/>
                            </a:lnTo>
                            <a:lnTo>
                              <a:pt x="191" y="559"/>
                            </a:lnTo>
                            <a:lnTo>
                              <a:pt x="197" y="566"/>
                            </a:lnTo>
                            <a:lnTo>
                              <a:pt x="203" y="566"/>
                            </a:lnTo>
                            <a:lnTo>
                              <a:pt x="209" y="572"/>
                            </a:lnTo>
                            <a:lnTo>
                              <a:pt x="215" y="572"/>
                            </a:lnTo>
                            <a:lnTo>
                              <a:pt x="222" y="572"/>
                            </a:lnTo>
                            <a:lnTo>
                              <a:pt x="222" y="578"/>
                            </a:lnTo>
                            <a:lnTo>
                              <a:pt x="228" y="578"/>
                            </a:lnTo>
                            <a:lnTo>
                              <a:pt x="234" y="578"/>
                            </a:lnTo>
                            <a:lnTo>
                              <a:pt x="240" y="584"/>
                            </a:lnTo>
                            <a:lnTo>
                              <a:pt x="246" y="584"/>
                            </a:lnTo>
                            <a:lnTo>
                              <a:pt x="252" y="584"/>
                            </a:lnTo>
                            <a:lnTo>
                              <a:pt x="258" y="578"/>
                            </a:lnTo>
                            <a:lnTo>
                              <a:pt x="265" y="566"/>
                            </a:lnTo>
                            <a:lnTo>
                              <a:pt x="271" y="553"/>
                            </a:lnTo>
                            <a:lnTo>
                              <a:pt x="277" y="535"/>
                            </a:lnTo>
                            <a:lnTo>
                              <a:pt x="283" y="510"/>
                            </a:lnTo>
                            <a:lnTo>
                              <a:pt x="289" y="461"/>
                            </a:lnTo>
                            <a:lnTo>
                              <a:pt x="289" y="387"/>
                            </a:lnTo>
                            <a:lnTo>
                              <a:pt x="295" y="295"/>
                            </a:lnTo>
                            <a:lnTo>
                              <a:pt x="301" y="191"/>
                            </a:lnTo>
                            <a:lnTo>
                              <a:pt x="308" y="74"/>
                            </a:lnTo>
                            <a:lnTo>
                              <a:pt x="314" y="0"/>
                            </a:lnTo>
                            <a:lnTo>
                              <a:pt x="320" y="0"/>
                            </a:lnTo>
                            <a:lnTo>
                              <a:pt x="320" y="25"/>
                            </a:lnTo>
                            <a:lnTo>
                              <a:pt x="326" y="80"/>
                            </a:lnTo>
                            <a:lnTo>
                              <a:pt x="332" y="166"/>
                            </a:lnTo>
                            <a:lnTo>
                              <a:pt x="338" y="258"/>
                            </a:lnTo>
                            <a:lnTo>
                              <a:pt x="344" y="350"/>
                            </a:lnTo>
                            <a:lnTo>
                              <a:pt x="351" y="406"/>
                            </a:lnTo>
                            <a:lnTo>
                              <a:pt x="351" y="461"/>
                            </a:lnTo>
                            <a:lnTo>
                              <a:pt x="357" y="510"/>
                            </a:lnTo>
                            <a:lnTo>
                              <a:pt x="363" y="559"/>
                            </a:lnTo>
                            <a:lnTo>
                              <a:pt x="369" y="590"/>
                            </a:lnTo>
                            <a:lnTo>
                              <a:pt x="375" y="602"/>
                            </a:lnTo>
                            <a:lnTo>
                              <a:pt x="381" y="621"/>
                            </a:lnTo>
                            <a:lnTo>
                              <a:pt x="381" y="633"/>
                            </a:lnTo>
                            <a:lnTo>
                              <a:pt x="388" y="646"/>
                            </a:lnTo>
                            <a:lnTo>
                              <a:pt x="394" y="652"/>
                            </a:lnTo>
                            <a:lnTo>
                              <a:pt x="400" y="658"/>
                            </a:lnTo>
                            <a:lnTo>
                              <a:pt x="406" y="664"/>
                            </a:lnTo>
                            <a:lnTo>
                              <a:pt x="412" y="670"/>
                            </a:lnTo>
                            <a:lnTo>
                              <a:pt x="418" y="676"/>
                            </a:lnTo>
                            <a:lnTo>
                              <a:pt x="418" y="682"/>
                            </a:lnTo>
                            <a:lnTo>
                              <a:pt x="424" y="682"/>
                            </a:lnTo>
                            <a:lnTo>
                              <a:pt x="431" y="689"/>
                            </a:lnTo>
                            <a:lnTo>
                              <a:pt x="437" y="689"/>
                            </a:lnTo>
                            <a:lnTo>
                              <a:pt x="443" y="695"/>
                            </a:lnTo>
                            <a:lnTo>
                              <a:pt x="449" y="695"/>
                            </a:lnTo>
                            <a:lnTo>
                              <a:pt x="449" y="701"/>
                            </a:lnTo>
                            <a:lnTo>
                              <a:pt x="455" y="701"/>
                            </a:lnTo>
                            <a:lnTo>
                              <a:pt x="461" y="701"/>
                            </a:lnTo>
                            <a:lnTo>
                              <a:pt x="467" y="707"/>
                            </a:lnTo>
                            <a:lnTo>
                              <a:pt x="474" y="707"/>
                            </a:lnTo>
                            <a:lnTo>
                              <a:pt x="480" y="707"/>
                            </a:lnTo>
                            <a:lnTo>
                              <a:pt x="480" y="713"/>
                            </a:lnTo>
                            <a:lnTo>
                              <a:pt x="486" y="713"/>
                            </a:lnTo>
                            <a:lnTo>
                              <a:pt x="492" y="713"/>
                            </a:lnTo>
                            <a:lnTo>
                              <a:pt x="498" y="719"/>
                            </a:lnTo>
                            <a:lnTo>
                              <a:pt x="504" y="719"/>
                            </a:lnTo>
                            <a:lnTo>
                              <a:pt x="510" y="719"/>
                            </a:lnTo>
                            <a:lnTo>
                              <a:pt x="517" y="719"/>
                            </a:lnTo>
                            <a:lnTo>
                              <a:pt x="523" y="713"/>
                            </a:lnTo>
                            <a:lnTo>
                              <a:pt x="529" y="713"/>
                            </a:lnTo>
                            <a:lnTo>
                              <a:pt x="535" y="707"/>
                            </a:lnTo>
                            <a:lnTo>
                              <a:pt x="541" y="695"/>
                            </a:lnTo>
                            <a:lnTo>
                              <a:pt x="547" y="676"/>
                            </a:lnTo>
                            <a:lnTo>
                              <a:pt x="547" y="658"/>
                            </a:lnTo>
                            <a:lnTo>
                              <a:pt x="553" y="627"/>
                            </a:lnTo>
                            <a:lnTo>
                              <a:pt x="560" y="596"/>
                            </a:lnTo>
                            <a:lnTo>
                              <a:pt x="566" y="566"/>
                            </a:lnTo>
                            <a:lnTo>
                              <a:pt x="572" y="541"/>
                            </a:lnTo>
                            <a:lnTo>
                              <a:pt x="578" y="504"/>
                            </a:lnTo>
                            <a:lnTo>
                              <a:pt x="578" y="461"/>
                            </a:lnTo>
                            <a:lnTo>
                              <a:pt x="584" y="418"/>
                            </a:lnTo>
                            <a:lnTo>
                              <a:pt x="590" y="406"/>
                            </a:lnTo>
                            <a:lnTo>
                              <a:pt x="597" y="424"/>
                            </a:lnTo>
                            <a:lnTo>
                              <a:pt x="603" y="467"/>
                            </a:lnTo>
                            <a:lnTo>
                              <a:pt x="609" y="516"/>
                            </a:lnTo>
                            <a:lnTo>
                              <a:pt x="609" y="553"/>
                            </a:lnTo>
                            <a:lnTo>
                              <a:pt x="615" y="590"/>
                            </a:lnTo>
                            <a:lnTo>
                              <a:pt x="621" y="621"/>
                            </a:lnTo>
                            <a:lnTo>
                              <a:pt x="627" y="652"/>
                            </a:lnTo>
                            <a:lnTo>
                              <a:pt x="633" y="676"/>
                            </a:lnTo>
                            <a:lnTo>
                              <a:pt x="640" y="695"/>
                            </a:lnTo>
                            <a:lnTo>
                              <a:pt x="640" y="719"/>
                            </a:lnTo>
                            <a:lnTo>
                              <a:pt x="646" y="738"/>
                            </a:lnTo>
                            <a:lnTo>
                              <a:pt x="652" y="750"/>
                            </a:lnTo>
                            <a:lnTo>
                              <a:pt x="658" y="762"/>
                            </a:lnTo>
                            <a:lnTo>
                              <a:pt x="664" y="768"/>
                            </a:lnTo>
                            <a:lnTo>
                              <a:pt x="670" y="775"/>
                            </a:lnTo>
                            <a:lnTo>
                              <a:pt x="676" y="781"/>
                            </a:lnTo>
                            <a:lnTo>
                              <a:pt x="676" y="793"/>
                            </a:lnTo>
                            <a:lnTo>
                              <a:pt x="683" y="799"/>
                            </a:lnTo>
                            <a:lnTo>
                              <a:pt x="689" y="811"/>
                            </a:lnTo>
                            <a:lnTo>
                              <a:pt x="695" y="818"/>
                            </a:lnTo>
                            <a:lnTo>
                              <a:pt x="701" y="824"/>
                            </a:lnTo>
                            <a:lnTo>
                              <a:pt x="707" y="830"/>
                            </a:lnTo>
                            <a:lnTo>
                              <a:pt x="713" y="836"/>
                            </a:lnTo>
                            <a:lnTo>
                              <a:pt x="719" y="836"/>
                            </a:lnTo>
                            <a:lnTo>
                              <a:pt x="726" y="842"/>
                            </a:lnTo>
                            <a:lnTo>
                              <a:pt x="732" y="848"/>
                            </a:lnTo>
                            <a:lnTo>
                              <a:pt x="738" y="848"/>
                            </a:lnTo>
                            <a:lnTo>
                              <a:pt x="738" y="855"/>
                            </a:lnTo>
                            <a:lnTo>
                              <a:pt x="744" y="861"/>
                            </a:lnTo>
                            <a:lnTo>
                              <a:pt x="750" y="861"/>
                            </a:lnTo>
                            <a:lnTo>
                              <a:pt x="756" y="867"/>
                            </a:lnTo>
                            <a:lnTo>
                              <a:pt x="762" y="867"/>
                            </a:lnTo>
                            <a:lnTo>
                              <a:pt x="769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5" y="891"/>
                            </a:lnTo>
                            <a:lnTo>
                              <a:pt x="812" y="898"/>
                            </a:lnTo>
                            <a:lnTo>
                              <a:pt x="818" y="898"/>
                            </a:lnTo>
                            <a:lnTo>
                              <a:pt x="824" y="904"/>
                            </a:lnTo>
                            <a:lnTo>
                              <a:pt x="830" y="904"/>
                            </a:lnTo>
                            <a:lnTo>
                              <a:pt x="836" y="904"/>
                            </a:lnTo>
                            <a:lnTo>
                              <a:pt x="836" y="910"/>
                            </a:lnTo>
                            <a:lnTo>
                              <a:pt x="842" y="910"/>
                            </a:lnTo>
                            <a:lnTo>
                              <a:pt x="849" y="916"/>
                            </a:lnTo>
                            <a:lnTo>
                              <a:pt x="855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2" y="934"/>
                            </a:lnTo>
                            <a:lnTo>
                              <a:pt x="898" y="941"/>
                            </a:lnTo>
                            <a:lnTo>
                              <a:pt x="904" y="947"/>
                            </a:lnTo>
                            <a:lnTo>
                              <a:pt x="910" y="947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8" y="959"/>
                            </a:lnTo>
                            <a:lnTo>
                              <a:pt x="935" y="959"/>
                            </a:lnTo>
                            <a:lnTo>
                              <a:pt x="935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7"/>
                            </a:lnTo>
                            <a:lnTo>
                              <a:pt x="971" y="984"/>
                            </a:lnTo>
                            <a:lnTo>
                              <a:pt x="978" y="984"/>
                            </a:lnTo>
                            <a:lnTo>
                              <a:pt x="984" y="990"/>
                            </a:lnTo>
                            <a:lnTo>
                              <a:pt x="990" y="990"/>
                            </a:lnTo>
                            <a:lnTo>
                              <a:pt x="996" y="990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8" y="1002"/>
                            </a:lnTo>
                            <a:lnTo>
                              <a:pt x="1014" y="1002"/>
                            </a:lnTo>
                            <a:lnTo>
                              <a:pt x="1021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1" y="1020"/>
                            </a:lnTo>
                            <a:lnTo>
                              <a:pt x="1058" y="1027"/>
                            </a:lnTo>
                            <a:lnTo>
                              <a:pt x="1064" y="1027"/>
                            </a:lnTo>
                            <a:lnTo>
                              <a:pt x="1064" y="1033"/>
                            </a:lnTo>
                            <a:lnTo>
                              <a:pt x="1070" y="1033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1" y="1051"/>
                            </a:lnTo>
                            <a:lnTo>
                              <a:pt x="1107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4"/>
                            </a:lnTo>
                            <a:lnTo>
                              <a:pt x="1131" y="1070"/>
                            </a:lnTo>
                            <a:lnTo>
                              <a:pt x="1137" y="1070"/>
                            </a:lnTo>
                            <a:lnTo>
                              <a:pt x="1144" y="1076"/>
                            </a:lnTo>
                            <a:lnTo>
                              <a:pt x="1150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7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7"/>
                            </a:lnTo>
                            <a:lnTo>
                              <a:pt x="1211" y="1107"/>
                            </a:lnTo>
                            <a:lnTo>
                              <a:pt x="1217" y="1113"/>
                            </a:lnTo>
                            <a:lnTo>
                              <a:pt x="1223" y="1113"/>
                            </a:lnTo>
                            <a:lnTo>
                              <a:pt x="1223" y="1119"/>
                            </a:lnTo>
                            <a:lnTo>
                              <a:pt x="1230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6" y="1137"/>
                            </a:lnTo>
                            <a:lnTo>
                              <a:pt x="1273" y="1143"/>
                            </a:lnTo>
                            <a:lnTo>
                              <a:pt x="1279" y="1143"/>
                            </a:lnTo>
                            <a:lnTo>
                              <a:pt x="1285" y="1150"/>
                            </a:lnTo>
                            <a:lnTo>
                              <a:pt x="1291" y="1156"/>
                            </a:lnTo>
                            <a:lnTo>
                              <a:pt x="1297" y="1156"/>
                            </a:lnTo>
                            <a:lnTo>
                              <a:pt x="1303" y="1156"/>
                            </a:lnTo>
                            <a:lnTo>
                              <a:pt x="1310" y="1162"/>
                            </a:lnTo>
                            <a:lnTo>
                              <a:pt x="1316" y="1162"/>
                            </a:lnTo>
                          </a:path>
                        </a:pathLst>
                      </a:custGeom>
                      <a:noFill/>
                      <a:ln w="9360">
                        <a:solidFill>
                          <a:srgbClr val="0000ff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  <p:grpSp>
                <p:nvGrpSpPr>
                  <p:cNvPr id="114" name="Group 68"/>
                  <p:cNvGrpSpPr/>
                  <p:nvPr/>
                </p:nvGrpSpPr>
                <p:grpSpPr>
                  <a:xfrm>
                    <a:off x="3784320" y="3916080"/>
                    <a:ext cx="1419840" cy="1119600"/>
                    <a:chOff x="3784320" y="3916080"/>
                    <a:chExt cx="1419840" cy="1119600"/>
                  </a:xfrm>
                </p:grpSpPr>
                <p:sp>
                  <p:nvSpPr>
                    <p:cNvPr id="115" name="Line 69"/>
                    <p:cNvSpPr/>
                    <p:nvPr/>
                  </p:nvSpPr>
                  <p:spPr>
                    <a:xfrm>
                      <a:off x="3784320" y="4357800"/>
                      <a:ext cx="1419840" cy="677520"/>
                    </a:xfrm>
                    <a:prstGeom prst="line">
                      <a:avLst/>
                    </a:prstGeom>
                    <a:ln w="9360">
                      <a:solidFill>
                        <a:srgbClr val="88888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116" name="Group 70"/>
                    <p:cNvGrpSpPr/>
                    <p:nvPr/>
                  </p:nvGrpSpPr>
                  <p:grpSpPr>
                    <a:xfrm>
                      <a:off x="3784320" y="3916080"/>
                      <a:ext cx="1419840" cy="1119600"/>
                      <a:chOff x="3784320" y="3916080"/>
                      <a:chExt cx="1419840" cy="1119600"/>
                    </a:xfrm>
                  </p:grpSpPr>
                  <p:sp>
                    <p:nvSpPr>
                      <p:cNvPr id="117" name="Freeform 71"/>
                      <p:cNvSpPr/>
                      <p:nvPr/>
                    </p:nvSpPr>
                    <p:spPr>
                      <a:xfrm>
                        <a:off x="3784320" y="3916080"/>
                        <a:ext cx="1419840" cy="1119600"/>
                      </a:xfrm>
                      <a:custGeom>
                        <a:avLst/>
                        <a:gdLst>
                          <a:gd name="textAreaLeft" fmla="*/ 0 w 1419840"/>
                          <a:gd name="textAreaRight" fmla="*/ 1420200 w 1419840"/>
                          <a:gd name="textAreaTop" fmla="*/ 0 h 1119600"/>
                          <a:gd name="textAreaBottom" fmla="*/ 1119600 h 1119600"/>
                        </a:gdLst>
                        <a:ahLst/>
                        <a:rect l="textAreaLeft" t="textAreaTop" r="textAreaRight" b="textAreaBottom"/>
                        <a:pathLst>
                          <a:path w="1322" h="1168">
                            <a:moveTo>
                              <a:pt x="0" y="461"/>
                            </a:moveTo>
                            <a:lnTo>
                              <a:pt x="7" y="461"/>
                            </a:lnTo>
                            <a:lnTo>
                              <a:pt x="13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79"/>
                            </a:lnTo>
                            <a:lnTo>
                              <a:pt x="37" y="479"/>
                            </a:lnTo>
                            <a:lnTo>
                              <a:pt x="44" y="485"/>
                            </a:lnTo>
                            <a:lnTo>
                              <a:pt x="50" y="485"/>
                            </a:lnTo>
                            <a:lnTo>
                              <a:pt x="56" y="485"/>
                            </a:lnTo>
                            <a:lnTo>
                              <a:pt x="62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7" y="504"/>
                            </a:lnTo>
                            <a:lnTo>
                              <a:pt x="93" y="510"/>
                            </a:lnTo>
                            <a:lnTo>
                              <a:pt x="99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2"/>
                            </a:lnTo>
                            <a:lnTo>
                              <a:pt x="123" y="522"/>
                            </a:lnTo>
                            <a:lnTo>
                              <a:pt x="123" y="529"/>
                            </a:lnTo>
                            <a:lnTo>
                              <a:pt x="130" y="529"/>
                            </a:lnTo>
                            <a:lnTo>
                              <a:pt x="136" y="535"/>
                            </a:lnTo>
                            <a:lnTo>
                              <a:pt x="142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3" y="553"/>
                            </a:lnTo>
                            <a:lnTo>
                              <a:pt x="179" y="553"/>
                            </a:lnTo>
                            <a:lnTo>
                              <a:pt x="185" y="559"/>
                            </a:lnTo>
                            <a:lnTo>
                              <a:pt x="191" y="559"/>
                            </a:lnTo>
                            <a:lnTo>
                              <a:pt x="197" y="565"/>
                            </a:lnTo>
                            <a:lnTo>
                              <a:pt x="203" y="565"/>
                            </a:lnTo>
                            <a:lnTo>
                              <a:pt x="209" y="572"/>
                            </a:lnTo>
                            <a:lnTo>
                              <a:pt x="216" y="572"/>
                            </a:lnTo>
                            <a:lnTo>
                              <a:pt x="222" y="578"/>
                            </a:lnTo>
                            <a:lnTo>
                              <a:pt x="228" y="578"/>
                            </a:lnTo>
                            <a:lnTo>
                              <a:pt x="234" y="584"/>
                            </a:lnTo>
                            <a:lnTo>
                              <a:pt x="240" y="584"/>
                            </a:lnTo>
                            <a:lnTo>
                              <a:pt x="246" y="590"/>
                            </a:lnTo>
                            <a:lnTo>
                              <a:pt x="252" y="590"/>
                            </a:lnTo>
                            <a:lnTo>
                              <a:pt x="252" y="584"/>
                            </a:lnTo>
                            <a:lnTo>
                              <a:pt x="259" y="578"/>
                            </a:lnTo>
                            <a:lnTo>
                              <a:pt x="265" y="559"/>
                            </a:lnTo>
                            <a:lnTo>
                              <a:pt x="271" y="529"/>
                            </a:lnTo>
                            <a:lnTo>
                              <a:pt x="277" y="461"/>
                            </a:lnTo>
                            <a:lnTo>
                              <a:pt x="283" y="326"/>
                            </a:lnTo>
                            <a:lnTo>
                              <a:pt x="289" y="166"/>
                            </a:lnTo>
                            <a:lnTo>
                              <a:pt x="289" y="129"/>
                            </a:lnTo>
                            <a:lnTo>
                              <a:pt x="296" y="86"/>
                            </a:lnTo>
                            <a:lnTo>
                              <a:pt x="302" y="0"/>
                            </a:lnTo>
                            <a:lnTo>
                              <a:pt x="308" y="18"/>
                            </a:lnTo>
                            <a:lnTo>
                              <a:pt x="314" y="123"/>
                            </a:lnTo>
                            <a:lnTo>
                              <a:pt x="320" y="215"/>
                            </a:lnTo>
                            <a:lnTo>
                              <a:pt x="320" y="283"/>
                            </a:lnTo>
                            <a:lnTo>
                              <a:pt x="326" y="344"/>
                            </a:lnTo>
                            <a:lnTo>
                              <a:pt x="332" y="393"/>
                            </a:lnTo>
                            <a:lnTo>
                              <a:pt x="339" y="442"/>
                            </a:lnTo>
                            <a:lnTo>
                              <a:pt x="345" y="485"/>
                            </a:lnTo>
                            <a:lnTo>
                              <a:pt x="351" y="516"/>
                            </a:lnTo>
                            <a:lnTo>
                              <a:pt x="351" y="535"/>
                            </a:lnTo>
                            <a:lnTo>
                              <a:pt x="357" y="547"/>
                            </a:lnTo>
                            <a:lnTo>
                              <a:pt x="363" y="565"/>
                            </a:lnTo>
                            <a:lnTo>
                              <a:pt x="369" y="584"/>
                            </a:lnTo>
                            <a:lnTo>
                              <a:pt x="375" y="602"/>
                            </a:lnTo>
                            <a:lnTo>
                              <a:pt x="382" y="615"/>
                            </a:lnTo>
                            <a:lnTo>
                              <a:pt x="382" y="627"/>
                            </a:lnTo>
                            <a:lnTo>
                              <a:pt x="388" y="639"/>
                            </a:lnTo>
                            <a:lnTo>
                              <a:pt x="394" y="645"/>
                            </a:lnTo>
                            <a:lnTo>
                              <a:pt x="400" y="651"/>
                            </a:lnTo>
                            <a:lnTo>
                              <a:pt x="406" y="658"/>
                            </a:lnTo>
                            <a:lnTo>
                              <a:pt x="412" y="664"/>
                            </a:lnTo>
                            <a:lnTo>
                              <a:pt x="418" y="670"/>
                            </a:lnTo>
                            <a:lnTo>
                              <a:pt x="425" y="676"/>
                            </a:lnTo>
                            <a:lnTo>
                              <a:pt x="431" y="676"/>
                            </a:lnTo>
                            <a:lnTo>
                              <a:pt x="437" y="682"/>
                            </a:lnTo>
                            <a:lnTo>
                              <a:pt x="443" y="688"/>
                            </a:lnTo>
                            <a:lnTo>
                              <a:pt x="449" y="688"/>
                            </a:lnTo>
                            <a:lnTo>
                              <a:pt x="449" y="694"/>
                            </a:lnTo>
                            <a:lnTo>
                              <a:pt x="455" y="694"/>
                            </a:lnTo>
                            <a:lnTo>
                              <a:pt x="461" y="694"/>
                            </a:lnTo>
                            <a:lnTo>
                              <a:pt x="468" y="701"/>
                            </a:lnTo>
                            <a:lnTo>
                              <a:pt x="474" y="701"/>
                            </a:lnTo>
                            <a:lnTo>
                              <a:pt x="480" y="707"/>
                            </a:lnTo>
                            <a:lnTo>
                              <a:pt x="486" y="707"/>
                            </a:lnTo>
                            <a:lnTo>
                              <a:pt x="492" y="713"/>
                            </a:lnTo>
                            <a:lnTo>
                              <a:pt x="498" y="713"/>
                            </a:lnTo>
                            <a:lnTo>
                              <a:pt x="505" y="719"/>
                            </a:lnTo>
                            <a:lnTo>
                              <a:pt x="511" y="719"/>
                            </a:lnTo>
                            <a:lnTo>
                              <a:pt x="517" y="725"/>
                            </a:lnTo>
                            <a:lnTo>
                              <a:pt x="523" y="725"/>
                            </a:lnTo>
                            <a:lnTo>
                              <a:pt x="529" y="719"/>
                            </a:lnTo>
                            <a:lnTo>
                              <a:pt x="535" y="713"/>
                            </a:lnTo>
                            <a:lnTo>
                              <a:pt x="541" y="707"/>
                            </a:lnTo>
                            <a:lnTo>
                              <a:pt x="548" y="701"/>
                            </a:lnTo>
                            <a:lnTo>
                              <a:pt x="548" y="694"/>
                            </a:lnTo>
                            <a:lnTo>
                              <a:pt x="554" y="688"/>
                            </a:lnTo>
                            <a:lnTo>
                              <a:pt x="560" y="682"/>
                            </a:lnTo>
                            <a:lnTo>
                              <a:pt x="566" y="670"/>
                            </a:lnTo>
                            <a:lnTo>
                              <a:pt x="572" y="658"/>
                            </a:lnTo>
                            <a:lnTo>
                              <a:pt x="578" y="658"/>
                            </a:lnTo>
                            <a:lnTo>
                              <a:pt x="578" y="664"/>
                            </a:lnTo>
                            <a:lnTo>
                              <a:pt x="584" y="664"/>
                            </a:lnTo>
                            <a:lnTo>
                              <a:pt x="591" y="670"/>
                            </a:lnTo>
                            <a:lnTo>
                              <a:pt x="597" y="682"/>
                            </a:lnTo>
                            <a:lnTo>
                              <a:pt x="603" y="694"/>
                            </a:lnTo>
                            <a:lnTo>
                              <a:pt x="609" y="707"/>
                            </a:lnTo>
                            <a:lnTo>
                              <a:pt x="609" y="719"/>
                            </a:lnTo>
                            <a:lnTo>
                              <a:pt x="615" y="731"/>
                            </a:lnTo>
                            <a:lnTo>
                              <a:pt x="621" y="738"/>
                            </a:lnTo>
                            <a:lnTo>
                              <a:pt x="627" y="744"/>
                            </a:lnTo>
                            <a:lnTo>
                              <a:pt x="634" y="750"/>
                            </a:lnTo>
                            <a:lnTo>
                              <a:pt x="640" y="762"/>
                            </a:lnTo>
                            <a:lnTo>
                              <a:pt x="640" y="774"/>
                            </a:lnTo>
                            <a:lnTo>
                              <a:pt x="646" y="787"/>
                            </a:lnTo>
                            <a:lnTo>
                              <a:pt x="652" y="793"/>
                            </a:lnTo>
                            <a:lnTo>
                              <a:pt x="658" y="793"/>
                            </a:lnTo>
                            <a:lnTo>
                              <a:pt x="664" y="799"/>
                            </a:lnTo>
                            <a:lnTo>
                              <a:pt x="670" y="805"/>
                            </a:lnTo>
                            <a:lnTo>
                              <a:pt x="677" y="805"/>
                            </a:lnTo>
                            <a:lnTo>
                              <a:pt x="677" y="811"/>
                            </a:lnTo>
                            <a:lnTo>
                              <a:pt x="683" y="817"/>
                            </a:lnTo>
                            <a:lnTo>
                              <a:pt x="689" y="817"/>
                            </a:lnTo>
                            <a:lnTo>
                              <a:pt x="695" y="824"/>
                            </a:lnTo>
                            <a:lnTo>
                              <a:pt x="701" y="830"/>
                            </a:lnTo>
                            <a:lnTo>
                              <a:pt x="707" y="830"/>
                            </a:lnTo>
                            <a:lnTo>
                              <a:pt x="707" y="836"/>
                            </a:lnTo>
                            <a:lnTo>
                              <a:pt x="714" y="836"/>
                            </a:lnTo>
                            <a:lnTo>
                              <a:pt x="720" y="842"/>
                            </a:lnTo>
                            <a:lnTo>
                              <a:pt x="726" y="848"/>
                            </a:lnTo>
                            <a:lnTo>
                              <a:pt x="732" y="848"/>
                            </a:lnTo>
                            <a:lnTo>
                              <a:pt x="738" y="854"/>
                            </a:lnTo>
                            <a:lnTo>
                              <a:pt x="744" y="860"/>
                            </a:lnTo>
                            <a:lnTo>
                              <a:pt x="750" y="860"/>
                            </a:lnTo>
                            <a:lnTo>
                              <a:pt x="757" y="867"/>
                            </a:lnTo>
                            <a:lnTo>
                              <a:pt x="763" y="867"/>
                            </a:lnTo>
                            <a:lnTo>
                              <a:pt x="769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800" y="885"/>
                            </a:lnTo>
                            <a:lnTo>
                              <a:pt x="806" y="891"/>
                            </a:lnTo>
                            <a:lnTo>
                              <a:pt x="812" y="897"/>
                            </a:lnTo>
                            <a:lnTo>
                              <a:pt x="818" y="897"/>
                            </a:lnTo>
                            <a:lnTo>
                              <a:pt x="824" y="903"/>
                            </a:lnTo>
                            <a:lnTo>
                              <a:pt x="830" y="903"/>
                            </a:lnTo>
                            <a:lnTo>
                              <a:pt x="836" y="903"/>
                            </a:lnTo>
                            <a:lnTo>
                              <a:pt x="836" y="910"/>
                            </a:lnTo>
                            <a:lnTo>
                              <a:pt x="843" y="910"/>
                            </a:lnTo>
                            <a:lnTo>
                              <a:pt x="849" y="916"/>
                            </a:lnTo>
                            <a:lnTo>
                              <a:pt x="855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6" y="934"/>
                            </a:lnTo>
                            <a:lnTo>
                              <a:pt x="892" y="934"/>
                            </a:lnTo>
                            <a:lnTo>
                              <a:pt x="898" y="940"/>
                            </a:lnTo>
                            <a:lnTo>
                              <a:pt x="904" y="947"/>
                            </a:lnTo>
                            <a:lnTo>
                              <a:pt x="910" y="947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9" y="959"/>
                            </a:lnTo>
                            <a:lnTo>
                              <a:pt x="935" y="959"/>
                            </a:lnTo>
                            <a:lnTo>
                              <a:pt x="935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6" y="977"/>
                            </a:lnTo>
                            <a:lnTo>
                              <a:pt x="972" y="983"/>
                            </a:lnTo>
                            <a:lnTo>
                              <a:pt x="978" y="983"/>
                            </a:lnTo>
                            <a:lnTo>
                              <a:pt x="984" y="990"/>
                            </a:lnTo>
                            <a:lnTo>
                              <a:pt x="990" y="990"/>
                            </a:lnTo>
                            <a:lnTo>
                              <a:pt x="996" y="990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9" y="1002"/>
                            </a:lnTo>
                            <a:lnTo>
                              <a:pt x="1015" y="1002"/>
                            </a:lnTo>
                            <a:lnTo>
                              <a:pt x="1021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2" y="1020"/>
                            </a:lnTo>
                            <a:lnTo>
                              <a:pt x="1058" y="1026"/>
                            </a:lnTo>
                            <a:lnTo>
                              <a:pt x="1064" y="1026"/>
                            </a:lnTo>
                            <a:lnTo>
                              <a:pt x="1064" y="1033"/>
                            </a:lnTo>
                            <a:lnTo>
                              <a:pt x="1070" y="1033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5" y="1045"/>
                            </a:lnTo>
                            <a:lnTo>
                              <a:pt x="1101" y="1051"/>
                            </a:lnTo>
                            <a:lnTo>
                              <a:pt x="1107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3"/>
                            </a:lnTo>
                            <a:lnTo>
                              <a:pt x="1131" y="1069"/>
                            </a:lnTo>
                            <a:lnTo>
                              <a:pt x="1138" y="1069"/>
                            </a:lnTo>
                            <a:lnTo>
                              <a:pt x="1144" y="1076"/>
                            </a:lnTo>
                            <a:lnTo>
                              <a:pt x="1150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5" y="1088"/>
                            </a:lnTo>
                            <a:lnTo>
                              <a:pt x="1181" y="1094"/>
                            </a:lnTo>
                            <a:lnTo>
                              <a:pt x="1187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6"/>
                            </a:lnTo>
                            <a:lnTo>
                              <a:pt x="1211" y="1106"/>
                            </a:lnTo>
                            <a:lnTo>
                              <a:pt x="1218" y="1112"/>
                            </a:lnTo>
                            <a:lnTo>
                              <a:pt x="1224" y="1112"/>
                            </a:lnTo>
                            <a:lnTo>
                              <a:pt x="1224" y="1119"/>
                            </a:lnTo>
                            <a:lnTo>
                              <a:pt x="1230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1" y="1137"/>
                            </a:lnTo>
                            <a:lnTo>
                              <a:pt x="1267" y="1137"/>
                            </a:lnTo>
                            <a:lnTo>
                              <a:pt x="1273" y="1143"/>
                            </a:lnTo>
                            <a:lnTo>
                              <a:pt x="1279" y="1143"/>
                            </a:lnTo>
                            <a:lnTo>
                              <a:pt x="1285" y="1149"/>
                            </a:lnTo>
                            <a:lnTo>
                              <a:pt x="1291" y="1156"/>
                            </a:lnTo>
                            <a:lnTo>
                              <a:pt x="1297" y="1156"/>
                            </a:lnTo>
                            <a:lnTo>
                              <a:pt x="1304" y="1156"/>
                            </a:lnTo>
                            <a:lnTo>
                              <a:pt x="1310" y="1162"/>
                            </a:lnTo>
                            <a:lnTo>
                              <a:pt x="1316" y="1162"/>
                            </a:lnTo>
                            <a:lnTo>
                              <a:pt x="1322" y="1168"/>
                            </a:lnTo>
                            <a:lnTo>
                              <a:pt x="0" y="461"/>
                            </a:lnTo>
                            <a:close/>
                          </a:path>
                        </a:pathLst>
                      </a:custGeom>
                      <a:solidFill>
                        <a:srgbClr val="ffffff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8" name="Freeform 72"/>
                      <p:cNvSpPr/>
                      <p:nvPr/>
                    </p:nvSpPr>
                    <p:spPr>
                      <a:xfrm>
                        <a:off x="3784320" y="3916080"/>
                        <a:ext cx="1413360" cy="1113840"/>
                      </a:xfrm>
                      <a:custGeom>
                        <a:avLst/>
                        <a:gdLst>
                          <a:gd name="textAreaLeft" fmla="*/ 0 w 1413360"/>
                          <a:gd name="textAreaRight" fmla="*/ 1413360 w 1413360"/>
                          <a:gd name="textAreaTop" fmla="*/ 0 h 1113840"/>
                          <a:gd name="textAreaBottom" fmla="*/ 1114200 h 1113840"/>
                        </a:gdLst>
                        <a:ahLst/>
                        <a:rect l="textAreaLeft" t="textAreaTop" r="textAreaRight" b="textAreaBottom"/>
                        <a:pathLst>
                          <a:path w="1316" h="1162">
                            <a:moveTo>
                              <a:pt x="0" y="461"/>
                            </a:moveTo>
                            <a:lnTo>
                              <a:pt x="7" y="461"/>
                            </a:lnTo>
                            <a:lnTo>
                              <a:pt x="13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79"/>
                            </a:lnTo>
                            <a:lnTo>
                              <a:pt x="37" y="479"/>
                            </a:lnTo>
                            <a:lnTo>
                              <a:pt x="44" y="485"/>
                            </a:lnTo>
                            <a:lnTo>
                              <a:pt x="50" y="485"/>
                            </a:lnTo>
                            <a:lnTo>
                              <a:pt x="56" y="485"/>
                            </a:lnTo>
                            <a:lnTo>
                              <a:pt x="62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7" y="504"/>
                            </a:lnTo>
                            <a:lnTo>
                              <a:pt x="93" y="510"/>
                            </a:lnTo>
                            <a:lnTo>
                              <a:pt x="99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2"/>
                            </a:lnTo>
                            <a:lnTo>
                              <a:pt x="123" y="522"/>
                            </a:lnTo>
                            <a:lnTo>
                              <a:pt x="123" y="529"/>
                            </a:lnTo>
                            <a:lnTo>
                              <a:pt x="130" y="529"/>
                            </a:lnTo>
                            <a:lnTo>
                              <a:pt x="136" y="535"/>
                            </a:lnTo>
                            <a:lnTo>
                              <a:pt x="142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3" y="553"/>
                            </a:lnTo>
                            <a:lnTo>
                              <a:pt x="179" y="553"/>
                            </a:lnTo>
                            <a:lnTo>
                              <a:pt x="185" y="559"/>
                            </a:lnTo>
                            <a:lnTo>
                              <a:pt x="191" y="559"/>
                            </a:lnTo>
                            <a:lnTo>
                              <a:pt x="197" y="565"/>
                            </a:lnTo>
                            <a:lnTo>
                              <a:pt x="203" y="565"/>
                            </a:lnTo>
                            <a:lnTo>
                              <a:pt x="209" y="572"/>
                            </a:lnTo>
                            <a:lnTo>
                              <a:pt x="216" y="572"/>
                            </a:lnTo>
                            <a:lnTo>
                              <a:pt x="222" y="578"/>
                            </a:lnTo>
                            <a:lnTo>
                              <a:pt x="228" y="578"/>
                            </a:lnTo>
                            <a:lnTo>
                              <a:pt x="234" y="584"/>
                            </a:lnTo>
                            <a:lnTo>
                              <a:pt x="240" y="584"/>
                            </a:lnTo>
                            <a:lnTo>
                              <a:pt x="246" y="590"/>
                            </a:lnTo>
                            <a:lnTo>
                              <a:pt x="252" y="590"/>
                            </a:lnTo>
                            <a:lnTo>
                              <a:pt x="252" y="584"/>
                            </a:lnTo>
                            <a:lnTo>
                              <a:pt x="259" y="578"/>
                            </a:lnTo>
                            <a:lnTo>
                              <a:pt x="265" y="559"/>
                            </a:lnTo>
                            <a:lnTo>
                              <a:pt x="271" y="529"/>
                            </a:lnTo>
                            <a:lnTo>
                              <a:pt x="277" y="461"/>
                            </a:lnTo>
                            <a:lnTo>
                              <a:pt x="283" y="326"/>
                            </a:lnTo>
                            <a:lnTo>
                              <a:pt x="289" y="166"/>
                            </a:lnTo>
                            <a:lnTo>
                              <a:pt x="289" y="129"/>
                            </a:lnTo>
                            <a:lnTo>
                              <a:pt x="296" y="86"/>
                            </a:lnTo>
                            <a:lnTo>
                              <a:pt x="302" y="0"/>
                            </a:lnTo>
                            <a:lnTo>
                              <a:pt x="308" y="18"/>
                            </a:lnTo>
                            <a:lnTo>
                              <a:pt x="314" y="123"/>
                            </a:lnTo>
                            <a:lnTo>
                              <a:pt x="320" y="215"/>
                            </a:lnTo>
                            <a:lnTo>
                              <a:pt x="320" y="283"/>
                            </a:lnTo>
                            <a:lnTo>
                              <a:pt x="326" y="344"/>
                            </a:lnTo>
                            <a:lnTo>
                              <a:pt x="332" y="393"/>
                            </a:lnTo>
                            <a:lnTo>
                              <a:pt x="339" y="442"/>
                            </a:lnTo>
                            <a:lnTo>
                              <a:pt x="345" y="485"/>
                            </a:lnTo>
                            <a:lnTo>
                              <a:pt x="351" y="516"/>
                            </a:lnTo>
                            <a:lnTo>
                              <a:pt x="351" y="535"/>
                            </a:lnTo>
                            <a:lnTo>
                              <a:pt x="357" y="547"/>
                            </a:lnTo>
                            <a:lnTo>
                              <a:pt x="363" y="565"/>
                            </a:lnTo>
                            <a:lnTo>
                              <a:pt x="369" y="584"/>
                            </a:lnTo>
                            <a:lnTo>
                              <a:pt x="375" y="602"/>
                            </a:lnTo>
                            <a:lnTo>
                              <a:pt x="382" y="615"/>
                            </a:lnTo>
                            <a:lnTo>
                              <a:pt x="382" y="627"/>
                            </a:lnTo>
                            <a:lnTo>
                              <a:pt x="388" y="639"/>
                            </a:lnTo>
                            <a:lnTo>
                              <a:pt x="394" y="645"/>
                            </a:lnTo>
                            <a:lnTo>
                              <a:pt x="400" y="651"/>
                            </a:lnTo>
                            <a:lnTo>
                              <a:pt x="406" y="658"/>
                            </a:lnTo>
                            <a:lnTo>
                              <a:pt x="412" y="664"/>
                            </a:lnTo>
                            <a:lnTo>
                              <a:pt x="418" y="670"/>
                            </a:lnTo>
                            <a:lnTo>
                              <a:pt x="425" y="676"/>
                            </a:lnTo>
                            <a:lnTo>
                              <a:pt x="431" y="676"/>
                            </a:lnTo>
                            <a:lnTo>
                              <a:pt x="437" y="682"/>
                            </a:lnTo>
                            <a:lnTo>
                              <a:pt x="443" y="688"/>
                            </a:lnTo>
                            <a:lnTo>
                              <a:pt x="449" y="688"/>
                            </a:lnTo>
                            <a:lnTo>
                              <a:pt x="449" y="694"/>
                            </a:lnTo>
                            <a:lnTo>
                              <a:pt x="455" y="694"/>
                            </a:lnTo>
                            <a:lnTo>
                              <a:pt x="461" y="694"/>
                            </a:lnTo>
                            <a:lnTo>
                              <a:pt x="468" y="701"/>
                            </a:lnTo>
                            <a:lnTo>
                              <a:pt x="474" y="701"/>
                            </a:lnTo>
                            <a:lnTo>
                              <a:pt x="480" y="707"/>
                            </a:lnTo>
                            <a:lnTo>
                              <a:pt x="486" y="707"/>
                            </a:lnTo>
                            <a:lnTo>
                              <a:pt x="492" y="713"/>
                            </a:lnTo>
                            <a:lnTo>
                              <a:pt x="498" y="713"/>
                            </a:lnTo>
                            <a:lnTo>
                              <a:pt x="505" y="719"/>
                            </a:lnTo>
                            <a:lnTo>
                              <a:pt x="511" y="719"/>
                            </a:lnTo>
                            <a:lnTo>
                              <a:pt x="517" y="725"/>
                            </a:lnTo>
                            <a:lnTo>
                              <a:pt x="523" y="725"/>
                            </a:lnTo>
                            <a:lnTo>
                              <a:pt x="529" y="719"/>
                            </a:lnTo>
                            <a:lnTo>
                              <a:pt x="535" y="713"/>
                            </a:lnTo>
                            <a:lnTo>
                              <a:pt x="541" y="707"/>
                            </a:lnTo>
                            <a:lnTo>
                              <a:pt x="548" y="701"/>
                            </a:lnTo>
                            <a:lnTo>
                              <a:pt x="548" y="694"/>
                            </a:lnTo>
                            <a:lnTo>
                              <a:pt x="554" y="688"/>
                            </a:lnTo>
                            <a:lnTo>
                              <a:pt x="560" y="682"/>
                            </a:lnTo>
                            <a:lnTo>
                              <a:pt x="566" y="670"/>
                            </a:lnTo>
                            <a:lnTo>
                              <a:pt x="572" y="658"/>
                            </a:lnTo>
                            <a:lnTo>
                              <a:pt x="578" y="658"/>
                            </a:lnTo>
                            <a:lnTo>
                              <a:pt x="578" y="664"/>
                            </a:lnTo>
                            <a:lnTo>
                              <a:pt x="584" y="664"/>
                            </a:lnTo>
                            <a:lnTo>
                              <a:pt x="591" y="670"/>
                            </a:lnTo>
                            <a:lnTo>
                              <a:pt x="597" y="682"/>
                            </a:lnTo>
                            <a:lnTo>
                              <a:pt x="603" y="694"/>
                            </a:lnTo>
                            <a:lnTo>
                              <a:pt x="609" y="707"/>
                            </a:lnTo>
                            <a:lnTo>
                              <a:pt x="609" y="719"/>
                            </a:lnTo>
                            <a:lnTo>
                              <a:pt x="615" y="731"/>
                            </a:lnTo>
                            <a:lnTo>
                              <a:pt x="621" y="738"/>
                            </a:lnTo>
                            <a:lnTo>
                              <a:pt x="627" y="744"/>
                            </a:lnTo>
                            <a:lnTo>
                              <a:pt x="634" y="750"/>
                            </a:lnTo>
                            <a:lnTo>
                              <a:pt x="640" y="762"/>
                            </a:lnTo>
                            <a:lnTo>
                              <a:pt x="640" y="774"/>
                            </a:lnTo>
                            <a:lnTo>
                              <a:pt x="646" y="787"/>
                            </a:lnTo>
                            <a:lnTo>
                              <a:pt x="652" y="793"/>
                            </a:lnTo>
                            <a:lnTo>
                              <a:pt x="658" y="793"/>
                            </a:lnTo>
                            <a:lnTo>
                              <a:pt x="664" y="799"/>
                            </a:lnTo>
                            <a:lnTo>
                              <a:pt x="670" y="805"/>
                            </a:lnTo>
                            <a:lnTo>
                              <a:pt x="677" y="805"/>
                            </a:lnTo>
                            <a:lnTo>
                              <a:pt x="677" y="811"/>
                            </a:lnTo>
                            <a:lnTo>
                              <a:pt x="683" y="817"/>
                            </a:lnTo>
                            <a:lnTo>
                              <a:pt x="689" y="817"/>
                            </a:lnTo>
                            <a:lnTo>
                              <a:pt x="695" y="824"/>
                            </a:lnTo>
                            <a:lnTo>
                              <a:pt x="701" y="830"/>
                            </a:lnTo>
                            <a:lnTo>
                              <a:pt x="707" y="830"/>
                            </a:lnTo>
                            <a:lnTo>
                              <a:pt x="707" y="836"/>
                            </a:lnTo>
                            <a:lnTo>
                              <a:pt x="714" y="836"/>
                            </a:lnTo>
                            <a:lnTo>
                              <a:pt x="720" y="842"/>
                            </a:lnTo>
                            <a:lnTo>
                              <a:pt x="726" y="848"/>
                            </a:lnTo>
                            <a:lnTo>
                              <a:pt x="732" y="848"/>
                            </a:lnTo>
                            <a:lnTo>
                              <a:pt x="738" y="854"/>
                            </a:lnTo>
                            <a:lnTo>
                              <a:pt x="744" y="860"/>
                            </a:lnTo>
                            <a:lnTo>
                              <a:pt x="750" y="860"/>
                            </a:lnTo>
                            <a:lnTo>
                              <a:pt x="757" y="867"/>
                            </a:lnTo>
                            <a:lnTo>
                              <a:pt x="763" y="867"/>
                            </a:lnTo>
                            <a:lnTo>
                              <a:pt x="769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800" y="885"/>
                            </a:lnTo>
                            <a:lnTo>
                              <a:pt x="806" y="891"/>
                            </a:lnTo>
                            <a:lnTo>
                              <a:pt x="812" y="897"/>
                            </a:lnTo>
                            <a:lnTo>
                              <a:pt x="818" y="897"/>
                            </a:lnTo>
                            <a:lnTo>
                              <a:pt x="824" y="903"/>
                            </a:lnTo>
                            <a:lnTo>
                              <a:pt x="830" y="903"/>
                            </a:lnTo>
                            <a:lnTo>
                              <a:pt x="836" y="903"/>
                            </a:lnTo>
                            <a:lnTo>
                              <a:pt x="836" y="910"/>
                            </a:lnTo>
                            <a:lnTo>
                              <a:pt x="843" y="910"/>
                            </a:lnTo>
                            <a:lnTo>
                              <a:pt x="849" y="916"/>
                            </a:lnTo>
                            <a:lnTo>
                              <a:pt x="855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6" y="934"/>
                            </a:lnTo>
                            <a:lnTo>
                              <a:pt x="892" y="934"/>
                            </a:lnTo>
                            <a:lnTo>
                              <a:pt x="898" y="940"/>
                            </a:lnTo>
                            <a:lnTo>
                              <a:pt x="904" y="947"/>
                            </a:lnTo>
                            <a:lnTo>
                              <a:pt x="910" y="947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9" y="959"/>
                            </a:lnTo>
                            <a:lnTo>
                              <a:pt x="935" y="959"/>
                            </a:lnTo>
                            <a:lnTo>
                              <a:pt x="935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6" y="977"/>
                            </a:lnTo>
                            <a:lnTo>
                              <a:pt x="972" y="983"/>
                            </a:lnTo>
                            <a:lnTo>
                              <a:pt x="978" y="983"/>
                            </a:lnTo>
                            <a:lnTo>
                              <a:pt x="984" y="990"/>
                            </a:lnTo>
                            <a:lnTo>
                              <a:pt x="990" y="990"/>
                            </a:lnTo>
                            <a:lnTo>
                              <a:pt x="996" y="990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9" y="1002"/>
                            </a:lnTo>
                            <a:lnTo>
                              <a:pt x="1015" y="1002"/>
                            </a:lnTo>
                            <a:lnTo>
                              <a:pt x="1021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2" y="1020"/>
                            </a:lnTo>
                            <a:lnTo>
                              <a:pt x="1058" y="1026"/>
                            </a:lnTo>
                            <a:lnTo>
                              <a:pt x="1064" y="1026"/>
                            </a:lnTo>
                            <a:lnTo>
                              <a:pt x="1064" y="1033"/>
                            </a:lnTo>
                            <a:lnTo>
                              <a:pt x="1070" y="1033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5" y="1045"/>
                            </a:lnTo>
                            <a:lnTo>
                              <a:pt x="1101" y="1051"/>
                            </a:lnTo>
                            <a:lnTo>
                              <a:pt x="1107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3"/>
                            </a:lnTo>
                            <a:lnTo>
                              <a:pt x="1131" y="1069"/>
                            </a:lnTo>
                            <a:lnTo>
                              <a:pt x="1138" y="1069"/>
                            </a:lnTo>
                            <a:lnTo>
                              <a:pt x="1144" y="1076"/>
                            </a:lnTo>
                            <a:lnTo>
                              <a:pt x="1150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5" y="1088"/>
                            </a:lnTo>
                            <a:lnTo>
                              <a:pt x="1181" y="1094"/>
                            </a:lnTo>
                            <a:lnTo>
                              <a:pt x="1187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6"/>
                            </a:lnTo>
                            <a:lnTo>
                              <a:pt x="1211" y="1106"/>
                            </a:lnTo>
                            <a:lnTo>
                              <a:pt x="1218" y="1112"/>
                            </a:lnTo>
                            <a:lnTo>
                              <a:pt x="1224" y="1112"/>
                            </a:lnTo>
                            <a:lnTo>
                              <a:pt x="1224" y="1119"/>
                            </a:lnTo>
                            <a:lnTo>
                              <a:pt x="1230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1" y="1137"/>
                            </a:lnTo>
                            <a:lnTo>
                              <a:pt x="1267" y="1137"/>
                            </a:lnTo>
                            <a:lnTo>
                              <a:pt x="1273" y="1143"/>
                            </a:lnTo>
                            <a:lnTo>
                              <a:pt x="1279" y="1143"/>
                            </a:lnTo>
                            <a:lnTo>
                              <a:pt x="1285" y="1149"/>
                            </a:lnTo>
                            <a:lnTo>
                              <a:pt x="1291" y="1156"/>
                            </a:lnTo>
                            <a:lnTo>
                              <a:pt x="1297" y="1156"/>
                            </a:lnTo>
                            <a:lnTo>
                              <a:pt x="1304" y="1156"/>
                            </a:lnTo>
                            <a:lnTo>
                              <a:pt x="1310" y="1162"/>
                            </a:lnTo>
                            <a:lnTo>
                              <a:pt x="1316" y="1162"/>
                            </a:lnTo>
                          </a:path>
                        </a:pathLst>
                      </a:custGeom>
                      <a:noFill/>
                      <a:ln w="9360">
                        <a:solidFill>
                          <a:srgbClr val="ff0000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</p:grpSp>
            <p:grpSp>
              <p:nvGrpSpPr>
                <p:cNvPr id="119" name="Group 91"/>
                <p:cNvGrpSpPr/>
                <p:nvPr/>
              </p:nvGrpSpPr>
              <p:grpSpPr>
                <a:xfrm>
                  <a:off x="1716120" y="3532680"/>
                  <a:ext cx="1720080" cy="1713240"/>
                  <a:chOff x="1716120" y="3532680"/>
                  <a:chExt cx="1720080" cy="1713240"/>
                </a:xfrm>
              </p:grpSpPr>
              <p:sp>
                <p:nvSpPr>
                  <p:cNvPr id="120" name="Rectangle 92"/>
                  <p:cNvSpPr/>
                  <p:nvPr/>
                </p:nvSpPr>
                <p:spPr>
                  <a:xfrm>
                    <a:off x="1726200" y="3532680"/>
                    <a:ext cx="1710000" cy="152604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21" name="Group 93"/>
                  <p:cNvGrpSpPr/>
                  <p:nvPr/>
                </p:nvGrpSpPr>
                <p:grpSpPr>
                  <a:xfrm>
                    <a:off x="1726200" y="4369680"/>
                    <a:ext cx="1406880" cy="700200"/>
                    <a:chOff x="1726200" y="4369680"/>
                    <a:chExt cx="1406880" cy="700200"/>
                  </a:xfrm>
                </p:grpSpPr>
                <p:sp>
                  <p:nvSpPr>
                    <p:cNvPr id="122" name="Line 94"/>
                    <p:cNvSpPr/>
                    <p:nvPr/>
                  </p:nvSpPr>
                  <p:spPr>
                    <a:xfrm>
                      <a:off x="1726200" y="4369680"/>
                      <a:ext cx="1080" cy="342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2600" bIns="-12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3" name="Line 95"/>
                    <p:cNvSpPr/>
                    <p:nvPr/>
                  </p:nvSpPr>
                  <p:spPr>
                    <a:xfrm>
                      <a:off x="1791720" y="4398480"/>
                      <a:ext cx="1080" cy="122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560" bIns="-345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4" name="Line 96"/>
                    <p:cNvSpPr/>
                    <p:nvPr/>
                  </p:nvSpPr>
                  <p:spPr>
                    <a:xfrm>
                      <a:off x="1864800" y="4433760"/>
                      <a:ext cx="720" cy="122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560" bIns="-345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5" name="Line 97"/>
                    <p:cNvSpPr/>
                    <p:nvPr/>
                  </p:nvSpPr>
                  <p:spPr>
                    <a:xfrm>
                      <a:off x="1937880" y="446940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6" name="Line 98"/>
                    <p:cNvSpPr/>
                    <p:nvPr/>
                  </p:nvSpPr>
                  <p:spPr>
                    <a:xfrm>
                      <a:off x="2003400" y="4498920"/>
                      <a:ext cx="720" cy="3528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520" bIns="-11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7" name="Line 99"/>
                    <p:cNvSpPr/>
                    <p:nvPr/>
                  </p:nvSpPr>
                  <p:spPr>
                    <a:xfrm>
                      <a:off x="2076480" y="453456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8" name="Line 100"/>
                    <p:cNvSpPr/>
                    <p:nvPr/>
                  </p:nvSpPr>
                  <p:spPr>
                    <a:xfrm>
                      <a:off x="2148120" y="456984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9" name="Line 101"/>
                    <p:cNvSpPr/>
                    <p:nvPr/>
                  </p:nvSpPr>
                  <p:spPr>
                    <a:xfrm>
                      <a:off x="2215080" y="4598640"/>
                      <a:ext cx="720" cy="126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200" bIns="-342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0" name="Line 102"/>
                    <p:cNvSpPr/>
                    <p:nvPr/>
                  </p:nvSpPr>
                  <p:spPr>
                    <a:xfrm>
                      <a:off x="2286720" y="4634280"/>
                      <a:ext cx="1080" cy="3528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520" bIns="-11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1" name="Line 103"/>
                    <p:cNvSpPr/>
                    <p:nvPr/>
                  </p:nvSpPr>
                  <p:spPr>
                    <a:xfrm>
                      <a:off x="2359800" y="466956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2" name="Line 104"/>
                    <p:cNvSpPr/>
                    <p:nvPr/>
                  </p:nvSpPr>
                  <p:spPr>
                    <a:xfrm>
                      <a:off x="2426400" y="469908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3" name="Line 105"/>
                    <p:cNvSpPr/>
                    <p:nvPr/>
                  </p:nvSpPr>
                  <p:spPr>
                    <a:xfrm>
                      <a:off x="2498400" y="473472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4" name="Line 106"/>
                    <p:cNvSpPr/>
                    <p:nvPr/>
                  </p:nvSpPr>
                  <p:spPr>
                    <a:xfrm>
                      <a:off x="2571480" y="4770360"/>
                      <a:ext cx="720" cy="342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2600" bIns="-12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5" name="Line 107"/>
                    <p:cNvSpPr/>
                    <p:nvPr/>
                  </p:nvSpPr>
                  <p:spPr>
                    <a:xfrm>
                      <a:off x="2643480" y="4804560"/>
                      <a:ext cx="1080" cy="126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200" bIns="-342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6" name="Line 108"/>
                    <p:cNvSpPr/>
                    <p:nvPr/>
                  </p:nvSpPr>
                  <p:spPr>
                    <a:xfrm>
                      <a:off x="2710080" y="4834440"/>
                      <a:ext cx="720" cy="122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560" bIns="-345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7" name="Line 109"/>
                    <p:cNvSpPr/>
                    <p:nvPr/>
                  </p:nvSpPr>
                  <p:spPr>
                    <a:xfrm>
                      <a:off x="2782080" y="486972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8" name="Line 110"/>
                    <p:cNvSpPr/>
                    <p:nvPr/>
                  </p:nvSpPr>
                  <p:spPr>
                    <a:xfrm>
                      <a:off x="2855160" y="4905360"/>
                      <a:ext cx="720" cy="356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160" bIns="-111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9" name="Line 111"/>
                    <p:cNvSpPr/>
                    <p:nvPr/>
                  </p:nvSpPr>
                  <p:spPr>
                    <a:xfrm>
                      <a:off x="2921760" y="4934880"/>
                      <a:ext cx="108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0" name="Line 112"/>
                    <p:cNvSpPr/>
                    <p:nvPr/>
                  </p:nvSpPr>
                  <p:spPr>
                    <a:xfrm>
                      <a:off x="2993760" y="4970520"/>
                      <a:ext cx="720" cy="111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5640" bIns="-356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1" name="Line 113"/>
                    <p:cNvSpPr/>
                    <p:nvPr/>
                  </p:nvSpPr>
                  <p:spPr>
                    <a:xfrm>
                      <a:off x="3066840" y="5005080"/>
                      <a:ext cx="720" cy="122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4560" bIns="-345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2" name="Line 114"/>
                    <p:cNvSpPr/>
                    <p:nvPr/>
                  </p:nvSpPr>
                  <p:spPr>
                    <a:xfrm>
                      <a:off x="3132360" y="5034600"/>
                      <a:ext cx="720" cy="3528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520" bIns="-11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43" name="Group 115"/>
                  <p:cNvGrpSpPr/>
                  <p:nvPr/>
                </p:nvGrpSpPr>
                <p:grpSpPr>
                  <a:xfrm>
                    <a:off x="1716120" y="4439520"/>
                    <a:ext cx="1621440" cy="806400"/>
                    <a:chOff x="1716120" y="4439520"/>
                    <a:chExt cx="1621440" cy="806400"/>
                  </a:xfrm>
                </p:grpSpPr>
                <p:sp>
                  <p:nvSpPr>
                    <p:cNvPr id="144" name="Rectangle 116"/>
                    <p:cNvSpPr/>
                    <p:nvPr/>
                  </p:nvSpPr>
                  <p:spPr>
                    <a:xfrm>
                      <a:off x="1716120" y="4439520"/>
                      <a:ext cx="648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5" name="Rectangle 117"/>
                    <p:cNvSpPr/>
                    <p:nvPr/>
                  </p:nvSpPr>
                  <p:spPr>
                    <a:xfrm>
                      <a:off x="1968480" y="4568760"/>
                      <a:ext cx="1926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6" name="Rectangle 118"/>
                    <p:cNvSpPr/>
                    <p:nvPr/>
                  </p:nvSpPr>
                  <p:spPr>
                    <a:xfrm>
                      <a:off x="2251080" y="4703760"/>
                      <a:ext cx="1926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7" name="Rectangle 119"/>
                    <p:cNvSpPr/>
                    <p:nvPr/>
                  </p:nvSpPr>
                  <p:spPr>
                    <a:xfrm>
                      <a:off x="2535840" y="4839120"/>
                      <a:ext cx="1926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8" name="Rectangle 120"/>
                    <p:cNvSpPr/>
                    <p:nvPr/>
                  </p:nvSpPr>
                  <p:spPr>
                    <a:xfrm>
                      <a:off x="2820240" y="4976280"/>
                      <a:ext cx="19260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9" name="Rectangle 121"/>
                    <p:cNvSpPr/>
                    <p:nvPr/>
                  </p:nvSpPr>
                  <p:spPr>
                    <a:xfrm>
                      <a:off x="3080880" y="5108400"/>
                      <a:ext cx="256680" cy="1375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50" name="Group 122"/>
                  <p:cNvGrpSpPr/>
                  <p:nvPr/>
                </p:nvGrpSpPr>
                <p:grpSpPr>
                  <a:xfrm>
                    <a:off x="1738800" y="4139280"/>
                    <a:ext cx="1637640" cy="889200"/>
                    <a:chOff x="1738800" y="4139280"/>
                    <a:chExt cx="1637640" cy="889200"/>
                  </a:xfrm>
                </p:grpSpPr>
                <p:sp>
                  <p:nvSpPr>
                    <p:cNvPr id="151" name="Line 123"/>
                    <p:cNvSpPr/>
                    <p:nvPr/>
                  </p:nvSpPr>
                  <p:spPr>
                    <a:xfrm flipV="1">
                      <a:off x="1738800" y="413928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2" name="Line 124"/>
                    <p:cNvSpPr/>
                    <p:nvPr/>
                  </p:nvSpPr>
                  <p:spPr>
                    <a:xfrm flipV="1">
                      <a:off x="1805400" y="4168800"/>
                      <a:ext cx="25632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3" name="Line 125"/>
                    <p:cNvSpPr/>
                    <p:nvPr/>
                  </p:nvSpPr>
                  <p:spPr>
                    <a:xfrm flipV="1">
                      <a:off x="1870920" y="419760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4" name="Line 126"/>
                    <p:cNvSpPr/>
                    <p:nvPr/>
                  </p:nvSpPr>
                  <p:spPr>
                    <a:xfrm flipV="1">
                      <a:off x="1943640" y="4232520"/>
                      <a:ext cx="257760" cy="23004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5" name="Line 127"/>
                    <p:cNvSpPr/>
                    <p:nvPr/>
                  </p:nvSpPr>
                  <p:spPr>
                    <a:xfrm flipV="1">
                      <a:off x="2009160" y="4268160"/>
                      <a:ext cx="257760" cy="23004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6" name="Line 128"/>
                    <p:cNvSpPr/>
                    <p:nvPr/>
                  </p:nvSpPr>
                  <p:spPr>
                    <a:xfrm flipV="1">
                      <a:off x="2082240" y="4298400"/>
                      <a:ext cx="25776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7" name="Line 129"/>
                    <p:cNvSpPr/>
                    <p:nvPr/>
                  </p:nvSpPr>
                  <p:spPr>
                    <a:xfrm flipV="1">
                      <a:off x="2147760" y="4333680"/>
                      <a:ext cx="25776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8" name="Line 130"/>
                    <p:cNvSpPr/>
                    <p:nvPr/>
                  </p:nvSpPr>
                  <p:spPr>
                    <a:xfrm flipV="1">
                      <a:off x="2220840" y="4368960"/>
                      <a:ext cx="25740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9" name="Line 131"/>
                    <p:cNvSpPr/>
                    <p:nvPr/>
                  </p:nvSpPr>
                  <p:spPr>
                    <a:xfrm flipV="1">
                      <a:off x="2286360" y="439812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0" name="Line 132"/>
                    <p:cNvSpPr/>
                    <p:nvPr/>
                  </p:nvSpPr>
                  <p:spPr>
                    <a:xfrm flipV="1">
                      <a:off x="2359440" y="443340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1" name="Line 133"/>
                    <p:cNvSpPr/>
                    <p:nvPr/>
                  </p:nvSpPr>
                  <p:spPr>
                    <a:xfrm flipV="1">
                      <a:off x="2426040" y="4463280"/>
                      <a:ext cx="25668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2" name="Line 134"/>
                    <p:cNvSpPr/>
                    <p:nvPr/>
                  </p:nvSpPr>
                  <p:spPr>
                    <a:xfrm flipV="1">
                      <a:off x="2498040" y="449856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3" name="Line 135"/>
                    <p:cNvSpPr/>
                    <p:nvPr/>
                  </p:nvSpPr>
                  <p:spPr>
                    <a:xfrm flipV="1">
                      <a:off x="2564640" y="4534200"/>
                      <a:ext cx="256680" cy="22896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4" name="Line 136"/>
                    <p:cNvSpPr/>
                    <p:nvPr/>
                  </p:nvSpPr>
                  <p:spPr>
                    <a:xfrm flipV="1">
                      <a:off x="2636640" y="4569480"/>
                      <a:ext cx="25740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5" name="Line 137"/>
                    <p:cNvSpPr/>
                    <p:nvPr/>
                  </p:nvSpPr>
                  <p:spPr>
                    <a:xfrm flipV="1">
                      <a:off x="2703240" y="4597920"/>
                      <a:ext cx="256680" cy="23004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6" name="Line 138"/>
                    <p:cNvSpPr/>
                    <p:nvPr/>
                  </p:nvSpPr>
                  <p:spPr>
                    <a:xfrm flipV="1">
                      <a:off x="2775240" y="463392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7" name="Line 139"/>
                    <p:cNvSpPr/>
                    <p:nvPr/>
                  </p:nvSpPr>
                  <p:spPr>
                    <a:xfrm flipV="1">
                      <a:off x="2841840" y="4663080"/>
                      <a:ext cx="257400" cy="23004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8" name="Line 140"/>
                    <p:cNvSpPr/>
                    <p:nvPr/>
                  </p:nvSpPr>
                  <p:spPr>
                    <a:xfrm flipV="1">
                      <a:off x="2913840" y="4698720"/>
                      <a:ext cx="257760" cy="23004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9" name="Line 141"/>
                    <p:cNvSpPr/>
                    <p:nvPr/>
                  </p:nvSpPr>
                  <p:spPr>
                    <a:xfrm flipV="1">
                      <a:off x="2980440" y="4728600"/>
                      <a:ext cx="257400" cy="22896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0" name="Line 142"/>
                    <p:cNvSpPr/>
                    <p:nvPr/>
                  </p:nvSpPr>
                  <p:spPr>
                    <a:xfrm flipV="1">
                      <a:off x="3052440" y="4763160"/>
                      <a:ext cx="257760" cy="229680"/>
                    </a:xfrm>
                    <a:prstGeom prst="line">
                      <a:avLst/>
                    </a:prstGeom>
                    <a:ln w="9360">
                      <a:solidFill>
                        <a:srgbClr val="dddddd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1" name="Line 143"/>
                    <p:cNvSpPr/>
                    <p:nvPr/>
                  </p:nvSpPr>
                  <p:spPr>
                    <a:xfrm flipV="1">
                      <a:off x="3119040" y="4798800"/>
                      <a:ext cx="257400" cy="229680"/>
                    </a:xfrm>
                    <a:prstGeom prst="line">
                      <a:avLst/>
                    </a:prstGeom>
                    <a:ln w="9360">
                      <a:solidFill>
                        <a:srgbClr val="aaaaaa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72" name="Group 144"/>
                  <p:cNvGrpSpPr/>
                  <p:nvPr/>
                </p:nvGrpSpPr>
                <p:grpSpPr>
                  <a:xfrm>
                    <a:off x="1996560" y="3697200"/>
                    <a:ext cx="1419840" cy="1119600"/>
                    <a:chOff x="1996560" y="3697200"/>
                    <a:chExt cx="1419840" cy="1119600"/>
                  </a:xfrm>
                </p:grpSpPr>
                <p:sp>
                  <p:nvSpPr>
                    <p:cNvPr id="173" name="Line 145"/>
                    <p:cNvSpPr/>
                    <p:nvPr/>
                  </p:nvSpPr>
                  <p:spPr>
                    <a:xfrm>
                      <a:off x="1996560" y="4138920"/>
                      <a:ext cx="1419840" cy="677520"/>
                    </a:xfrm>
                    <a:prstGeom prst="line">
                      <a:avLst/>
                    </a:prstGeom>
                    <a:ln w="9360">
                      <a:solidFill>
                        <a:srgbClr val="88888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174" name="Group 146"/>
                    <p:cNvGrpSpPr/>
                    <p:nvPr/>
                  </p:nvGrpSpPr>
                  <p:grpSpPr>
                    <a:xfrm>
                      <a:off x="1996560" y="3697200"/>
                      <a:ext cx="1419840" cy="1119600"/>
                      <a:chOff x="1996560" y="3697200"/>
                      <a:chExt cx="1419840" cy="1119600"/>
                    </a:xfrm>
                  </p:grpSpPr>
                  <p:sp>
                    <p:nvSpPr>
                      <p:cNvPr id="175" name="Freeform 147"/>
                      <p:cNvSpPr/>
                      <p:nvPr/>
                    </p:nvSpPr>
                    <p:spPr>
                      <a:xfrm>
                        <a:off x="1996560" y="3697200"/>
                        <a:ext cx="1419840" cy="1119600"/>
                      </a:xfrm>
                      <a:custGeom>
                        <a:avLst/>
                        <a:gdLst>
                          <a:gd name="textAreaLeft" fmla="*/ 0 w 1419840"/>
                          <a:gd name="textAreaRight" fmla="*/ 1420200 w 1419840"/>
                          <a:gd name="textAreaTop" fmla="*/ 0 h 1119600"/>
                          <a:gd name="textAreaBottom" fmla="*/ 1119600 h 1119600"/>
                        </a:gdLst>
                        <a:ahLst/>
                        <a:rect l="textAreaLeft" t="textAreaTop" r="textAreaRight" b="textAreaBottom"/>
                        <a:pathLst>
                          <a:path w="1322" h="1168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2" y="467"/>
                            </a:lnTo>
                            <a:lnTo>
                              <a:pt x="18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79"/>
                            </a:lnTo>
                            <a:lnTo>
                              <a:pt x="37" y="479"/>
                            </a:lnTo>
                            <a:lnTo>
                              <a:pt x="43" y="485"/>
                            </a:lnTo>
                            <a:lnTo>
                              <a:pt x="49" y="485"/>
                            </a:lnTo>
                            <a:lnTo>
                              <a:pt x="55" y="485"/>
                            </a:lnTo>
                            <a:lnTo>
                              <a:pt x="61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8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2"/>
                            </a:lnTo>
                            <a:lnTo>
                              <a:pt x="123" y="522"/>
                            </a:lnTo>
                            <a:lnTo>
                              <a:pt x="123" y="528"/>
                            </a:lnTo>
                            <a:lnTo>
                              <a:pt x="129" y="528"/>
                            </a:lnTo>
                            <a:lnTo>
                              <a:pt x="135" y="535"/>
                            </a:lnTo>
                            <a:lnTo>
                              <a:pt x="141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53"/>
                            </a:lnTo>
                            <a:lnTo>
                              <a:pt x="178" y="553"/>
                            </a:lnTo>
                            <a:lnTo>
                              <a:pt x="184" y="559"/>
                            </a:lnTo>
                            <a:lnTo>
                              <a:pt x="191" y="559"/>
                            </a:lnTo>
                            <a:lnTo>
                              <a:pt x="191" y="565"/>
                            </a:lnTo>
                            <a:lnTo>
                              <a:pt x="197" y="565"/>
                            </a:lnTo>
                            <a:lnTo>
                              <a:pt x="203" y="565"/>
                            </a:lnTo>
                            <a:lnTo>
                              <a:pt x="209" y="571"/>
                            </a:lnTo>
                            <a:lnTo>
                              <a:pt x="215" y="571"/>
                            </a:lnTo>
                            <a:lnTo>
                              <a:pt x="221" y="578"/>
                            </a:lnTo>
                            <a:lnTo>
                              <a:pt x="227" y="578"/>
                            </a:lnTo>
                            <a:lnTo>
                              <a:pt x="234" y="584"/>
                            </a:lnTo>
                            <a:lnTo>
                              <a:pt x="240" y="584"/>
                            </a:lnTo>
                            <a:lnTo>
                              <a:pt x="246" y="584"/>
                            </a:lnTo>
                            <a:lnTo>
                              <a:pt x="252" y="590"/>
                            </a:lnTo>
                            <a:lnTo>
                              <a:pt x="258" y="590"/>
                            </a:lnTo>
                            <a:lnTo>
                              <a:pt x="264" y="590"/>
                            </a:lnTo>
                            <a:lnTo>
                              <a:pt x="270" y="584"/>
                            </a:lnTo>
                            <a:lnTo>
                              <a:pt x="277" y="571"/>
                            </a:lnTo>
                            <a:lnTo>
                              <a:pt x="283" y="559"/>
                            </a:lnTo>
                            <a:lnTo>
                              <a:pt x="289" y="547"/>
                            </a:lnTo>
                            <a:lnTo>
                              <a:pt x="289" y="516"/>
                            </a:lnTo>
                            <a:lnTo>
                              <a:pt x="295" y="467"/>
                            </a:lnTo>
                            <a:lnTo>
                              <a:pt x="301" y="412"/>
                            </a:lnTo>
                            <a:lnTo>
                              <a:pt x="307" y="344"/>
                            </a:lnTo>
                            <a:lnTo>
                              <a:pt x="313" y="283"/>
                            </a:lnTo>
                            <a:lnTo>
                              <a:pt x="320" y="209"/>
                            </a:lnTo>
                            <a:lnTo>
                              <a:pt x="320" y="123"/>
                            </a:lnTo>
                            <a:lnTo>
                              <a:pt x="326" y="74"/>
                            </a:lnTo>
                            <a:lnTo>
                              <a:pt x="332" y="86"/>
                            </a:lnTo>
                            <a:lnTo>
                              <a:pt x="338" y="6"/>
                            </a:lnTo>
                            <a:lnTo>
                              <a:pt x="344" y="0"/>
                            </a:lnTo>
                            <a:lnTo>
                              <a:pt x="350" y="104"/>
                            </a:lnTo>
                            <a:lnTo>
                              <a:pt x="350" y="209"/>
                            </a:lnTo>
                            <a:lnTo>
                              <a:pt x="357" y="283"/>
                            </a:lnTo>
                            <a:lnTo>
                              <a:pt x="363" y="344"/>
                            </a:lnTo>
                            <a:lnTo>
                              <a:pt x="369" y="406"/>
                            </a:lnTo>
                            <a:lnTo>
                              <a:pt x="375" y="449"/>
                            </a:lnTo>
                            <a:lnTo>
                              <a:pt x="381" y="485"/>
                            </a:lnTo>
                            <a:lnTo>
                              <a:pt x="381" y="528"/>
                            </a:lnTo>
                            <a:lnTo>
                              <a:pt x="387" y="559"/>
                            </a:lnTo>
                            <a:lnTo>
                              <a:pt x="393" y="590"/>
                            </a:lnTo>
                            <a:lnTo>
                              <a:pt x="400" y="615"/>
                            </a:lnTo>
                            <a:lnTo>
                              <a:pt x="406" y="633"/>
                            </a:lnTo>
                            <a:lnTo>
                              <a:pt x="412" y="645"/>
                            </a:lnTo>
                            <a:lnTo>
                              <a:pt x="418" y="651"/>
                            </a:lnTo>
                            <a:lnTo>
                              <a:pt x="418" y="658"/>
                            </a:lnTo>
                            <a:lnTo>
                              <a:pt x="424" y="664"/>
                            </a:lnTo>
                            <a:lnTo>
                              <a:pt x="430" y="670"/>
                            </a:lnTo>
                            <a:lnTo>
                              <a:pt x="436" y="676"/>
                            </a:lnTo>
                            <a:lnTo>
                              <a:pt x="443" y="682"/>
                            </a:lnTo>
                            <a:lnTo>
                              <a:pt x="449" y="688"/>
                            </a:lnTo>
                            <a:lnTo>
                              <a:pt x="455" y="694"/>
                            </a:lnTo>
                            <a:lnTo>
                              <a:pt x="461" y="694"/>
                            </a:lnTo>
                            <a:lnTo>
                              <a:pt x="467" y="701"/>
                            </a:lnTo>
                            <a:lnTo>
                              <a:pt x="473" y="701"/>
                            </a:lnTo>
                            <a:lnTo>
                              <a:pt x="479" y="707"/>
                            </a:lnTo>
                            <a:lnTo>
                              <a:pt x="486" y="707"/>
                            </a:lnTo>
                            <a:lnTo>
                              <a:pt x="492" y="707"/>
                            </a:lnTo>
                            <a:lnTo>
                              <a:pt x="498" y="707"/>
                            </a:lnTo>
                            <a:lnTo>
                              <a:pt x="504" y="707"/>
                            </a:lnTo>
                            <a:lnTo>
                              <a:pt x="510" y="707"/>
                            </a:lnTo>
                            <a:lnTo>
                              <a:pt x="516" y="707"/>
                            </a:lnTo>
                            <a:lnTo>
                              <a:pt x="522" y="701"/>
                            </a:lnTo>
                            <a:lnTo>
                              <a:pt x="529" y="701"/>
                            </a:lnTo>
                            <a:lnTo>
                              <a:pt x="535" y="694"/>
                            </a:lnTo>
                            <a:lnTo>
                              <a:pt x="541" y="688"/>
                            </a:lnTo>
                            <a:lnTo>
                              <a:pt x="547" y="688"/>
                            </a:lnTo>
                            <a:lnTo>
                              <a:pt x="547" y="682"/>
                            </a:lnTo>
                            <a:lnTo>
                              <a:pt x="553" y="676"/>
                            </a:lnTo>
                            <a:lnTo>
                              <a:pt x="559" y="664"/>
                            </a:lnTo>
                            <a:lnTo>
                              <a:pt x="566" y="651"/>
                            </a:lnTo>
                            <a:lnTo>
                              <a:pt x="572" y="633"/>
                            </a:lnTo>
                            <a:lnTo>
                              <a:pt x="578" y="621"/>
                            </a:lnTo>
                            <a:lnTo>
                              <a:pt x="578" y="608"/>
                            </a:lnTo>
                            <a:lnTo>
                              <a:pt x="584" y="602"/>
                            </a:lnTo>
                            <a:lnTo>
                              <a:pt x="590" y="584"/>
                            </a:lnTo>
                            <a:lnTo>
                              <a:pt x="596" y="553"/>
                            </a:lnTo>
                            <a:lnTo>
                              <a:pt x="602" y="522"/>
                            </a:lnTo>
                            <a:lnTo>
                              <a:pt x="609" y="504"/>
                            </a:lnTo>
                            <a:lnTo>
                              <a:pt x="609" y="492"/>
                            </a:lnTo>
                            <a:lnTo>
                              <a:pt x="615" y="492"/>
                            </a:lnTo>
                            <a:lnTo>
                              <a:pt x="621" y="492"/>
                            </a:lnTo>
                            <a:lnTo>
                              <a:pt x="627" y="504"/>
                            </a:lnTo>
                            <a:lnTo>
                              <a:pt x="633" y="541"/>
                            </a:lnTo>
                            <a:lnTo>
                              <a:pt x="639" y="565"/>
                            </a:lnTo>
                            <a:lnTo>
                              <a:pt x="639" y="584"/>
                            </a:lnTo>
                            <a:lnTo>
                              <a:pt x="645" y="615"/>
                            </a:lnTo>
                            <a:lnTo>
                              <a:pt x="652" y="639"/>
                            </a:lnTo>
                            <a:lnTo>
                              <a:pt x="658" y="658"/>
                            </a:lnTo>
                            <a:lnTo>
                              <a:pt x="664" y="670"/>
                            </a:lnTo>
                            <a:lnTo>
                              <a:pt x="670" y="682"/>
                            </a:lnTo>
                            <a:lnTo>
                              <a:pt x="676" y="707"/>
                            </a:lnTo>
                            <a:lnTo>
                              <a:pt x="676" y="725"/>
                            </a:lnTo>
                            <a:lnTo>
                              <a:pt x="682" y="750"/>
                            </a:lnTo>
                            <a:lnTo>
                              <a:pt x="688" y="762"/>
                            </a:lnTo>
                            <a:lnTo>
                              <a:pt x="695" y="774"/>
                            </a:lnTo>
                            <a:lnTo>
                              <a:pt x="701" y="781"/>
                            </a:lnTo>
                            <a:lnTo>
                              <a:pt x="707" y="793"/>
                            </a:lnTo>
                            <a:lnTo>
                              <a:pt x="707" y="811"/>
                            </a:lnTo>
                            <a:lnTo>
                              <a:pt x="713" y="824"/>
                            </a:lnTo>
                            <a:lnTo>
                              <a:pt x="719" y="830"/>
                            </a:lnTo>
                            <a:lnTo>
                              <a:pt x="725" y="836"/>
                            </a:lnTo>
                            <a:lnTo>
                              <a:pt x="731" y="842"/>
                            </a:lnTo>
                            <a:lnTo>
                              <a:pt x="738" y="848"/>
                            </a:lnTo>
                            <a:lnTo>
                              <a:pt x="738" y="854"/>
                            </a:lnTo>
                            <a:lnTo>
                              <a:pt x="744" y="860"/>
                            </a:lnTo>
                            <a:lnTo>
                              <a:pt x="750" y="860"/>
                            </a:lnTo>
                            <a:lnTo>
                              <a:pt x="756" y="867"/>
                            </a:lnTo>
                            <a:lnTo>
                              <a:pt x="762" y="867"/>
                            </a:lnTo>
                            <a:lnTo>
                              <a:pt x="768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5" y="891"/>
                            </a:lnTo>
                            <a:lnTo>
                              <a:pt x="811" y="897"/>
                            </a:lnTo>
                            <a:lnTo>
                              <a:pt x="818" y="897"/>
                            </a:lnTo>
                            <a:lnTo>
                              <a:pt x="824" y="903"/>
                            </a:lnTo>
                            <a:lnTo>
                              <a:pt x="830" y="903"/>
                            </a:lnTo>
                            <a:lnTo>
                              <a:pt x="836" y="903"/>
                            </a:lnTo>
                            <a:lnTo>
                              <a:pt x="836" y="910"/>
                            </a:lnTo>
                            <a:lnTo>
                              <a:pt x="842" y="910"/>
                            </a:lnTo>
                            <a:lnTo>
                              <a:pt x="848" y="916"/>
                            </a:lnTo>
                            <a:lnTo>
                              <a:pt x="854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1" y="934"/>
                            </a:lnTo>
                            <a:lnTo>
                              <a:pt x="897" y="940"/>
                            </a:lnTo>
                            <a:lnTo>
                              <a:pt x="904" y="946"/>
                            </a:lnTo>
                            <a:lnTo>
                              <a:pt x="910" y="946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8" y="959"/>
                            </a:lnTo>
                            <a:lnTo>
                              <a:pt x="934" y="959"/>
                            </a:lnTo>
                            <a:lnTo>
                              <a:pt x="934" y="965"/>
                            </a:lnTo>
                            <a:lnTo>
                              <a:pt x="940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7"/>
                            </a:lnTo>
                            <a:lnTo>
                              <a:pt x="971" y="983"/>
                            </a:lnTo>
                            <a:lnTo>
                              <a:pt x="977" y="983"/>
                            </a:lnTo>
                            <a:lnTo>
                              <a:pt x="983" y="990"/>
                            </a:lnTo>
                            <a:lnTo>
                              <a:pt x="990" y="990"/>
                            </a:lnTo>
                            <a:lnTo>
                              <a:pt x="996" y="990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8" y="1002"/>
                            </a:lnTo>
                            <a:lnTo>
                              <a:pt x="1014" y="1002"/>
                            </a:lnTo>
                            <a:lnTo>
                              <a:pt x="1020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1" y="1020"/>
                            </a:lnTo>
                            <a:lnTo>
                              <a:pt x="1057" y="1026"/>
                            </a:lnTo>
                            <a:lnTo>
                              <a:pt x="1063" y="1026"/>
                            </a:lnTo>
                            <a:lnTo>
                              <a:pt x="1063" y="1033"/>
                            </a:lnTo>
                            <a:lnTo>
                              <a:pt x="1070" y="1033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0" y="1051"/>
                            </a:lnTo>
                            <a:lnTo>
                              <a:pt x="1106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3"/>
                            </a:lnTo>
                            <a:lnTo>
                              <a:pt x="1131" y="1069"/>
                            </a:lnTo>
                            <a:lnTo>
                              <a:pt x="1137" y="1069"/>
                            </a:lnTo>
                            <a:lnTo>
                              <a:pt x="1143" y="1076"/>
                            </a:lnTo>
                            <a:lnTo>
                              <a:pt x="1149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6" y="1094"/>
                            </a:lnTo>
                            <a:lnTo>
                              <a:pt x="1192" y="1100"/>
                            </a:lnTo>
                            <a:lnTo>
                              <a:pt x="1199" y="1100"/>
                            </a:lnTo>
                            <a:lnTo>
                              <a:pt x="1205" y="1106"/>
                            </a:lnTo>
                            <a:lnTo>
                              <a:pt x="1211" y="1106"/>
                            </a:lnTo>
                            <a:lnTo>
                              <a:pt x="1217" y="1112"/>
                            </a:lnTo>
                            <a:lnTo>
                              <a:pt x="1223" y="1112"/>
                            </a:lnTo>
                            <a:lnTo>
                              <a:pt x="1223" y="1119"/>
                            </a:lnTo>
                            <a:lnTo>
                              <a:pt x="1229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6" y="1137"/>
                            </a:lnTo>
                            <a:lnTo>
                              <a:pt x="1272" y="1143"/>
                            </a:lnTo>
                            <a:lnTo>
                              <a:pt x="1279" y="1143"/>
                            </a:lnTo>
                            <a:lnTo>
                              <a:pt x="1285" y="1149"/>
                            </a:lnTo>
                            <a:lnTo>
                              <a:pt x="1291" y="1155"/>
                            </a:lnTo>
                            <a:lnTo>
                              <a:pt x="1297" y="1155"/>
                            </a:lnTo>
                            <a:lnTo>
                              <a:pt x="1303" y="1155"/>
                            </a:lnTo>
                            <a:lnTo>
                              <a:pt x="1309" y="1162"/>
                            </a:lnTo>
                            <a:lnTo>
                              <a:pt x="1315" y="1162"/>
                            </a:lnTo>
                            <a:lnTo>
                              <a:pt x="1322" y="1168"/>
                            </a:lnTo>
                            <a:lnTo>
                              <a:pt x="0" y="461"/>
                            </a:lnTo>
                            <a:close/>
                          </a:path>
                        </a:pathLst>
                      </a:custGeom>
                      <a:solidFill>
                        <a:srgbClr val="ffffff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76" name="Freeform 148"/>
                      <p:cNvSpPr/>
                      <p:nvPr/>
                    </p:nvSpPr>
                    <p:spPr>
                      <a:xfrm>
                        <a:off x="1996560" y="3697200"/>
                        <a:ext cx="1412280" cy="1113840"/>
                      </a:xfrm>
                      <a:custGeom>
                        <a:avLst/>
                        <a:gdLst>
                          <a:gd name="textAreaLeft" fmla="*/ 0 w 1412280"/>
                          <a:gd name="textAreaRight" fmla="*/ 1412640 w 1412280"/>
                          <a:gd name="textAreaTop" fmla="*/ 0 h 1113840"/>
                          <a:gd name="textAreaBottom" fmla="*/ 1114200 h 1113840"/>
                        </a:gdLst>
                        <a:ahLst/>
                        <a:rect l="textAreaLeft" t="textAreaTop" r="textAreaRight" b="textAreaBottom"/>
                        <a:pathLst>
                          <a:path w="1315" h="1162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2" y="467"/>
                            </a:lnTo>
                            <a:lnTo>
                              <a:pt x="18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79"/>
                            </a:lnTo>
                            <a:lnTo>
                              <a:pt x="37" y="479"/>
                            </a:lnTo>
                            <a:lnTo>
                              <a:pt x="43" y="485"/>
                            </a:lnTo>
                            <a:lnTo>
                              <a:pt x="49" y="485"/>
                            </a:lnTo>
                            <a:lnTo>
                              <a:pt x="55" y="485"/>
                            </a:lnTo>
                            <a:lnTo>
                              <a:pt x="61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8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2"/>
                            </a:lnTo>
                            <a:lnTo>
                              <a:pt x="123" y="522"/>
                            </a:lnTo>
                            <a:lnTo>
                              <a:pt x="123" y="528"/>
                            </a:lnTo>
                            <a:lnTo>
                              <a:pt x="129" y="528"/>
                            </a:lnTo>
                            <a:lnTo>
                              <a:pt x="135" y="535"/>
                            </a:lnTo>
                            <a:lnTo>
                              <a:pt x="141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53"/>
                            </a:lnTo>
                            <a:lnTo>
                              <a:pt x="178" y="553"/>
                            </a:lnTo>
                            <a:lnTo>
                              <a:pt x="184" y="559"/>
                            </a:lnTo>
                            <a:lnTo>
                              <a:pt x="191" y="559"/>
                            </a:lnTo>
                            <a:lnTo>
                              <a:pt x="191" y="565"/>
                            </a:lnTo>
                            <a:lnTo>
                              <a:pt x="197" y="565"/>
                            </a:lnTo>
                            <a:lnTo>
                              <a:pt x="203" y="565"/>
                            </a:lnTo>
                            <a:lnTo>
                              <a:pt x="209" y="571"/>
                            </a:lnTo>
                            <a:lnTo>
                              <a:pt x="215" y="571"/>
                            </a:lnTo>
                            <a:lnTo>
                              <a:pt x="221" y="578"/>
                            </a:lnTo>
                            <a:lnTo>
                              <a:pt x="227" y="578"/>
                            </a:lnTo>
                            <a:lnTo>
                              <a:pt x="234" y="584"/>
                            </a:lnTo>
                            <a:lnTo>
                              <a:pt x="240" y="584"/>
                            </a:lnTo>
                            <a:lnTo>
                              <a:pt x="246" y="584"/>
                            </a:lnTo>
                            <a:lnTo>
                              <a:pt x="252" y="590"/>
                            </a:lnTo>
                            <a:lnTo>
                              <a:pt x="258" y="590"/>
                            </a:lnTo>
                            <a:lnTo>
                              <a:pt x="264" y="590"/>
                            </a:lnTo>
                            <a:lnTo>
                              <a:pt x="270" y="584"/>
                            </a:lnTo>
                            <a:lnTo>
                              <a:pt x="277" y="571"/>
                            </a:lnTo>
                            <a:lnTo>
                              <a:pt x="283" y="559"/>
                            </a:lnTo>
                            <a:lnTo>
                              <a:pt x="289" y="547"/>
                            </a:lnTo>
                            <a:lnTo>
                              <a:pt x="289" y="516"/>
                            </a:lnTo>
                            <a:lnTo>
                              <a:pt x="295" y="467"/>
                            </a:lnTo>
                            <a:lnTo>
                              <a:pt x="301" y="412"/>
                            </a:lnTo>
                            <a:lnTo>
                              <a:pt x="307" y="344"/>
                            </a:lnTo>
                            <a:lnTo>
                              <a:pt x="313" y="283"/>
                            </a:lnTo>
                            <a:lnTo>
                              <a:pt x="320" y="209"/>
                            </a:lnTo>
                            <a:lnTo>
                              <a:pt x="320" y="123"/>
                            </a:lnTo>
                            <a:lnTo>
                              <a:pt x="326" y="74"/>
                            </a:lnTo>
                            <a:lnTo>
                              <a:pt x="332" y="86"/>
                            </a:lnTo>
                            <a:lnTo>
                              <a:pt x="338" y="6"/>
                            </a:lnTo>
                            <a:lnTo>
                              <a:pt x="344" y="0"/>
                            </a:lnTo>
                            <a:lnTo>
                              <a:pt x="350" y="104"/>
                            </a:lnTo>
                            <a:lnTo>
                              <a:pt x="350" y="209"/>
                            </a:lnTo>
                            <a:lnTo>
                              <a:pt x="357" y="283"/>
                            </a:lnTo>
                            <a:lnTo>
                              <a:pt x="363" y="344"/>
                            </a:lnTo>
                            <a:lnTo>
                              <a:pt x="369" y="406"/>
                            </a:lnTo>
                            <a:lnTo>
                              <a:pt x="375" y="449"/>
                            </a:lnTo>
                            <a:lnTo>
                              <a:pt x="381" y="485"/>
                            </a:lnTo>
                            <a:lnTo>
                              <a:pt x="381" y="528"/>
                            </a:lnTo>
                            <a:lnTo>
                              <a:pt x="387" y="559"/>
                            </a:lnTo>
                            <a:lnTo>
                              <a:pt x="393" y="590"/>
                            </a:lnTo>
                            <a:lnTo>
                              <a:pt x="400" y="615"/>
                            </a:lnTo>
                            <a:lnTo>
                              <a:pt x="406" y="633"/>
                            </a:lnTo>
                            <a:lnTo>
                              <a:pt x="412" y="645"/>
                            </a:lnTo>
                            <a:lnTo>
                              <a:pt x="418" y="651"/>
                            </a:lnTo>
                            <a:lnTo>
                              <a:pt x="418" y="658"/>
                            </a:lnTo>
                            <a:lnTo>
                              <a:pt x="424" y="664"/>
                            </a:lnTo>
                            <a:lnTo>
                              <a:pt x="430" y="670"/>
                            </a:lnTo>
                            <a:lnTo>
                              <a:pt x="436" y="676"/>
                            </a:lnTo>
                            <a:lnTo>
                              <a:pt x="443" y="682"/>
                            </a:lnTo>
                            <a:lnTo>
                              <a:pt x="449" y="688"/>
                            </a:lnTo>
                            <a:lnTo>
                              <a:pt x="455" y="694"/>
                            </a:lnTo>
                            <a:lnTo>
                              <a:pt x="461" y="694"/>
                            </a:lnTo>
                            <a:lnTo>
                              <a:pt x="467" y="701"/>
                            </a:lnTo>
                            <a:lnTo>
                              <a:pt x="473" y="701"/>
                            </a:lnTo>
                            <a:lnTo>
                              <a:pt x="479" y="707"/>
                            </a:lnTo>
                            <a:lnTo>
                              <a:pt x="486" y="707"/>
                            </a:lnTo>
                            <a:lnTo>
                              <a:pt x="492" y="707"/>
                            </a:lnTo>
                            <a:lnTo>
                              <a:pt x="498" y="707"/>
                            </a:lnTo>
                            <a:lnTo>
                              <a:pt x="504" y="707"/>
                            </a:lnTo>
                            <a:lnTo>
                              <a:pt x="510" y="707"/>
                            </a:lnTo>
                            <a:lnTo>
                              <a:pt x="516" y="707"/>
                            </a:lnTo>
                            <a:lnTo>
                              <a:pt x="522" y="701"/>
                            </a:lnTo>
                            <a:lnTo>
                              <a:pt x="529" y="701"/>
                            </a:lnTo>
                            <a:lnTo>
                              <a:pt x="535" y="694"/>
                            </a:lnTo>
                            <a:lnTo>
                              <a:pt x="541" y="688"/>
                            </a:lnTo>
                            <a:lnTo>
                              <a:pt x="547" y="688"/>
                            </a:lnTo>
                            <a:lnTo>
                              <a:pt x="547" y="682"/>
                            </a:lnTo>
                            <a:lnTo>
                              <a:pt x="553" y="676"/>
                            </a:lnTo>
                            <a:lnTo>
                              <a:pt x="559" y="664"/>
                            </a:lnTo>
                            <a:lnTo>
                              <a:pt x="566" y="651"/>
                            </a:lnTo>
                            <a:lnTo>
                              <a:pt x="572" y="633"/>
                            </a:lnTo>
                            <a:lnTo>
                              <a:pt x="578" y="621"/>
                            </a:lnTo>
                            <a:lnTo>
                              <a:pt x="578" y="608"/>
                            </a:lnTo>
                            <a:lnTo>
                              <a:pt x="584" y="602"/>
                            </a:lnTo>
                            <a:lnTo>
                              <a:pt x="590" y="584"/>
                            </a:lnTo>
                            <a:lnTo>
                              <a:pt x="596" y="553"/>
                            </a:lnTo>
                            <a:lnTo>
                              <a:pt x="602" y="522"/>
                            </a:lnTo>
                            <a:lnTo>
                              <a:pt x="609" y="504"/>
                            </a:lnTo>
                            <a:lnTo>
                              <a:pt x="609" y="492"/>
                            </a:lnTo>
                            <a:lnTo>
                              <a:pt x="615" y="492"/>
                            </a:lnTo>
                            <a:lnTo>
                              <a:pt x="621" y="492"/>
                            </a:lnTo>
                            <a:lnTo>
                              <a:pt x="627" y="504"/>
                            </a:lnTo>
                            <a:lnTo>
                              <a:pt x="633" y="541"/>
                            </a:lnTo>
                            <a:lnTo>
                              <a:pt x="639" y="565"/>
                            </a:lnTo>
                            <a:lnTo>
                              <a:pt x="639" y="584"/>
                            </a:lnTo>
                            <a:lnTo>
                              <a:pt x="645" y="615"/>
                            </a:lnTo>
                            <a:lnTo>
                              <a:pt x="652" y="639"/>
                            </a:lnTo>
                            <a:lnTo>
                              <a:pt x="658" y="658"/>
                            </a:lnTo>
                            <a:lnTo>
                              <a:pt x="664" y="670"/>
                            </a:lnTo>
                            <a:lnTo>
                              <a:pt x="670" y="682"/>
                            </a:lnTo>
                            <a:lnTo>
                              <a:pt x="676" y="707"/>
                            </a:lnTo>
                            <a:lnTo>
                              <a:pt x="676" y="725"/>
                            </a:lnTo>
                            <a:lnTo>
                              <a:pt x="682" y="750"/>
                            </a:lnTo>
                            <a:lnTo>
                              <a:pt x="688" y="762"/>
                            </a:lnTo>
                            <a:lnTo>
                              <a:pt x="695" y="774"/>
                            </a:lnTo>
                            <a:lnTo>
                              <a:pt x="701" y="781"/>
                            </a:lnTo>
                            <a:lnTo>
                              <a:pt x="707" y="793"/>
                            </a:lnTo>
                            <a:lnTo>
                              <a:pt x="707" y="811"/>
                            </a:lnTo>
                            <a:lnTo>
                              <a:pt x="713" y="824"/>
                            </a:lnTo>
                            <a:lnTo>
                              <a:pt x="719" y="830"/>
                            </a:lnTo>
                            <a:lnTo>
                              <a:pt x="725" y="836"/>
                            </a:lnTo>
                            <a:lnTo>
                              <a:pt x="731" y="842"/>
                            </a:lnTo>
                            <a:lnTo>
                              <a:pt x="738" y="848"/>
                            </a:lnTo>
                            <a:lnTo>
                              <a:pt x="738" y="854"/>
                            </a:lnTo>
                            <a:lnTo>
                              <a:pt x="744" y="860"/>
                            </a:lnTo>
                            <a:lnTo>
                              <a:pt x="750" y="860"/>
                            </a:lnTo>
                            <a:lnTo>
                              <a:pt x="756" y="867"/>
                            </a:lnTo>
                            <a:lnTo>
                              <a:pt x="762" y="867"/>
                            </a:lnTo>
                            <a:lnTo>
                              <a:pt x="768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5" y="891"/>
                            </a:lnTo>
                            <a:lnTo>
                              <a:pt x="811" y="897"/>
                            </a:lnTo>
                            <a:lnTo>
                              <a:pt x="818" y="897"/>
                            </a:lnTo>
                            <a:lnTo>
                              <a:pt x="824" y="903"/>
                            </a:lnTo>
                            <a:lnTo>
                              <a:pt x="830" y="903"/>
                            </a:lnTo>
                            <a:lnTo>
                              <a:pt x="836" y="903"/>
                            </a:lnTo>
                            <a:lnTo>
                              <a:pt x="836" y="910"/>
                            </a:lnTo>
                            <a:lnTo>
                              <a:pt x="842" y="910"/>
                            </a:lnTo>
                            <a:lnTo>
                              <a:pt x="848" y="916"/>
                            </a:lnTo>
                            <a:lnTo>
                              <a:pt x="854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1" y="934"/>
                            </a:lnTo>
                            <a:lnTo>
                              <a:pt x="897" y="940"/>
                            </a:lnTo>
                            <a:lnTo>
                              <a:pt x="904" y="946"/>
                            </a:lnTo>
                            <a:lnTo>
                              <a:pt x="910" y="946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8" y="959"/>
                            </a:lnTo>
                            <a:lnTo>
                              <a:pt x="934" y="959"/>
                            </a:lnTo>
                            <a:lnTo>
                              <a:pt x="934" y="965"/>
                            </a:lnTo>
                            <a:lnTo>
                              <a:pt x="940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7"/>
                            </a:lnTo>
                            <a:lnTo>
                              <a:pt x="971" y="983"/>
                            </a:lnTo>
                            <a:lnTo>
                              <a:pt x="977" y="983"/>
                            </a:lnTo>
                            <a:lnTo>
                              <a:pt x="983" y="990"/>
                            </a:lnTo>
                            <a:lnTo>
                              <a:pt x="990" y="990"/>
                            </a:lnTo>
                            <a:lnTo>
                              <a:pt x="996" y="990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8" y="1002"/>
                            </a:lnTo>
                            <a:lnTo>
                              <a:pt x="1014" y="1002"/>
                            </a:lnTo>
                            <a:lnTo>
                              <a:pt x="1020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1" y="1020"/>
                            </a:lnTo>
                            <a:lnTo>
                              <a:pt x="1057" y="1026"/>
                            </a:lnTo>
                            <a:lnTo>
                              <a:pt x="1063" y="1026"/>
                            </a:lnTo>
                            <a:lnTo>
                              <a:pt x="1063" y="1033"/>
                            </a:lnTo>
                            <a:lnTo>
                              <a:pt x="1070" y="1033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0" y="1051"/>
                            </a:lnTo>
                            <a:lnTo>
                              <a:pt x="1106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3"/>
                            </a:lnTo>
                            <a:lnTo>
                              <a:pt x="1131" y="1069"/>
                            </a:lnTo>
                            <a:lnTo>
                              <a:pt x="1137" y="1069"/>
                            </a:lnTo>
                            <a:lnTo>
                              <a:pt x="1143" y="1076"/>
                            </a:lnTo>
                            <a:lnTo>
                              <a:pt x="1149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6" y="1094"/>
                            </a:lnTo>
                            <a:lnTo>
                              <a:pt x="1192" y="1100"/>
                            </a:lnTo>
                            <a:lnTo>
                              <a:pt x="1199" y="1100"/>
                            </a:lnTo>
                            <a:lnTo>
                              <a:pt x="1205" y="1106"/>
                            </a:lnTo>
                            <a:lnTo>
                              <a:pt x="1211" y="1106"/>
                            </a:lnTo>
                            <a:lnTo>
                              <a:pt x="1217" y="1112"/>
                            </a:lnTo>
                            <a:lnTo>
                              <a:pt x="1223" y="1112"/>
                            </a:lnTo>
                            <a:lnTo>
                              <a:pt x="1223" y="1119"/>
                            </a:lnTo>
                            <a:lnTo>
                              <a:pt x="1229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6" y="1137"/>
                            </a:lnTo>
                            <a:lnTo>
                              <a:pt x="1272" y="1143"/>
                            </a:lnTo>
                            <a:lnTo>
                              <a:pt x="1279" y="1143"/>
                            </a:lnTo>
                            <a:lnTo>
                              <a:pt x="1285" y="1149"/>
                            </a:lnTo>
                            <a:lnTo>
                              <a:pt x="1291" y="1155"/>
                            </a:lnTo>
                            <a:lnTo>
                              <a:pt x="1297" y="1155"/>
                            </a:lnTo>
                            <a:lnTo>
                              <a:pt x="1303" y="1155"/>
                            </a:lnTo>
                            <a:lnTo>
                              <a:pt x="1309" y="1162"/>
                            </a:lnTo>
                            <a:lnTo>
                              <a:pt x="1315" y="1162"/>
                            </a:lnTo>
                          </a:path>
                        </a:pathLst>
                      </a:custGeom>
                      <a:noFill/>
                      <a:ln w="9360">
                        <a:solidFill>
                          <a:srgbClr val="00ff00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  <p:grpSp>
                <p:nvGrpSpPr>
                  <p:cNvPr id="177" name="Group 149"/>
                  <p:cNvGrpSpPr/>
                  <p:nvPr/>
                </p:nvGrpSpPr>
                <p:grpSpPr>
                  <a:xfrm>
                    <a:off x="1864800" y="3815280"/>
                    <a:ext cx="1419840" cy="1119600"/>
                    <a:chOff x="1864800" y="3815280"/>
                    <a:chExt cx="1419840" cy="1119600"/>
                  </a:xfrm>
                </p:grpSpPr>
                <p:sp>
                  <p:nvSpPr>
                    <p:cNvPr id="178" name="Line 150"/>
                    <p:cNvSpPr/>
                    <p:nvPr/>
                  </p:nvSpPr>
                  <p:spPr>
                    <a:xfrm>
                      <a:off x="1864800" y="4257000"/>
                      <a:ext cx="1419840" cy="677880"/>
                    </a:xfrm>
                    <a:prstGeom prst="line">
                      <a:avLst/>
                    </a:prstGeom>
                    <a:ln w="9360">
                      <a:solidFill>
                        <a:srgbClr val="88888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179" name="Group 151"/>
                    <p:cNvGrpSpPr/>
                    <p:nvPr/>
                  </p:nvGrpSpPr>
                  <p:grpSpPr>
                    <a:xfrm>
                      <a:off x="1864800" y="3815280"/>
                      <a:ext cx="1419840" cy="1119600"/>
                      <a:chOff x="1864800" y="3815280"/>
                      <a:chExt cx="1419840" cy="1119600"/>
                    </a:xfrm>
                  </p:grpSpPr>
                  <p:sp>
                    <p:nvSpPr>
                      <p:cNvPr id="180" name="Freeform 152"/>
                      <p:cNvSpPr/>
                      <p:nvPr/>
                    </p:nvSpPr>
                    <p:spPr>
                      <a:xfrm>
                        <a:off x="1864800" y="3815280"/>
                        <a:ext cx="1419840" cy="1119600"/>
                      </a:xfrm>
                      <a:custGeom>
                        <a:avLst/>
                        <a:gdLst>
                          <a:gd name="textAreaLeft" fmla="*/ 0 w 1419840"/>
                          <a:gd name="textAreaRight" fmla="*/ 1420200 w 1419840"/>
                          <a:gd name="textAreaTop" fmla="*/ 0 h 1119600"/>
                          <a:gd name="textAreaBottom" fmla="*/ 1119600 h 1119600"/>
                        </a:gdLst>
                        <a:ahLst/>
                        <a:rect l="textAreaLeft" t="textAreaTop" r="textAreaRight" b="textAreaBottom"/>
                        <a:pathLst>
                          <a:path w="1322" h="1168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2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79"/>
                            </a:lnTo>
                            <a:lnTo>
                              <a:pt x="37" y="479"/>
                            </a:lnTo>
                            <a:lnTo>
                              <a:pt x="43" y="485"/>
                            </a:lnTo>
                            <a:lnTo>
                              <a:pt x="49" y="485"/>
                            </a:lnTo>
                            <a:lnTo>
                              <a:pt x="55" y="485"/>
                            </a:lnTo>
                            <a:lnTo>
                              <a:pt x="62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8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2"/>
                            </a:lnTo>
                            <a:lnTo>
                              <a:pt x="123" y="522"/>
                            </a:lnTo>
                            <a:lnTo>
                              <a:pt x="123" y="528"/>
                            </a:lnTo>
                            <a:lnTo>
                              <a:pt x="129" y="528"/>
                            </a:lnTo>
                            <a:lnTo>
                              <a:pt x="135" y="535"/>
                            </a:lnTo>
                            <a:lnTo>
                              <a:pt x="141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47"/>
                            </a:lnTo>
                            <a:lnTo>
                              <a:pt x="178" y="553"/>
                            </a:lnTo>
                            <a:lnTo>
                              <a:pt x="184" y="553"/>
                            </a:lnTo>
                            <a:lnTo>
                              <a:pt x="191" y="553"/>
                            </a:lnTo>
                            <a:lnTo>
                              <a:pt x="197" y="553"/>
                            </a:lnTo>
                            <a:lnTo>
                              <a:pt x="203" y="553"/>
                            </a:lnTo>
                            <a:lnTo>
                              <a:pt x="209" y="553"/>
                            </a:lnTo>
                            <a:lnTo>
                              <a:pt x="215" y="553"/>
                            </a:lnTo>
                            <a:lnTo>
                              <a:pt x="221" y="547"/>
                            </a:lnTo>
                            <a:lnTo>
                              <a:pt x="221" y="535"/>
                            </a:lnTo>
                            <a:lnTo>
                              <a:pt x="228" y="522"/>
                            </a:lnTo>
                            <a:lnTo>
                              <a:pt x="234" y="510"/>
                            </a:lnTo>
                            <a:lnTo>
                              <a:pt x="240" y="492"/>
                            </a:lnTo>
                            <a:lnTo>
                              <a:pt x="246" y="485"/>
                            </a:lnTo>
                            <a:lnTo>
                              <a:pt x="252" y="479"/>
                            </a:lnTo>
                            <a:lnTo>
                              <a:pt x="252" y="467"/>
                            </a:lnTo>
                            <a:lnTo>
                              <a:pt x="258" y="448"/>
                            </a:lnTo>
                            <a:lnTo>
                              <a:pt x="264" y="418"/>
                            </a:lnTo>
                            <a:lnTo>
                              <a:pt x="271" y="387"/>
                            </a:lnTo>
                            <a:lnTo>
                              <a:pt x="277" y="350"/>
                            </a:lnTo>
                            <a:lnTo>
                              <a:pt x="283" y="301"/>
                            </a:lnTo>
                            <a:lnTo>
                              <a:pt x="289" y="239"/>
                            </a:lnTo>
                            <a:lnTo>
                              <a:pt x="289" y="203"/>
                            </a:lnTo>
                            <a:lnTo>
                              <a:pt x="295" y="190"/>
                            </a:lnTo>
                            <a:lnTo>
                              <a:pt x="301" y="160"/>
                            </a:lnTo>
                            <a:lnTo>
                              <a:pt x="307" y="123"/>
                            </a:lnTo>
                            <a:lnTo>
                              <a:pt x="314" y="92"/>
                            </a:lnTo>
                            <a:lnTo>
                              <a:pt x="320" y="37"/>
                            </a:lnTo>
                            <a:lnTo>
                              <a:pt x="320" y="0"/>
                            </a:lnTo>
                            <a:lnTo>
                              <a:pt x="326" y="24"/>
                            </a:lnTo>
                            <a:lnTo>
                              <a:pt x="332" y="80"/>
                            </a:lnTo>
                            <a:lnTo>
                              <a:pt x="338" y="117"/>
                            </a:lnTo>
                            <a:lnTo>
                              <a:pt x="344" y="129"/>
                            </a:lnTo>
                            <a:lnTo>
                              <a:pt x="350" y="153"/>
                            </a:lnTo>
                            <a:lnTo>
                              <a:pt x="350" y="190"/>
                            </a:lnTo>
                            <a:lnTo>
                              <a:pt x="357" y="246"/>
                            </a:lnTo>
                            <a:lnTo>
                              <a:pt x="363" y="319"/>
                            </a:lnTo>
                            <a:lnTo>
                              <a:pt x="369" y="405"/>
                            </a:lnTo>
                            <a:lnTo>
                              <a:pt x="375" y="461"/>
                            </a:lnTo>
                            <a:lnTo>
                              <a:pt x="381" y="510"/>
                            </a:lnTo>
                            <a:lnTo>
                              <a:pt x="381" y="553"/>
                            </a:lnTo>
                            <a:lnTo>
                              <a:pt x="387" y="590"/>
                            </a:lnTo>
                            <a:lnTo>
                              <a:pt x="393" y="614"/>
                            </a:lnTo>
                            <a:lnTo>
                              <a:pt x="400" y="627"/>
                            </a:lnTo>
                            <a:lnTo>
                              <a:pt x="406" y="633"/>
                            </a:lnTo>
                            <a:lnTo>
                              <a:pt x="412" y="639"/>
                            </a:lnTo>
                            <a:lnTo>
                              <a:pt x="418" y="639"/>
                            </a:lnTo>
                            <a:lnTo>
                              <a:pt x="418" y="645"/>
                            </a:lnTo>
                            <a:lnTo>
                              <a:pt x="424" y="651"/>
                            </a:lnTo>
                            <a:lnTo>
                              <a:pt x="430" y="658"/>
                            </a:lnTo>
                            <a:lnTo>
                              <a:pt x="436" y="664"/>
                            </a:lnTo>
                            <a:lnTo>
                              <a:pt x="443" y="670"/>
                            </a:lnTo>
                            <a:lnTo>
                              <a:pt x="449" y="670"/>
                            </a:lnTo>
                            <a:lnTo>
                              <a:pt x="455" y="670"/>
                            </a:lnTo>
                            <a:lnTo>
                              <a:pt x="461" y="670"/>
                            </a:lnTo>
                            <a:lnTo>
                              <a:pt x="467" y="670"/>
                            </a:lnTo>
                            <a:lnTo>
                              <a:pt x="473" y="670"/>
                            </a:lnTo>
                            <a:lnTo>
                              <a:pt x="480" y="670"/>
                            </a:lnTo>
                            <a:lnTo>
                              <a:pt x="486" y="670"/>
                            </a:lnTo>
                            <a:lnTo>
                              <a:pt x="492" y="670"/>
                            </a:lnTo>
                            <a:lnTo>
                              <a:pt x="498" y="658"/>
                            </a:lnTo>
                            <a:lnTo>
                              <a:pt x="504" y="658"/>
                            </a:lnTo>
                            <a:lnTo>
                              <a:pt x="510" y="651"/>
                            </a:lnTo>
                            <a:lnTo>
                              <a:pt x="510" y="658"/>
                            </a:lnTo>
                            <a:lnTo>
                              <a:pt x="516" y="664"/>
                            </a:lnTo>
                            <a:lnTo>
                              <a:pt x="523" y="664"/>
                            </a:lnTo>
                            <a:lnTo>
                              <a:pt x="529" y="664"/>
                            </a:lnTo>
                            <a:lnTo>
                              <a:pt x="535" y="658"/>
                            </a:lnTo>
                            <a:lnTo>
                              <a:pt x="541" y="651"/>
                            </a:lnTo>
                            <a:lnTo>
                              <a:pt x="547" y="645"/>
                            </a:lnTo>
                            <a:lnTo>
                              <a:pt x="547" y="639"/>
                            </a:lnTo>
                            <a:lnTo>
                              <a:pt x="553" y="639"/>
                            </a:lnTo>
                            <a:lnTo>
                              <a:pt x="559" y="633"/>
                            </a:lnTo>
                            <a:lnTo>
                              <a:pt x="566" y="627"/>
                            </a:lnTo>
                            <a:lnTo>
                              <a:pt x="572" y="621"/>
                            </a:lnTo>
                            <a:lnTo>
                              <a:pt x="578" y="621"/>
                            </a:lnTo>
                            <a:lnTo>
                              <a:pt x="584" y="627"/>
                            </a:lnTo>
                            <a:lnTo>
                              <a:pt x="590" y="621"/>
                            </a:lnTo>
                            <a:lnTo>
                              <a:pt x="596" y="614"/>
                            </a:lnTo>
                            <a:lnTo>
                              <a:pt x="602" y="596"/>
                            </a:lnTo>
                            <a:lnTo>
                              <a:pt x="609" y="584"/>
                            </a:lnTo>
                            <a:lnTo>
                              <a:pt x="609" y="578"/>
                            </a:lnTo>
                            <a:lnTo>
                              <a:pt x="615" y="571"/>
                            </a:lnTo>
                            <a:lnTo>
                              <a:pt x="621" y="571"/>
                            </a:lnTo>
                            <a:lnTo>
                              <a:pt x="627" y="571"/>
                            </a:lnTo>
                            <a:lnTo>
                              <a:pt x="633" y="584"/>
                            </a:lnTo>
                            <a:lnTo>
                              <a:pt x="639" y="602"/>
                            </a:lnTo>
                            <a:lnTo>
                              <a:pt x="639" y="621"/>
                            </a:lnTo>
                            <a:lnTo>
                              <a:pt x="645" y="627"/>
                            </a:lnTo>
                            <a:lnTo>
                              <a:pt x="652" y="639"/>
                            </a:lnTo>
                            <a:lnTo>
                              <a:pt x="658" y="651"/>
                            </a:lnTo>
                            <a:lnTo>
                              <a:pt x="664" y="670"/>
                            </a:lnTo>
                            <a:lnTo>
                              <a:pt x="670" y="688"/>
                            </a:lnTo>
                            <a:lnTo>
                              <a:pt x="676" y="713"/>
                            </a:lnTo>
                            <a:lnTo>
                              <a:pt x="676" y="731"/>
                            </a:lnTo>
                            <a:lnTo>
                              <a:pt x="682" y="750"/>
                            </a:lnTo>
                            <a:lnTo>
                              <a:pt x="689" y="762"/>
                            </a:lnTo>
                            <a:lnTo>
                              <a:pt x="695" y="774"/>
                            </a:lnTo>
                            <a:lnTo>
                              <a:pt x="701" y="787"/>
                            </a:lnTo>
                            <a:lnTo>
                              <a:pt x="707" y="799"/>
                            </a:lnTo>
                            <a:lnTo>
                              <a:pt x="707" y="805"/>
                            </a:lnTo>
                            <a:lnTo>
                              <a:pt x="713" y="817"/>
                            </a:lnTo>
                            <a:lnTo>
                              <a:pt x="719" y="823"/>
                            </a:lnTo>
                            <a:lnTo>
                              <a:pt x="725" y="836"/>
                            </a:lnTo>
                            <a:lnTo>
                              <a:pt x="732" y="842"/>
                            </a:lnTo>
                            <a:lnTo>
                              <a:pt x="738" y="848"/>
                            </a:lnTo>
                            <a:lnTo>
                              <a:pt x="738" y="854"/>
                            </a:lnTo>
                            <a:lnTo>
                              <a:pt x="744" y="860"/>
                            </a:lnTo>
                            <a:lnTo>
                              <a:pt x="750" y="860"/>
                            </a:lnTo>
                            <a:lnTo>
                              <a:pt x="756" y="867"/>
                            </a:lnTo>
                            <a:lnTo>
                              <a:pt x="762" y="867"/>
                            </a:lnTo>
                            <a:lnTo>
                              <a:pt x="768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5" y="891"/>
                            </a:lnTo>
                            <a:lnTo>
                              <a:pt x="811" y="897"/>
                            </a:lnTo>
                            <a:lnTo>
                              <a:pt x="818" y="897"/>
                            </a:lnTo>
                            <a:lnTo>
                              <a:pt x="824" y="903"/>
                            </a:lnTo>
                            <a:lnTo>
                              <a:pt x="830" y="903"/>
                            </a:lnTo>
                            <a:lnTo>
                              <a:pt x="836" y="903"/>
                            </a:lnTo>
                            <a:lnTo>
                              <a:pt x="836" y="910"/>
                            </a:lnTo>
                            <a:lnTo>
                              <a:pt x="842" y="910"/>
                            </a:lnTo>
                            <a:lnTo>
                              <a:pt x="848" y="916"/>
                            </a:lnTo>
                            <a:lnTo>
                              <a:pt x="854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1" y="934"/>
                            </a:lnTo>
                            <a:lnTo>
                              <a:pt x="898" y="940"/>
                            </a:lnTo>
                            <a:lnTo>
                              <a:pt x="904" y="946"/>
                            </a:lnTo>
                            <a:lnTo>
                              <a:pt x="910" y="946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8" y="959"/>
                            </a:lnTo>
                            <a:lnTo>
                              <a:pt x="934" y="959"/>
                            </a:lnTo>
                            <a:lnTo>
                              <a:pt x="934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7"/>
                            </a:lnTo>
                            <a:lnTo>
                              <a:pt x="971" y="983"/>
                            </a:lnTo>
                            <a:lnTo>
                              <a:pt x="977" y="983"/>
                            </a:lnTo>
                            <a:lnTo>
                              <a:pt x="984" y="989"/>
                            </a:lnTo>
                            <a:lnTo>
                              <a:pt x="990" y="989"/>
                            </a:lnTo>
                            <a:lnTo>
                              <a:pt x="996" y="989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8" y="1002"/>
                            </a:lnTo>
                            <a:lnTo>
                              <a:pt x="1014" y="1002"/>
                            </a:lnTo>
                            <a:lnTo>
                              <a:pt x="1020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1" y="1020"/>
                            </a:lnTo>
                            <a:lnTo>
                              <a:pt x="1057" y="1026"/>
                            </a:lnTo>
                            <a:lnTo>
                              <a:pt x="1063" y="1026"/>
                            </a:lnTo>
                            <a:lnTo>
                              <a:pt x="1063" y="1032"/>
                            </a:lnTo>
                            <a:lnTo>
                              <a:pt x="1070" y="1032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0" y="1051"/>
                            </a:lnTo>
                            <a:lnTo>
                              <a:pt x="1106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3"/>
                            </a:lnTo>
                            <a:lnTo>
                              <a:pt x="1131" y="1069"/>
                            </a:lnTo>
                            <a:lnTo>
                              <a:pt x="1137" y="1069"/>
                            </a:lnTo>
                            <a:lnTo>
                              <a:pt x="1143" y="1076"/>
                            </a:lnTo>
                            <a:lnTo>
                              <a:pt x="1150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6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6"/>
                            </a:lnTo>
                            <a:lnTo>
                              <a:pt x="1211" y="1106"/>
                            </a:lnTo>
                            <a:lnTo>
                              <a:pt x="1217" y="1112"/>
                            </a:lnTo>
                            <a:lnTo>
                              <a:pt x="1223" y="1112"/>
                            </a:lnTo>
                            <a:lnTo>
                              <a:pt x="1223" y="1119"/>
                            </a:lnTo>
                            <a:lnTo>
                              <a:pt x="1229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6" y="1137"/>
                            </a:lnTo>
                            <a:lnTo>
                              <a:pt x="1272" y="1143"/>
                            </a:lnTo>
                            <a:lnTo>
                              <a:pt x="1279" y="1143"/>
                            </a:lnTo>
                            <a:lnTo>
                              <a:pt x="1285" y="1149"/>
                            </a:lnTo>
                            <a:lnTo>
                              <a:pt x="1291" y="1155"/>
                            </a:lnTo>
                            <a:lnTo>
                              <a:pt x="1297" y="1155"/>
                            </a:lnTo>
                            <a:lnTo>
                              <a:pt x="1303" y="1155"/>
                            </a:lnTo>
                            <a:lnTo>
                              <a:pt x="1309" y="1162"/>
                            </a:lnTo>
                            <a:lnTo>
                              <a:pt x="1315" y="1162"/>
                            </a:lnTo>
                            <a:lnTo>
                              <a:pt x="1322" y="1168"/>
                            </a:lnTo>
                            <a:lnTo>
                              <a:pt x="0" y="461"/>
                            </a:lnTo>
                            <a:close/>
                          </a:path>
                        </a:pathLst>
                      </a:custGeom>
                      <a:solidFill>
                        <a:srgbClr val="ffffff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81" name="Freeform 153"/>
                      <p:cNvSpPr/>
                      <p:nvPr/>
                    </p:nvSpPr>
                    <p:spPr>
                      <a:xfrm>
                        <a:off x="1864800" y="3815280"/>
                        <a:ext cx="1412280" cy="1113840"/>
                      </a:xfrm>
                      <a:custGeom>
                        <a:avLst/>
                        <a:gdLst>
                          <a:gd name="textAreaLeft" fmla="*/ 0 w 1412280"/>
                          <a:gd name="textAreaRight" fmla="*/ 1412640 w 1412280"/>
                          <a:gd name="textAreaTop" fmla="*/ 0 h 1113840"/>
                          <a:gd name="textAreaBottom" fmla="*/ 1114200 h 1113840"/>
                        </a:gdLst>
                        <a:ahLst/>
                        <a:rect l="textAreaLeft" t="textAreaTop" r="textAreaRight" b="textAreaBottom"/>
                        <a:pathLst>
                          <a:path w="1315" h="1162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2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79"/>
                            </a:lnTo>
                            <a:lnTo>
                              <a:pt x="37" y="479"/>
                            </a:lnTo>
                            <a:lnTo>
                              <a:pt x="43" y="485"/>
                            </a:lnTo>
                            <a:lnTo>
                              <a:pt x="49" y="485"/>
                            </a:lnTo>
                            <a:lnTo>
                              <a:pt x="55" y="485"/>
                            </a:lnTo>
                            <a:lnTo>
                              <a:pt x="62" y="492"/>
                            </a:lnTo>
                            <a:lnTo>
                              <a:pt x="68" y="498"/>
                            </a:lnTo>
                            <a:lnTo>
                              <a:pt x="74" y="498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8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2"/>
                            </a:lnTo>
                            <a:lnTo>
                              <a:pt x="123" y="522"/>
                            </a:lnTo>
                            <a:lnTo>
                              <a:pt x="123" y="528"/>
                            </a:lnTo>
                            <a:lnTo>
                              <a:pt x="129" y="528"/>
                            </a:lnTo>
                            <a:lnTo>
                              <a:pt x="135" y="535"/>
                            </a:lnTo>
                            <a:lnTo>
                              <a:pt x="141" y="535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47"/>
                            </a:lnTo>
                            <a:lnTo>
                              <a:pt x="178" y="553"/>
                            </a:lnTo>
                            <a:lnTo>
                              <a:pt x="184" y="553"/>
                            </a:lnTo>
                            <a:lnTo>
                              <a:pt x="191" y="553"/>
                            </a:lnTo>
                            <a:lnTo>
                              <a:pt x="197" y="553"/>
                            </a:lnTo>
                            <a:lnTo>
                              <a:pt x="203" y="553"/>
                            </a:lnTo>
                            <a:lnTo>
                              <a:pt x="209" y="553"/>
                            </a:lnTo>
                            <a:lnTo>
                              <a:pt x="215" y="553"/>
                            </a:lnTo>
                            <a:lnTo>
                              <a:pt x="221" y="547"/>
                            </a:lnTo>
                            <a:lnTo>
                              <a:pt x="221" y="535"/>
                            </a:lnTo>
                            <a:lnTo>
                              <a:pt x="228" y="522"/>
                            </a:lnTo>
                            <a:lnTo>
                              <a:pt x="234" y="510"/>
                            </a:lnTo>
                            <a:lnTo>
                              <a:pt x="240" y="492"/>
                            </a:lnTo>
                            <a:lnTo>
                              <a:pt x="246" y="485"/>
                            </a:lnTo>
                            <a:lnTo>
                              <a:pt x="252" y="479"/>
                            </a:lnTo>
                            <a:lnTo>
                              <a:pt x="252" y="467"/>
                            </a:lnTo>
                            <a:lnTo>
                              <a:pt x="258" y="448"/>
                            </a:lnTo>
                            <a:lnTo>
                              <a:pt x="264" y="418"/>
                            </a:lnTo>
                            <a:lnTo>
                              <a:pt x="271" y="387"/>
                            </a:lnTo>
                            <a:lnTo>
                              <a:pt x="277" y="350"/>
                            </a:lnTo>
                            <a:lnTo>
                              <a:pt x="283" y="301"/>
                            </a:lnTo>
                            <a:lnTo>
                              <a:pt x="289" y="239"/>
                            </a:lnTo>
                            <a:lnTo>
                              <a:pt x="289" y="203"/>
                            </a:lnTo>
                            <a:lnTo>
                              <a:pt x="295" y="190"/>
                            </a:lnTo>
                            <a:lnTo>
                              <a:pt x="301" y="160"/>
                            </a:lnTo>
                            <a:lnTo>
                              <a:pt x="307" y="123"/>
                            </a:lnTo>
                            <a:lnTo>
                              <a:pt x="314" y="92"/>
                            </a:lnTo>
                            <a:lnTo>
                              <a:pt x="320" y="37"/>
                            </a:lnTo>
                            <a:lnTo>
                              <a:pt x="320" y="0"/>
                            </a:lnTo>
                            <a:lnTo>
                              <a:pt x="326" y="24"/>
                            </a:lnTo>
                            <a:lnTo>
                              <a:pt x="332" y="80"/>
                            </a:lnTo>
                            <a:lnTo>
                              <a:pt x="338" y="117"/>
                            </a:lnTo>
                            <a:lnTo>
                              <a:pt x="344" y="129"/>
                            </a:lnTo>
                            <a:lnTo>
                              <a:pt x="350" y="153"/>
                            </a:lnTo>
                            <a:lnTo>
                              <a:pt x="350" y="190"/>
                            </a:lnTo>
                            <a:lnTo>
                              <a:pt x="357" y="246"/>
                            </a:lnTo>
                            <a:lnTo>
                              <a:pt x="363" y="319"/>
                            </a:lnTo>
                            <a:lnTo>
                              <a:pt x="369" y="405"/>
                            </a:lnTo>
                            <a:lnTo>
                              <a:pt x="375" y="461"/>
                            </a:lnTo>
                            <a:lnTo>
                              <a:pt x="381" y="510"/>
                            </a:lnTo>
                            <a:lnTo>
                              <a:pt x="381" y="553"/>
                            </a:lnTo>
                            <a:lnTo>
                              <a:pt x="387" y="590"/>
                            </a:lnTo>
                            <a:lnTo>
                              <a:pt x="393" y="614"/>
                            </a:lnTo>
                            <a:lnTo>
                              <a:pt x="400" y="627"/>
                            </a:lnTo>
                            <a:lnTo>
                              <a:pt x="406" y="633"/>
                            </a:lnTo>
                            <a:lnTo>
                              <a:pt x="412" y="639"/>
                            </a:lnTo>
                            <a:lnTo>
                              <a:pt x="418" y="639"/>
                            </a:lnTo>
                            <a:lnTo>
                              <a:pt x="418" y="645"/>
                            </a:lnTo>
                            <a:lnTo>
                              <a:pt x="424" y="651"/>
                            </a:lnTo>
                            <a:lnTo>
                              <a:pt x="430" y="658"/>
                            </a:lnTo>
                            <a:lnTo>
                              <a:pt x="436" y="664"/>
                            </a:lnTo>
                            <a:lnTo>
                              <a:pt x="443" y="670"/>
                            </a:lnTo>
                            <a:lnTo>
                              <a:pt x="449" y="670"/>
                            </a:lnTo>
                            <a:lnTo>
                              <a:pt x="455" y="670"/>
                            </a:lnTo>
                            <a:lnTo>
                              <a:pt x="461" y="670"/>
                            </a:lnTo>
                            <a:lnTo>
                              <a:pt x="467" y="670"/>
                            </a:lnTo>
                            <a:lnTo>
                              <a:pt x="473" y="670"/>
                            </a:lnTo>
                            <a:lnTo>
                              <a:pt x="480" y="670"/>
                            </a:lnTo>
                            <a:lnTo>
                              <a:pt x="486" y="670"/>
                            </a:lnTo>
                            <a:lnTo>
                              <a:pt x="492" y="670"/>
                            </a:lnTo>
                            <a:lnTo>
                              <a:pt x="498" y="658"/>
                            </a:lnTo>
                            <a:lnTo>
                              <a:pt x="504" y="658"/>
                            </a:lnTo>
                            <a:lnTo>
                              <a:pt x="510" y="651"/>
                            </a:lnTo>
                            <a:lnTo>
                              <a:pt x="510" y="658"/>
                            </a:lnTo>
                            <a:lnTo>
                              <a:pt x="516" y="664"/>
                            </a:lnTo>
                            <a:lnTo>
                              <a:pt x="523" y="664"/>
                            </a:lnTo>
                            <a:lnTo>
                              <a:pt x="529" y="664"/>
                            </a:lnTo>
                            <a:lnTo>
                              <a:pt x="535" y="658"/>
                            </a:lnTo>
                            <a:lnTo>
                              <a:pt x="541" y="651"/>
                            </a:lnTo>
                            <a:lnTo>
                              <a:pt x="547" y="645"/>
                            </a:lnTo>
                            <a:lnTo>
                              <a:pt x="547" y="639"/>
                            </a:lnTo>
                            <a:lnTo>
                              <a:pt x="553" y="639"/>
                            </a:lnTo>
                            <a:lnTo>
                              <a:pt x="559" y="633"/>
                            </a:lnTo>
                            <a:lnTo>
                              <a:pt x="566" y="627"/>
                            </a:lnTo>
                            <a:lnTo>
                              <a:pt x="572" y="621"/>
                            </a:lnTo>
                            <a:lnTo>
                              <a:pt x="578" y="621"/>
                            </a:lnTo>
                            <a:lnTo>
                              <a:pt x="584" y="627"/>
                            </a:lnTo>
                            <a:lnTo>
                              <a:pt x="590" y="621"/>
                            </a:lnTo>
                            <a:lnTo>
                              <a:pt x="596" y="614"/>
                            </a:lnTo>
                            <a:lnTo>
                              <a:pt x="602" y="596"/>
                            </a:lnTo>
                            <a:lnTo>
                              <a:pt x="609" y="584"/>
                            </a:lnTo>
                            <a:lnTo>
                              <a:pt x="609" y="578"/>
                            </a:lnTo>
                            <a:lnTo>
                              <a:pt x="615" y="571"/>
                            </a:lnTo>
                            <a:lnTo>
                              <a:pt x="621" y="571"/>
                            </a:lnTo>
                            <a:lnTo>
                              <a:pt x="627" y="571"/>
                            </a:lnTo>
                            <a:lnTo>
                              <a:pt x="633" y="584"/>
                            </a:lnTo>
                            <a:lnTo>
                              <a:pt x="639" y="602"/>
                            </a:lnTo>
                            <a:lnTo>
                              <a:pt x="639" y="621"/>
                            </a:lnTo>
                            <a:lnTo>
                              <a:pt x="645" y="627"/>
                            </a:lnTo>
                            <a:lnTo>
                              <a:pt x="652" y="639"/>
                            </a:lnTo>
                            <a:lnTo>
                              <a:pt x="658" y="651"/>
                            </a:lnTo>
                            <a:lnTo>
                              <a:pt x="664" y="670"/>
                            </a:lnTo>
                            <a:lnTo>
                              <a:pt x="670" y="688"/>
                            </a:lnTo>
                            <a:lnTo>
                              <a:pt x="676" y="713"/>
                            </a:lnTo>
                            <a:lnTo>
                              <a:pt x="676" y="731"/>
                            </a:lnTo>
                            <a:lnTo>
                              <a:pt x="682" y="750"/>
                            </a:lnTo>
                            <a:lnTo>
                              <a:pt x="689" y="762"/>
                            </a:lnTo>
                            <a:lnTo>
                              <a:pt x="695" y="774"/>
                            </a:lnTo>
                            <a:lnTo>
                              <a:pt x="701" y="787"/>
                            </a:lnTo>
                            <a:lnTo>
                              <a:pt x="707" y="799"/>
                            </a:lnTo>
                            <a:lnTo>
                              <a:pt x="707" y="805"/>
                            </a:lnTo>
                            <a:lnTo>
                              <a:pt x="713" y="817"/>
                            </a:lnTo>
                            <a:lnTo>
                              <a:pt x="719" y="823"/>
                            </a:lnTo>
                            <a:lnTo>
                              <a:pt x="725" y="836"/>
                            </a:lnTo>
                            <a:lnTo>
                              <a:pt x="732" y="842"/>
                            </a:lnTo>
                            <a:lnTo>
                              <a:pt x="738" y="848"/>
                            </a:lnTo>
                            <a:lnTo>
                              <a:pt x="738" y="854"/>
                            </a:lnTo>
                            <a:lnTo>
                              <a:pt x="744" y="860"/>
                            </a:lnTo>
                            <a:lnTo>
                              <a:pt x="750" y="860"/>
                            </a:lnTo>
                            <a:lnTo>
                              <a:pt x="756" y="867"/>
                            </a:lnTo>
                            <a:lnTo>
                              <a:pt x="762" y="867"/>
                            </a:lnTo>
                            <a:lnTo>
                              <a:pt x="768" y="873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5" y="891"/>
                            </a:lnTo>
                            <a:lnTo>
                              <a:pt x="811" y="897"/>
                            </a:lnTo>
                            <a:lnTo>
                              <a:pt x="818" y="897"/>
                            </a:lnTo>
                            <a:lnTo>
                              <a:pt x="824" y="903"/>
                            </a:lnTo>
                            <a:lnTo>
                              <a:pt x="830" y="903"/>
                            </a:lnTo>
                            <a:lnTo>
                              <a:pt x="836" y="903"/>
                            </a:lnTo>
                            <a:lnTo>
                              <a:pt x="836" y="910"/>
                            </a:lnTo>
                            <a:lnTo>
                              <a:pt x="842" y="910"/>
                            </a:lnTo>
                            <a:lnTo>
                              <a:pt x="848" y="916"/>
                            </a:lnTo>
                            <a:lnTo>
                              <a:pt x="854" y="916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1" y="934"/>
                            </a:lnTo>
                            <a:lnTo>
                              <a:pt x="898" y="940"/>
                            </a:lnTo>
                            <a:lnTo>
                              <a:pt x="904" y="946"/>
                            </a:lnTo>
                            <a:lnTo>
                              <a:pt x="910" y="946"/>
                            </a:lnTo>
                            <a:lnTo>
                              <a:pt x="916" y="953"/>
                            </a:lnTo>
                            <a:lnTo>
                              <a:pt x="922" y="953"/>
                            </a:lnTo>
                            <a:lnTo>
                              <a:pt x="928" y="959"/>
                            </a:lnTo>
                            <a:lnTo>
                              <a:pt x="934" y="959"/>
                            </a:lnTo>
                            <a:lnTo>
                              <a:pt x="934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7"/>
                            </a:lnTo>
                            <a:lnTo>
                              <a:pt x="971" y="983"/>
                            </a:lnTo>
                            <a:lnTo>
                              <a:pt x="977" y="983"/>
                            </a:lnTo>
                            <a:lnTo>
                              <a:pt x="984" y="989"/>
                            </a:lnTo>
                            <a:lnTo>
                              <a:pt x="990" y="989"/>
                            </a:lnTo>
                            <a:lnTo>
                              <a:pt x="996" y="989"/>
                            </a:lnTo>
                            <a:lnTo>
                              <a:pt x="996" y="996"/>
                            </a:lnTo>
                            <a:lnTo>
                              <a:pt x="1002" y="996"/>
                            </a:lnTo>
                            <a:lnTo>
                              <a:pt x="1008" y="1002"/>
                            </a:lnTo>
                            <a:lnTo>
                              <a:pt x="1014" y="1002"/>
                            </a:lnTo>
                            <a:lnTo>
                              <a:pt x="1020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1" y="1020"/>
                            </a:lnTo>
                            <a:lnTo>
                              <a:pt x="1057" y="1026"/>
                            </a:lnTo>
                            <a:lnTo>
                              <a:pt x="1063" y="1026"/>
                            </a:lnTo>
                            <a:lnTo>
                              <a:pt x="1063" y="1032"/>
                            </a:lnTo>
                            <a:lnTo>
                              <a:pt x="1070" y="1032"/>
                            </a:lnTo>
                            <a:lnTo>
                              <a:pt x="1076" y="1039"/>
                            </a:lnTo>
                            <a:lnTo>
                              <a:pt x="1082" y="1039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0" y="1051"/>
                            </a:lnTo>
                            <a:lnTo>
                              <a:pt x="1106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3"/>
                            </a:lnTo>
                            <a:lnTo>
                              <a:pt x="1131" y="1069"/>
                            </a:lnTo>
                            <a:lnTo>
                              <a:pt x="1137" y="1069"/>
                            </a:lnTo>
                            <a:lnTo>
                              <a:pt x="1143" y="1076"/>
                            </a:lnTo>
                            <a:lnTo>
                              <a:pt x="1150" y="1076"/>
                            </a:lnTo>
                            <a:lnTo>
                              <a:pt x="1156" y="1076"/>
                            </a:lnTo>
                            <a:lnTo>
                              <a:pt x="1156" y="1082"/>
                            </a:lnTo>
                            <a:lnTo>
                              <a:pt x="1162" y="1082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6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6"/>
                            </a:lnTo>
                            <a:lnTo>
                              <a:pt x="1211" y="1106"/>
                            </a:lnTo>
                            <a:lnTo>
                              <a:pt x="1217" y="1112"/>
                            </a:lnTo>
                            <a:lnTo>
                              <a:pt x="1223" y="1112"/>
                            </a:lnTo>
                            <a:lnTo>
                              <a:pt x="1223" y="1119"/>
                            </a:lnTo>
                            <a:lnTo>
                              <a:pt x="1229" y="1119"/>
                            </a:lnTo>
                            <a:lnTo>
                              <a:pt x="1236" y="1125"/>
                            </a:lnTo>
                            <a:lnTo>
                              <a:pt x="1242" y="1125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6" y="1137"/>
                            </a:lnTo>
                            <a:lnTo>
                              <a:pt x="1272" y="1143"/>
                            </a:lnTo>
                            <a:lnTo>
                              <a:pt x="1279" y="1143"/>
                            </a:lnTo>
                            <a:lnTo>
                              <a:pt x="1285" y="1149"/>
                            </a:lnTo>
                            <a:lnTo>
                              <a:pt x="1291" y="1155"/>
                            </a:lnTo>
                            <a:lnTo>
                              <a:pt x="1297" y="1155"/>
                            </a:lnTo>
                            <a:lnTo>
                              <a:pt x="1303" y="1155"/>
                            </a:lnTo>
                            <a:lnTo>
                              <a:pt x="1309" y="1162"/>
                            </a:lnTo>
                            <a:lnTo>
                              <a:pt x="1315" y="1162"/>
                            </a:lnTo>
                          </a:path>
                        </a:pathLst>
                      </a:custGeom>
                      <a:noFill/>
                      <a:ln w="9360">
                        <a:solidFill>
                          <a:srgbClr val="0000ff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  <p:grpSp>
                <p:nvGrpSpPr>
                  <p:cNvPr id="182" name="Group 154"/>
                  <p:cNvGrpSpPr/>
                  <p:nvPr/>
                </p:nvGrpSpPr>
                <p:grpSpPr>
                  <a:xfrm>
                    <a:off x="1738800" y="3927600"/>
                    <a:ext cx="1419840" cy="1119600"/>
                    <a:chOff x="1738800" y="3927600"/>
                    <a:chExt cx="1419840" cy="1119600"/>
                  </a:xfrm>
                </p:grpSpPr>
                <p:sp>
                  <p:nvSpPr>
                    <p:cNvPr id="183" name="Line 155"/>
                    <p:cNvSpPr/>
                    <p:nvPr/>
                  </p:nvSpPr>
                  <p:spPr>
                    <a:xfrm>
                      <a:off x="1738800" y="4369320"/>
                      <a:ext cx="1419840" cy="677880"/>
                    </a:xfrm>
                    <a:prstGeom prst="line">
                      <a:avLst/>
                    </a:prstGeom>
                    <a:ln w="9360">
                      <a:solidFill>
                        <a:srgbClr val="88888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184" name="Group 156"/>
                    <p:cNvGrpSpPr/>
                    <p:nvPr/>
                  </p:nvGrpSpPr>
                  <p:grpSpPr>
                    <a:xfrm>
                      <a:off x="1738800" y="3927600"/>
                      <a:ext cx="1419840" cy="1119600"/>
                      <a:chOff x="1738800" y="3927600"/>
                      <a:chExt cx="1419840" cy="1119600"/>
                    </a:xfrm>
                  </p:grpSpPr>
                  <p:sp>
                    <p:nvSpPr>
                      <p:cNvPr id="185" name="Freeform 157"/>
                      <p:cNvSpPr/>
                      <p:nvPr/>
                    </p:nvSpPr>
                    <p:spPr>
                      <a:xfrm>
                        <a:off x="1738800" y="3927600"/>
                        <a:ext cx="1419840" cy="1119600"/>
                      </a:xfrm>
                      <a:custGeom>
                        <a:avLst/>
                        <a:gdLst>
                          <a:gd name="textAreaLeft" fmla="*/ 0 w 1419840"/>
                          <a:gd name="textAreaRight" fmla="*/ 1420200 w 1419840"/>
                          <a:gd name="textAreaTop" fmla="*/ 0 h 1119600"/>
                          <a:gd name="textAreaBottom" fmla="*/ 1119600 h 1119600"/>
                        </a:gdLst>
                        <a:ahLst/>
                        <a:rect l="textAreaLeft" t="textAreaTop" r="textAreaRight" b="textAreaBottom"/>
                        <a:pathLst>
                          <a:path w="1322" h="1168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3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79"/>
                            </a:lnTo>
                            <a:lnTo>
                              <a:pt x="37" y="479"/>
                            </a:lnTo>
                            <a:lnTo>
                              <a:pt x="43" y="485"/>
                            </a:lnTo>
                            <a:lnTo>
                              <a:pt x="49" y="485"/>
                            </a:lnTo>
                            <a:lnTo>
                              <a:pt x="56" y="485"/>
                            </a:lnTo>
                            <a:lnTo>
                              <a:pt x="62" y="491"/>
                            </a:lnTo>
                            <a:lnTo>
                              <a:pt x="68" y="497"/>
                            </a:lnTo>
                            <a:lnTo>
                              <a:pt x="74" y="497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9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2"/>
                            </a:lnTo>
                            <a:lnTo>
                              <a:pt x="123" y="522"/>
                            </a:lnTo>
                            <a:lnTo>
                              <a:pt x="123" y="528"/>
                            </a:lnTo>
                            <a:lnTo>
                              <a:pt x="129" y="528"/>
                            </a:lnTo>
                            <a:lnTo>
                              <a:pt x="136" y="534"/>
                            </a:lnTo>
                            <a:lnTo>
                              <a:pt x="142" y="534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53"/>
                            </a:lnTo>
                            <a:lnTo>
                              <a:pt x="179" y="553"/>
                            </a:lnTo>
                            <a:lnTo>
                              <a:pt x="185" y="559"/>
                            </a:lnTo>
                            <a:lnTo>
                              <a:pt x="191" y="559"/>
                            </a:lnTo>
                            <a:lnTo>
                              <a:pt x="191" y="565"/>
                            </a:lnTo>
                            <a:lnTo>
                              <a:pt x="197" y="565"/>
                            </a:lnTo>
                            <a:lnTo>
                              <a:pt x="203" y="565"/>
                            </a:lnTo>
                            <a:lnTo>
                              <a:pt x="209" y="571"/>
                            </a:lnTo>
                            <a:lnTo>
                              <a:pt x="215" y="571"/>
                            </a:lnTo>
                            <a:lnTo>
                              <a:pt x="222" y="577"/>
                            </a:lnTo>
                            <a:lnTo>
                              <a:pt x="228" y="584"/>
                            </a:lnTo>
                            <a:lnTo>
                              <a:pt x="234" y="584"/>
                            </a:lnTo>
                            <a:lnTo>
                              <a:pt x="240" y="590"/>
                            </a:lnTo>
                            <a:lnTo>
                              <a:pt x="246" y="590"/>
                            </a:lnTo>
                            <a:lnTo>
                              <a:pt x="252" y="590"/>
                            </a:lnTo>
                            <a:lnTo>
                              <a:pt x="252" y="596"/>
                            </a:lnTo>
                            <a:lnTo>
                              <a:pt x="258" y="590"/>
                            </a:lnTo>
                            <a:lnTo>
                              <a:pt x="265" y="577"/>
                            </a:lnTo>
                            <a:lnTo>
                              <a:pt x="271" y="534"/>
                            </a:lnTo>
                            <a:lnTo>
                              <a:pt x="277" y="461"/>
                            </a:lnTo>
                            <a:lnTo>
                              <a:pt x="283" y="344"/>
                            </a:lnTo>
                            <a:lnTo>
                              <a:pt x="289" y="184"/>
                            </a:lnTo>
                            <a:lnTo>
                              <a:pt x="289" y="55"/>
                            </a:lnTo>
                            <a:lnTo>
                              <a:pt x="295" y="0"/>
                            </a:lnTo>
                            <a:lnTo>
                              <a:pt x="301" y="24"/>
                            </a:lnTo>
                            <a:lnTo>
                              <a:pt x="308" y="116"/>
                            </a:lnTo>
                            <a:lnTo>
                              <a:pt x="314" y="227"/>
                            </a:lnTo>
                            <a:lnTo>
                              <a:pt x="320" y="331"/>
                            </a:lnTo>
                            <a:lnTo>
                              <a:pt x="320" y="393"/>
                            </a:lnTo>
                            <a:lnTo>
                              <a:pt x="326" y="418"/>
                            </a:lnTo>
                            <a:lnTo>
                              <a:pt x="332" y="461"/>
                            </a:lnTo>
                            <a:lnTo>
                              <a:pt x="338" y="504"/>
                            </a:lnTo>
                            <a:lnTo>
                              <a:pt x="345" y="541"/>
                            </a:lnTo>
                            <a:lnTo>
                              <a:pt x="351" y="559"/>
                            </a:lnTo>
                            <a:lnTo>
                              <a:pt x="351" y="577"/>
                            </a:lnTo>
                            <a:lnTo>
                              <a:pt x="357" y="596"/>
                            </a:lnTo>
                            <a:lnTo>
                              <a:pt x="363" y="608"/>
                            </a:lnTo>
                            <a:lnTo>
                              <a:pt x="369" y="620"/>
                            </a:lnTo>
                            <a:lnTo>
                              <a:pt x="375" y="633"/>
                            </a:lnTo>
                            <a:lnTo>
                              <a:pt x="381" y="639"/>
                            </a:lnTo>
                            <a:lnTo>
                              <a:pt x="381" y="645"/>
                            </a:lnTo>
                            <a:lnTo>
                              <a:pt x="388" y="651"/>
                            </a:lnTo>
                            <a:lnTo>
                              <a:pt x="394" y="657"/>
                            </a:lnTo>
                            <a:lnTo>
                              <a:pt x="400" y="663"/>
                            </a:lnTo>
                            <a:lnTo>
                              <a:pt x="406" y="663"/>
                            </a:lnTo>
                            <a:lnTo>
                              <a:pt x="412" y="670"/>
                            </a:lnTo>
                            <a:lnTo>
                              <a:pt x="418" y="676"/>
                            </a:lnTo>
                            <a:lnTo>
                              <a:pt x="424" y="682"/>
                            </a:lnTo>
                            <a:lnTo>
                              <a:pt x="431" y="682"/>
                            </a:lnTo>
                            <a:lnTo>
                              <a:pt x="437" y="688"/>
                            </a:lnTo>
                            <a:lnTo>
                              <a:pt x="443" y="688"/>
                            </a:lnTo>
                            <a:lnTo>
                              <a:pt x="449" y="694"/>
                            </a:lnTo>
                            <a:lnTo>
                              <a:pt x="455" y="700"/>
                            </a:lnTo>
                            <a:lnTo>
                              <a:pt x="461" y="706"/>
                            </a:lnTo>
                            <a:lnTo>
                              <a:pt x="467" y="706"/>
                            </a:lnTo>
                            <a:lnTo>
                              <a:pt x="474" y="713"/>
                            </a:lnTo>
                            <a:lnTo>
                              <a:pt x="480" y="713"/>
                            </a:lnTo>
                            <a:lnTo>
                              <a:pt x="486" y="719"/>
                            </a:lnTo>
                            <a:lnTo>
                              <a:pt x="492" y="719"/>
                            </a:lnTo>
                            <a:lnTo>
                              <a:pt x="498" y="725"/>
                            </a:lnTo>
                            <a:lnTo>
                              <a:pt x="504" y="725"/>
                            </a:lnTo>
                            <a:lnTo>
                              <a:pt x="510" y="731"/>
                            </a:lnTo>
                            <a:lnTo>
                              <a:pt x="517" y="731"/>
                            </a:lnTo>
                            <a:lnTo>
                              <a:pt x="523" y="731"/>
                            </a:lnTo>
                            <a:lnTo>
                              <a:pt x="529" y="737"/>
                            </a:lnTo>
                            <a:lnTo>
                              <a:pt x="535" y="737"/>
                            </a:lnTo>
                            <a:lnTo>
                              <a:pt x="541" y="737"/>
                            </a:lnTo>
                            <a:lnTo>
                              <a:pt x="547" y="737"/>
                            </a:lnTo>
                            <a:lnTo>
                              <a:pt x="547" y="731"/>
                            </a:lnTo>
                            <a:lnTo>
                              <a:pt x="553" y="731"/>
                            </a:lnTo>
                            <a:lnTo>
                              <a:pt x="560" y="731"/>
                            </a:lnTo>
                            <a:lnTo>
                              <a:pt x="566" y="731"/>
                            </a:lnTo>
                            <a:lnTo>
                              <a:pt x="572" y="731"/>
                            </a:lnTo>
                            <a:lnTo>
                              <a:pt x="578" y="731"/>
                            </a:lnTo>
                            <a:lnTo>
                              <a:pt x="584" y="731"/>
                            </a:lnTo>
                            <a:lnTo>
                              <a:pt x="590" y="731"/>
                            </a:lnTo>
                            <a:lnTo>
                              <a:pt x="597" y="737"/>
                            </a:lnTo>
                            <a:lnTo>
                              <a:pt x="603" y="743"/>
                            </a:lnTo>
                            <a:lnTo>
                              <a:pt x="609" y="750"/>
                            </a:lnTo>
                            <a:lnTo>
                              <a:pt x="609" y="756"/>
                            </a:lnTo>
                            <a:lnTo>
                              <a:pt x="615" y="762"/>
                            </a:lnTo>
                            <a:lnTo>
                              <a:pt x="621" y="762"/>
                            </a:lnTo>
                            <a:lnTo>
                              <a:pt x="627" y="768"/>
                            </a:lnTo>
                            <a:lnTo>
                              <a:pt x="633" y="774"/>
                            </a:lnTo>
                            <a:lnTo>
                              <a:pt x="640" y="786"/>
                            </a:lnTo>
                            <a:lnTo>
                              <a:pt x="640" y="793"/>
                            </a:lnTo>
                            <a:lnTo>
                              <a:pt x="646" y="793"/>
                            </a:lnTo>
                            <a:lnTo>
                              <a:pt x="652" y="799"/>
                            </a:lnTo>
                            <a:lnTo>
                              <a:pt x="658" y="805"/>
                            </a:lnTo>
                            <a:lnTo>
                              <a:pt x="664" y="805"/>
                            </a:lnTo>
                            <a:lnTo>
                              <a:pt x="670" y="811"/>
                            </a:lnTo>
                            <a:lnTo>
                              <a:pt x="676" y="817"/>
                            </a:lnTo>
                            <a:lnTo>
                              <a:pt x="683" y="823"/>
                            </a:lnTo>
                            <a:lnTo>
                              <a:pt x="689" y="823"/>
                            </a:lnTo>
                            <a:lnTo>
                              <a:pt x="695" y="829"/>
                            </a:lnTo>
                            <a:lnTo>
                              <a:pt x="701" y="829"/>
                            </a:lnTo>
                            <a:lnTo>
                              <a:pt x="707" y="836"/>
                            </a:lnTo>
                            <a:lnTo>
                              <a:pt x="713" y="842"/>
                            </a:lnTo>
                            <a:lnTo>
                              <a:pt x="719" y="842"/>
                            </a:lnTo>
                            <a:lnTo>
                              <a:pt x="726" y="848"/>
                            </a:lnTo>
                            <a:lnTo>
                              <a:pt x="732" y="848"/>
                            </a:lnTo>
                            <a:lnTo>
                              <a:pt x="738" y="854"/>
                            </a:lnTo>
                            <a:lnTo>
                              <a:pt x="744" y="860"/>
                            </a:lnTo>
                            <a:lnTo>
                              <a:pt x="750" y="860"/>
                            </a:lnTo>
                            <a:lnTo>
                              <a:pt x="756" y="866"/>
                            </a:lnTo>
                            <a:lnTo>
                              <a:pt x="762" y="866"/>
                            </a:lnTo>
                            <a:lnTo>
                              <a:pt x="769" y="872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6" y="891"/>
                            </a:lnTo>
                            <a:lnTo>
                              <a:pt x="812" y="897"/>
                            </a:lnTo>
                            <a:lnTo>
                              <a:pt x="818" y="897"/>
                            </a:lnTo>
                            <a:lnTo>
                              <a:pt x="824" y="903"/>
                            </a:lnTo>
                            <a:lnTo>
                              <a:pt x="830" y="903"/>
                            </a:lnTo>
                            <a:lnTo>
                              <a:pt x="836" y="903"/>
                            </a:lnTo>
                            <a:lnTo>
                              <a:pt x="836" y="909"/>
                            </a:lnTo>
                            <a:lnTo>
                              <a:pt x="842" y="909"/>
                            </a:lnTo>
                            <a:lnTo>
                              <a:pt x="849" y="915"/>
                            </a:lnTo>
                            <a:lnTo>
                              <a:pt x="855" y="915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2" y="934"/>
                            </a:lnTo>
                            <a:lnTo>
                              <a:pt x="898" y="940"/>
                            </a:lnTo>
                            <a:lnTo>
                              <a:pt x="904" y="946"/>
                            </a:lnTo>
                            <a:lnTo>
                              <a:pt x="910" y="946"/>
                            </a:lnTo>
                            <a:lnTo>
                              <a:pt x="916" y="952"/>
                            </a:lnTo>
                            <a:lnTo>
                              <a:pt x="922" y="952"/>
                            </a:lnTo>
                            <a:lnTo>
                              <a:pt x="928" y="959"/>
                            </a:lnTo>
                            <a:lnTo>
                              <a:pt x="935" y="959"/>
                            </a:lnTo>
                            <a:lnTo>
                              <a:pt x="935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7"/>
                            </a:lnTo>
                            <a:lnTo>
                              <a:pt x="971" y="983"/>
                            </a:lnTo>
                            <a:lnTo>
                              <a:pt x="978" y="983"/>
                            </a:lnTo>
                            <a:lnTo>
                              <a:pt x="984" y="989"/>
                            </a:lnTo>
                            <a:lnTo>
                              <a:pt x="990" y="989"/>
                            </a:lnTo>
                            <a:lnTo>
                              <a:pt x="996" y="989"/>
                            </a:lnTo>
                            <a:lnTo>
                              <a:pt x="996" y="995"/>
                            </a:lnTo>
                            <a:lnTo>
                              <a:pt x="1002" y="995"/>
                            </a:lnTo>
                            <a:lnTo>
                              <a:pt x="1008" y="1002"/>
                            </a:lnTo>
                            <a:lnTo>
                              <a:pt x="1015" y="1002"/>
                            </a:lnTo>
                            <a:lnTo>
                              <a:pt x="1021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1" y="1020"/>
                            </a:lnTo>
                            <a:lnTo>
                              <a:pt x="1058" y="1026"/>
                            </a:lnTo>
                            <a:lnTo>
                              <a:pt x="1064" y="1026"/>
                            </a:lnTo>
                            <a:lnTo>
                              <a:pt x="1064" y="1032"/>
                            </a:lnTo>
                            <a:lnTo>
                              <a:pt x="1070" y="1032"/>
                            </a:lnTo>
                            <a:lnTo>
                              <a:pt x="1076" y="1038"/>
                            </a:lnTo>
                            <a:lnTo>
                              <a:pt x="1082" y="1038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1" y="1051"/>
                            </a:lnTo>
                            <a:lnTo>
                              <a:pt x="1107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3"/>
                            </a:lnTo>
                            <a:lnTo>
                              <a:pt x="1131" y="1069"/>
                            </a:lnTo>
                            <a:lnTo>
                              <a:pt x="1137" y="1069"/>
                            </a:lnTo>
                            <a:lnTo>
                              <a:pt x="1144" y="1075"/>
                            </a:lnTo>
                            <a:lnTo>
                              <a:pt x="1150" y="1075"/>
                            </a:lnTo>
                            <a:lnTo>
                              <a:pt x="1156" y="1075"/>
                            </a:lnTo>
                            <a:lnTo>
                              <a:pt x="1156" y="1081"/>
                            </a:lnTo>
                            <a:lnTo>
                              <a:pt x="1162" y="1081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7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6"/>
                            </a:lnTo>
                            <a:lnTo>
                              <a:pt x="1211" y="1106"/>
                            </a:lnTo>
                            <a:lnTo>
                              <a:pt x="1217" y="1112"/>
                            </a:lnTo>
                            <a:lnTo>
                              <a:pt x="1223" y="1112"/>
                            </a:lnTo>
                            <a:lnTo>
                              <a:pt x="1223" y="1118"/>
                            </a:lnTo>
                            <a:lnTo>
                              <a:pt x="1230" y="1118"/>
                            </a:lnTo>
                            <a:lnTo>
                              <a:pt x="1236" y="1124"/>
                            </a:lnTo>
                            <a:lnTo>
                              <a:pt x="1242" y="1124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7" y="1137"/>
                            </a:lnTo>
                            <a:lnTo>
                              <a:pt x="1273" y="1143"/>
                            </a:lnTo>
                            <a:lnTo>
                              <a:pt x="1279" y="1143"/>
                            </a:lnTo>
                            <a:lnTo>
                              <a:pt x="1285" y="1149"/>
                            </a:lnTo>
                            <a:lnTo>
                              <a:pt x="1291" y="1155"/>
                            </a:lnTo>
                            <a:lnTo>
                              <a:pt x="1297" y="1155"/>
                            </a:lnTo>
                            <a:lnTo>
                              <a:pt x="1303" y="1155"/>
                            </a:lnTo>
                            <a:lnTo>
                              <a:pt x="1310" y="1161"/>
                            </a:lnTo>
                            <a:lnTo>
                              <a:pt x="1316" y="1161"/>
                            </a:lnTo>
                            <a:lnTo>
                              <a:pt x="1322" y="1168"/>
                            </a:lnTo>
                            <a:lnTo>
                              <a:pt x="0" y="461"/>
                            </a:lnTo>
                            <a:close/>
                          </a:path>
                        </a:pathLst>
                      </a:custGeom>
                      <a:solidFill>
                        <a:srgbClr val="ffffff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86" name="Freeform 158"/>
                      <p:cNvSpPr/>
                      <p:nvPr/>
                    </p:nvSpPr>
                    <p:spPr>
                      <a:xfrm>
                        <a:off x="1738800" y="3927600"/>
                        <a:ext cx="1413360" cy="1112760"/>
                      </a:xfrm>
                      <a:custGeom>
                        <a:avLst/>
                        <a:gdLst>
                          <a:gd name="textAreaLeft" fmla="*/ 0 w 1413360"/>
                          <a:gd name="textAreaRight" fmla="*/ 1413360 w 1413360"/>
                          <a:gd name="textAreaTop" fmla="*/ 0 h 1112760"/>
                          <a:gd name="textAreaBottom" fmla="*/ 1113120 h 1112760"/>
                        </a:gdLst>
                        <a:ahLst/>
                        <a:rect l="textAreaLeft" t="textAreaTop" r="textAreaRight" b="textAreaBottom"/>
                        <a:pathLst>
                          <a:path w="1316" h="1161">
                            <a:moveTo>
                              <a:pt x="0" y="461"/>
                            </a:moveTo>
                            <a:lnTo>
                              <a:pt x="6" y="461"/>
                            </a:lnTo>
                            <a:lnTo>
                              <a:pt x="13" y="467"/>
                            </a:lnTo>
                            <a:lnTo>
                              <a:pt x="19" y="467"/>
                            </a:lnTo>
                            <a:lnTo>
                              <a:pt x="25" y="473"/>
                            </a:lnTo>
                            <a:lnTo>
                              <a:pt x="31" y="473"/>
                            </a:lnTo>
                            <a:lnTo>
                              <a:pt x="31" y="479"/>
                            </a:lnTo>
                            <a:lnTo>
                              <a:pt x="37" y="479"/>
                            </a:lnTo>
                            <a:lnTo>
                              <a:pt x="43" y="485"/>
                            </a:lnTo>
                            <a:lnTo>
                              <a:pt x="49" y="485"/>
                            </a:lnTo>
                            <a:lnTo>
                              <a:pt x="56" y="485"/>
                            </a:lnTo>
                            <a:lnTo>
                              <a:pt x="62" y="491"/>
                            </a:lnTo>
                            <a:lnTo>
                              <a:pt x="68" y="497"/>
                            </a:lnTo>
                            <a:lnTo>
                              <a:pt x="74" y="497"/>
                            </a:lnTo>
                            <a:lnTo>
                              <a:pt x="80" y="504"/>
                            </a:lnTo>
                            <a:lnTo>
                              <a:pt x="86" y="504"/>
                            </a:lnTo>
                            <a:lnTo>
                              <a:pt x="92" y="510"/>
                            </a:lnTo>
                            <a:lnTo>
                              <a:pt x="99" y="516"/>
                            </a:lnTo>
                            <a:lnTo>
                              <a:pt x="105" y="516"/>
                            </a:lnTo>
                            <a:lnTo>
                              <a:pt x="111" y="516"/>
                            </a:lnTo>
                            <a:lnTo>
                              <a:pt x="117" y="522"/>
                            </a:lnTo>
                            <a:lnTo>
                              <a:pt x="123" y="522"/>
                            </a:lnTo>
                            <a:lnTo>
                              <a:pt x="123" y="528"/>
                            </a:lnTo>
                            <a:lnTo>
                              <a:pt x="129" y="528"/>
                            </a:lnTo>
                            <a:lnTo>
                              <a:pt x="136" y="534"/>
                            </a:lnTo>
                            <a:lnTo>
                              <a:pt x="142" y="534"/>
                            </a:lnTo>
                            <a:lnTo>
                              <a:pt x="148" y="541"/>
                            </a:lnTo>
                            <a:lnTo>
                              <a:pt x="154" y="541"/>
                            </a:lnTo>
                            <a:lnTo>
                              <a:pt x="160" y="541"/>
                            </a:lnTo>
                            <a:lnTo>
                              <a:pt x="160" y="547"/>
                            </a:lnTo>
                            <a:lnTo>
                              <a:pt x="166" y="547"/>
                            </a:lnTo>
                            <a:lnTo>
                              <a:pt x="172" y="553"/>
                            </a:lnTo>
                            <a:lnTo>
                              <a:pt x="179" y="553"/>
                            </a:lnTo>
                            <a:lnTo>
                              <a:pt x="185" y="559"/>
                            </a:lnTo>
                            <a:lnTo>
                              <a:pt x="191" y="559"/>
                            </a:lnTo>
                            <a:lnTo>
                              <a:pt x="191" y="565"/>
                            </a:lnTo>
                            <a:lnTo>
                              <a:pt x="197" y="565"/>
                            </a:lnTo>
                            <a:lnTo>
                              <a:pt x="203" y="565"/>
                            </a:lnTo>
                            <a:lnTo>
                              <a:pt x="209" y="571"/>
                            </a:lnTo>
                            <a:lnTo>
                              <a:pt x="215" y="571"/>
                            </a:lnTo>
                            <a:lnTo>
                              <a:pt x="222" y="577"/>
                            </a:lnTo>
                            <a:lnTo>
                              <a:pt x="228" y="584"/>
                            </a:lnTo>
                            <a:lnTo>
                              <a:pt x="234" y="584"/>
                            </a:lnTo>
                            <a:lnTo>
                              <a:pt x="240" y="590"/>
                            </a:lnTo>
                            <a:lnTo>
                              <a:pt x="246" y="590"/>
                            </a:lnTo>
                            <a:lnTo>
                              <a:pt x="252" y="590"/>
                            </a:lnTo>
                            <a:lnTo>
                              <a:pt x="252" y="596"/>
                            </a:lnTo>
                            <a:lnTo>
                              <a:pt x="258" y="590"/>
                            </a:lnTo>
                            <a:lnTo>
                              <a:pt x="265" y="577"/>
                            </a:lnTo>
                            <a:lnTo>
                              <a:pt x="271" y="534"/>
                            </a:lnTo>
                            <a:lnTo>
                              <a:pt x="277" y="461"/>
                            </a:lnTo>
                            <a:lnTo>
                              <a:pt x="283" y="344"/>
                            </a:lnTo>
                            <a:lnTo>
                              <a:pt x="289" y="184"/>
                            </a:lnTo>
                            <a:lnTo>
                              <a:pt x="289" y="55"/>
                            </a:lnTo>
                            <a:lnTo>
                              <a:pt x="295" y="0"/>
                            </a:lnTo>
                            <a:lnTo>
                              <a:pt x="301" y="24"/>
                            </a:lnTo>
                            <a:lnTo>
                              <a:pt x="308" y="116"/>
                            </a:lnTo>
                            <a:lnTo>
                              <a:pt x="314" y="227"/>
                            </a:lnTo>
                            <a:lnTo>
                              <a:pt x="320" y="331"/>
                            </a:lnTo>
                            <a:lnTo>
                              <a:pt x="320" y="393"/>
                            </a:lnTo>
                            <a:lnTo>
                              <a:pt x="326" y="418"/>
                            </a:lnTo>
                            <a:lnTo>
                              <a:pt x="332" y="461"/>
                            </a:lnTo>
                            <a:lnTo>
                              <a:pt x="338" y="504"/>
                            </a:lnTo>
                            <a:lnTo>
                              <a:pt x="345" y="541"/>
                            </a:lnTo>
                            <a:lnTo>
                              <a:pt x="351" y="559"/>
                            </a:lnTo>
                            <a:lnTo>
                              <a:pt x="351" y="577"/>
                            </a:lnTo>
                            <a:lnTo>
                              <a:pt x="357" y="596"/>
                            </a:lnTo>
                            <a:lnTo>
                              <a:pt x="363" y="608"/>
                            </a:lnTo>
                            <a:lnTo>
                              <a:pt x="369" y="620"/>
                            </a:lnTo>
                            <a:lnTo>
                              <a:pt x="375" y="633"/>
                            </a:lnTo>
                            <a:lnTo>
                              <a:pt x="381" y="639"/>
                            </a:lnTo>
                            <a:lnTo>
                              <a:pt x="381" y="645"/>
                            </a:lnTo>
                            <a:lnTo>
                              <a:pt x="388" y="651"/>
                            </a:lnTo>
                            <a:lnTo>
                              <a:pt x="394" y="657"/>
                            </a:lnTo>
                            <a:lnTo>
                              <a:pt x="400" y="663"/>
                            </a:lnTo>
                            <a:lnTo>
                              <a:pt x="406" y="663"/>
                            </a:lnTo>
                            <a:lnTo>
                              <a:pt x="412" y="670"/>
                            </a:lnTo>
                            <a:lnTo>
                              <a:pt x="418" y="676"/>
                            </a:lnTo>
                            <a:lnTo>
                              <a:pt x="424" y="682"/>
                            </a:lnTo>
                            <a:lnTo>
                              <a:pt x="431" y="682"/>
                            </a:lnTo>
                            <a:lnTo>
                              <a:pt x="437" y="688"/>
                            </a:lnTo>
                            <a:lnTo>
                              <a:pt x="443" y="688"/>
                            </a:lnTo>
                            <a:lnTo>
                              <a:pt x="449" y="694"/>
                            </a:lnTo>
                            <a:lnTo>
                              <a:pt x="455" y="700"/>
                            </a:lnTo>
                            <a:lnTo>
                              <a:pt x="461" y="706"/>
                            </a:lnTo>
                            <a:lnTo>
                              <a:pt x="467" y="706"/>
                            </a:lnTo>
                            <a:lnTo>
                              <a:pt x="474" y="713"/>
                            </a:lnTo>
                            <a:lnTo>
                              <a:pt x="480" y="713"/>
                            </a:lnTo>
                            <a:lnTo>
                              <a:pt x="486" y="719"/>
                            </a:lnTo>
                            <a:lnTo>
                              <a:pt x="492" y="719"/>
                            </a:lnTo>
                            <a:lnTo>
                              <a:pt x="498" y="725"/>
                            </a:lnTo>
                            <a:lnTo>
                              <a:pt x="504" y="725"/>
                            </a:lnTo>
                            <a:lnTo>
                              <a:pt x="510" y="731"/>
                            </a:lnTo>
                            <a:lnTo>
                              <a:pt x="517" y="731"/>
                            </a:lnTo>
                            <a:lnTo>
                              <a:pt x="523" y="731"/>
                            </a:lnTo>
                            <a:lnTo>
                              <a:pt x="529" y="737"/>
                            </a:lnTo>
                            <a:lnTo>
                              <a:pt x="535" y="737"/>
                            </a:lnTo>
                            <a:lnTo>
                              <a:pt x="541" y="737"/>
                            </a:lnTo>
                            <a:lnTo>
                              <a:pt x="547" y="737"/>
                            </a:lnTo>
                            <a:lnTo>
                              <a:pt x="547" y="731"/>
                            </a:lnTo>
                            <a:lnTo>
                              <a:pt x="553" y="731"/>
                            </a:lnTo>
                            <a:lnTo>
                              <a:pt x="560" y="731"/>
                            </a:lnTo>
                            <a:lnTo>
                              <a:pt x="566" y="731"/>
                            </a:lnTo>
                            <a:lnTo>
                              <a:pt x="572" y="731"/>
                            </a:lnTo>
                            <a:lnTo>
                              <a:pt x="578" y="731"/>
                            </a:lnTo>
                            <a:lnTo>
                              <a:pt x="584" y="731"/>
                            </a:lnTo>
                            <a:lnTo>
                              <a:pt x="590" y="731"/>
                            </a:lnTo>
                            <a:lnTo>
                              <a:pt x="597" y="737"/>
                            </a:lnTo>
                            <a:lnTo>
                              <a:pt x="603" y="743"/>
                            </a:lnTo>
                            <a:lnTo>
                              <a:pt x="609" y="750"/>
                            </a:lnTo>
                            <a:lnTo>
                              <a:pt x="609" y="756"/>
                            </a:lnTo>
                            <a:lnTo>
                              <a:pt x="615" y="762"/>
                            </a:lnTo>
                            <a:lnTo>
                              <a:pt x="621" y="762"/>
                            </a:lnTo>
                            <a:lnTo>
                              <a:pt x="627" y="768"/>
                            </a:lnTo>
                            <a:lnTo>
                              <a:pt x="633" y="774"/>
                            </a:lnTo>
                            <a:lnTo>
                              <a:pt x="640" y="786"/>
                            </a:lnTo>
                            <a:lnTo>
                              <a:pt x="640" y="793"/>
                            </a:lnTo>
                            <a:lnTo>
                              <a:pt x="646" y="793"/>
                            </a:lnTo>
                            <a:lnTo>
                              <a:pt x="652" y="799"/>
                            </a:lnTo>
                            <a:lnTo>
                              <a:pt x="658" y="805"/>
                            </a:lnTo>
                            <a:lnTo>
                              <a:pt x="664" y="805"/>
                            </a:lnTo>
                            <a:lnTo>
                              <a:pt x="670" y="811"/>
                            </a:lnTo>
                            <a:lnTo>
                              <a:pt x="676" y="817"/>
                            </a:lnTo>
                            <a:lnTo>
                              <a:pt x="683" y="823"/>
                            </a:lnTo>
                            <a:lnTo>
                              <a:pt x="689" y="823"/>
                            </a:lnTo>
                            <a:lnTo>
                              <a:pt x="695" y="829"/>
                            </a:lnTo>
                            <a:lnTo>
                              <a:pt x="701" y="829"/>
                            </a:lnTo>
                            <a:lnTo>
                              <a:pt x="707" y="836"/>
                            </a:lnTo>
                            <a:lnTo>
                              <a:pt x="713" y="842"/>
                            </a:lnTo>
                            <a:lnTo>
                              <a:pt x="719" y="842"/>
                            </a:lnTo>
                            <a:lnTo>
                              <a:pt x="726" y="848"/>
                            </a:lnTo>
                            <a:lnTo>
                              <a:pt x="732" y="848"/>
                            </a:lnTo>
                            <a:lnTo>
                              <a:pt x="738" y="854"/>
                            </a:lnTo>
                            <a:lnTo>
                              <a:pt x="744" y="860"/>
                            </a:lnTo>
                            <a:lnTo>
                              <a:pt x="750" y="860"/>
                            </a:lnTo>
                            <a:lnTo>
                              <a:pt x="756" y="866"/>
                            </a:lnTo>
                            <a:lnTo>
                              <a:pt x="762" y="866"/>
                            </a:lnTo>
                            <a:lnTo>
                              <a:pt x="769" y="872"/>
                            </a:lnTo>
                            <a:lnTo>
                              <a:pt x="775" y="879"/>
                            </a:lnTo>
                            <a:lnTo>
                              <a:pt x="781" y="879"/>
                            </a:lnTo>
                            <a:lnTo>
                              <a:pt x="787" y="879"/>
                            </a:lnTo>
                            <a:lnTo>
                              <a:pt x="793" y="885"/>
                            </a:lnTo>
                            <a:lnTo>
                              <a:pt x="799" y="885"/>
                            </a:lnTo>
                            <a:lnTo>
                              <a:pt x="806" y="891"/>
                            </a:lnTo>
                            <a:lnTo>
                              <a:pt x="812" y="897"/>
                            </a:lnTo>
                            <a:lnTo>
                              <a:pt x="818" y="897"/>
                            </a:lnTo>
                            <a:lnTo>
                              <a:pt x="824" y="903"/>
                            </a:lnTo>
                            <a:lnTo>
                              <a:pt x="830" y="903"/>
                            </a:lnTo>
                            <a:lnTo>
                              <a:pt x="836" y="903"/>
                            </a:lnTo>
                            <a:lnTo>
                              <a:pt x="836" y="909"/>
                            </a:lnTo>
                            <a:lnTo>
                              <a:pt x="842" y="909"/>
                            </a:lnTo>
                            <a:lnTo>
                              <a:pt x="849" y="915"/>
                            </a:lnTo>
                            <a:lnTo>
                              <a:pt x="855" y="915"/>
                            </a:lnTo>
                            <a:lnTo>
                              <a:pt x="861" y="922"/>
                            </a:lnTo>
                            <a:lnTo>
                              <a:pt x="867" y="922"/>
                            </a:lnTo>
                            <a:lnTo>
                              <a:pt x="867" y="928"/>
                            </a:lnTo>
                            <a:lnTo>
                              <a:pt x="873" y="928"/>
                            </a:lnTo>
                            <a:lnTo>
                              <a:pt x="879" y="934"/>
                            </a:lnTo>
                            <a:lnTo>
                              <a:pt x="885" y="934"/>
                            </a:lnTo>
                            <a:lnTo>
                              <a:pt x="892" y="934"/>
                            </a:lnTo>
                            <a:lnTo>
                              <a:pt x="898" y="940"/>
                            </a:lnTo>
                            <a:lnTo>
                              <a:pt x="904" y="946"/>
                            </a:lnTo>
                            <a:lnTo>
                              <a:pt x="910" y="946"/>
                            </a:lnTo>
                            <a:lnTo>
                              <a:pt x="916" y="952"/>
                            </a:lnTo>
                            <a:lnTo>
                              <a:pt x="922" y="952"/>
                            </a:lnTo>
                            <a:lnTo>
                              <a:pt x="928" y="959"/>
                            </a:lnTo>
                            <a:lnTo>
                              <a:pt x="935" y="959"/>
                            </a:lnTo>
                            <a:lnTo>
                              <a:pt x="935" y="965"/>
                            </a:lnTo>
                            <a:lnTo>
                              <a:pt x="941" y="965"/>
                            </a:lnTo>
                            <a:lnTo>
                              <a:pt x="947" y="965"/>
                            </a:lnTo>
                            <a:lnTo>
                              <a:pt x="953" y="971"/>
                            </a:lnTo>
                            <a:lnTo>
                              <a:pt x="959" y="971"/>
                            </a:lnTo>
                            <a:lnTo>
                              <a:pt x="965" y="977"/>
                            </a:lnTo>
                            <a:lnTo>
                              <a:pt x="971" y="983"/>
                            </a:lnTo>
                            <a:lnTo>
                              <a:pt x="978" y="983"/>
                            </a:lnTo>
                            <a:lnTo>
                              <a:pt x="984" y="989"/>
                            </a:lnTo>
                            <a:lnTo>
                              <a:pt x="990" y="989"/>
                            </a:lnTo>
                            <a:lnTo>
                              <a:pt x="996" y="989"/>
                            </a:lnTo>
                            <a:lnTo>
                              <a:pt x="996" y="995"/>
                            </a:lnTo>
                            <a:lnTo>
                              <a:pt x="1002" y="995"/>
                            </a:lnTo>
                            <a:lnTo>
                              <a:pt x="1008" y="1002"/>
                            </a:lnTo>
                            <a:lnTo>
                              <a:pt x="1015" y="1002"/>
                            </a:lnTo>
                            <a:lnTo>
                              <a:pt x="1021" y="1008"/>
                            </a:lnTo>
                            <a:lnTo>
                              <a:pt x="1027" y="1008"/>
                            </a:lnTo>
                            <a:lnTo>
                              <a:pt x="1027" y="1014"/>
                            </a:lnTo>
                            <a:lnTo>
                              <a:pt x="1033" y="1014"/>
                            </a:lnTo>
                            <a:lnTo>
                              <a:pt x="1039" y="1020"/>
                            </a:lnTo>
                            <a:lnTo>
                              <a:pt x="1045" y="1020"/>
                            </a:lnTo>
                            <a:lnTo>
                              <a:pt x="1051" y="1020"/>
                            </a:lnTo>
                            <a:lnTo>
                              <a:pt x="1058" y="1026"/>
                            </a:lnTo>
                            <a:lnTo>
                              <a:pt x="1064" y="1026"/>
                            </a:lnTo>
                            <a:lnTo>
                              <a:pt x="1064" y="1032"/>
                            </a:lnTo>
                            <a:lnTo>
                              <a:pt x="1070" y="1032"/>
                            </a:lnTo>
                            <a:lnTo>
                              <a:pt x="1076" y="1038"/>
                            </a:lnTo>
                            <a:lnTo>
                              <a:pt x="1082" y="1038"/>
                            </a:lnTo>
                            <a:lnTo>
                              <a:pt x="1088" y="1045"/>
                            </a:lnTo>
                            <a:lnTo>
                              <a:pt x="1094" y="1045"/>
                            </a:lnTo>
                            <a:lnTo>
                              <a:pt x="1101" y="1051"/>
                            </a:lnTo>
                            <a:lnTo>
                              <a:pt x="1107" y="1051"/>
                            </a:lnTo>
                            <a:lnTo>
                              <a:pt x="1113" y="1057"/>
                            </a:lnTo>
                            <a:lnTo>
                              <a:pt x="1119" y="1057"/>
                            </a:lnTo>
                            <a:lnTo>
                              <a:pt x="1125" y="1063"/>
                            </a:lnTo>
                            <a:lnTo>
                              <a:pt x="1131" y="1069"/>
                            </a:lnTo>
                            <a:lnTo>
                              <a:pt x="1137" y="1069"/>
                            </a:lnTo>
                            <a:lnTo>
                              <a:pt x="1144" y="1075"/>
                            </a:lnTo>
                            <a:lnTo>
                              <a:pt x="1150" y="1075"/>
                            </a:lnTo>
                            <a:lnTo>
                              <a:pt x="1156" y="1075"/>
                            </a:lnTo>
                            <a:lnTo>
                              <a:pt x="1156" y="1081"/>
                            </a:lnTo>
                            <a:lnTo>
                              <a:pt x="1162" y="1081"/>
                            </a:lnTo>
                            <a:lnTo>
                              <a:pt x="1168" y="1088"/>
                            </a:lnTo>
                            <a:lnTo>
                              <a:pt x="1174" y="1088"/>
                            </a:lnTo>
                            <a:lnTo>
                              <a:pt x="1180" y="1094"/>
                            </a:lnTo>
                            <a:lnTo>
                              <a:pt x="1187" y="1094"/>
                            </a:lnTo>
                            <a:lnTo>
                              <a:pt x="1193" y="1100"/>
                            </a:lnTo>
                            <a:lnTo>
                              <a:pt x="1199" y="1100"/>
                            </a:lnTo>
                            <a:lnTo>
                              <a:pt x="1205" y="1106"/>
                            </a:lnTo>
                            <a:lnTo>
                              <a:pt x="1211" y="1106"/>
                            </a:lnTo>
                            <a:lnTo>
                              <a:pt x="1217" y="1112"/>
                            </a:lnTo>
                            <a:lnTo>
                              <a:pt x="1223" y="1112"/>
                            </a:lnTo>
                            <a:lnTo>
                              <a:pt x="1223" y="1118"/>
                            </a:lnTo>
                            <a:lnTo>
                              <a:pt x="1230" y="1118"/>
                            </a:lnTo>
                            <a:lnTo>
                              <a:pt x="1236" y="1124"/>
                            </a:lnTo>
                            <a:lnTo>
                              <a:pt x="1242" y="1124"/>
                            </a:lnTo>
                            <a:lnTo>
                              <a:pt x="1248" y="1131"/>
                            </a:lnTo>
                            <a:lnTo>
                              <a:pt x="1254" y="1131"/>
                            </a:lnTo>
                            <a:lnTo>
                              <a:pt x="1260" y="1137"/>
                            </a:lnTo>
                            <a:lnTo>
                              <a:pt x="1267" y="1137"/>
                            </a:lnTo>
                            <a:lnTo>
                              <a:pt x="1273" y="1143"/>
                            </a:lnTo>
                            <a:lnTo>
                              <a:pt x="1279" y="1143"/>
                            </a:lnTo>
                            <a:lnTo>
                              <a:pt x="1285" y="1149"/>
                            </a:lnTo>
                            <a:lnTo>
                              <a:pt x="1291" y="1155"/>
                            </a:lnTo>
                            <a:lnTo>
                              <a:pt x="1297" y="1155"/>
                            </a:lnTo>
                            <a:lnTo>
                              <a:pt x="1303" y="1155"/>
                            </a:lnTo>
                            <a:lnTo>
                              <a:pt x="1310" y="1161"/>
                            </a:lnTo>
                            <a:lnTo>
                              <a:pt x="1316" y="1161"/>
                            </a:lnTo>
                          </a:path>
                        </a:pathLst>
                      </a:custGeom>
                      <a:noFill/>
                      <a:ln w="9360">
                        <a:solidFill>
                          <a:srgbClr val="ff0000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</p:grpSp>
            <p:grpSp>
              <p:nvGrpSpPr>
                <p:cNvPr id="187" name="Group 541"/>
                <p:cNvGrpSpPr/>
                <p:nvPr/>
              </p:nvGrpSpPr>
              <p:grpSpPr>
                <a:xfrm>
                  <a:off x="2622960" y="3203640"/>
                  <a:ext cx="1308960" cy="482400"/>
                  <a:chOff x="2622960" y="3203640"/>
                  <a:chExt cx="1308960" cy="482400"/>
                </a:xfrm>
              </p:grpSpPr>
              <p:sp>
                <p:nvSpPr>
                  <p:cNvPr id="188" name="Rectangle 162"/>
                  <p:cNvSpPr/>
                  <p:nvPr/>
                </p:nvSpPr>
                <p:spPr>
                  <a:xfrm>
                    <a:off x="2622960" y="3547440"/>
                    <a:ext cx="155880" cy="138600"/>
                  </a:xfrm>
                  <a:prstGeom prst="rect">
                    <a:avLst/>
                  </a:prstGeom>
                  <a:solidFill>
                    <a:srgbClr val="00ff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9" name="Rectangle 165"/>
                  <p:cNvSpPr/>
                  <p:nvPr/>
                </p:nvSpPr>
                <p:spPr>
                  <a:xfrm>
                    <a:off x="3000240" y="3547440"/>
                    <a:ext cx="8938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800" spc="-1" strike="noStrike">
                        <a:solidFill>
                          <a:srgbClr val="000000"/>
                        </a:solidFill>
                        <a:latin typeface="Arial"/>
                      </a:rPr>
                      <a:t>Drug dose 50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µ</a:t>
                    </a:r>
                    <a:r>
                      <a:rPr b="0" lang="en-GB" sz="800" spc="-1" strike="noStrike">
                        <a:solidFill>
                          <a:srgbClr val="000000"/>
                        </a:solidFill>
                        <a:latin typeface="Arial"/>
                      </a:rPr>
                      <a:t>g/ml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0" name="Rectangle 167"/>
                  <p:cNvSpPr/>
                  <p:nvPr/>
                </p:nvSpPr>
                <p:spPr>
                  <a:xfrm>
                    <a:off x="2622960" y="3378240"/>
                    <a:ext cx="155880" cy="138600"/>
                  </a:xfrm>
                  <a:prstGeom prst="rect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1" name="Rectangle 170"/>
                  <p:cNvSpPr/>
                  <p:nvPr/>
                </p:nvSpPr>
                <p:spPr>
                  <a:xfrm>
                    <a:off x="3000240" y="3378240"/>
                    <a:ext cx="8938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800" spc="-1" strike="noStrike">
                        <a:solidFill>
                          <a:srgbClr val="000000"/>
                        </a:solidFill>
                        <a:latin typeface="Arial"/>
                      </a:rPr>
                      <a:t>Drug dose 10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µg/ml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Rectangle 172"/>
                  <p:cNvSpPr/>
                  <p:nvPr/>
                </p:nvSpPr>
                <p:spPr>
                  <a:xfrm>
                    <a:off x="2622960" y="3206880"/>
                    <a:ext cx="155880" cy="139320"/>
                  </a:xfrm>
                  <a:prstGeom prst="rect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3" name="Rectangle 175"/>
                  <p:cNvSpPr/>
                  <p:nvPr/>
                </p:nvSpPr>
                <p:spPr>
                  <a:xfrm>
                    <a:off x="3004560" y="3203640"/>
                    <a:ext cx="9273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800" spc="-1" strike="noStrike">
                        <a:solidFill>
                          <a:srgbClr val="000000"/>
                        </a:solidFill>
                        <a:latin typeface="Arial"/>
                      </a:rPr>
                      <a:t>Mock treated control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94" name="Text Box 485"/>
                <p:cNvSpPr/>
                <p:nvPr/>
              </p:nvSpPr>
              <p:spPr>
                <a:xfrm>
                  <a:off x="1759320" y="3293640"/>
                  <a:ext cx="3812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6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5" name="Group 321"/>
              <p:cNvGrpSpPr/>
              <p:nvPr/>
            </p:nvGrpSpPr>
            <p:grpSpPr>
              <a:xfrm>
                <a:off x="1557360" y="5942880"/>
                <a:ext cx="2199240" cy="2376000"/>
                <a:chOff x="1557360" y="5942880"/>
                <a:chExt cx="2199240" cy="2376000"/>
              </a:xfrm>
            </p:grpSpPr>
            <p:sp>
              <p:nvSpPr>
                <p:cNvPr id="196" name="Text Box 491"/>
                <p:cNvSpPr/>
                <p:nvPr/>
              </p:nvSpPr>
              <p:spPr>
                <a:xfrm>
                  <a:off x="1759320" y="5942880"/>
                  <a:ext cx="3812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6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97" name="Group 317"/>
                <p:cNvGrpSpPr/>
                <p:nvPr/>
              </p:nvGrpSpPr>
              <p:grpSpPr>
                <a:xfrm>
                  <a:off x="1557360" y="5942880"/>
                  <a:ext cx="2199240" cy="2376000"/>
                  <a:chOff x="1557360" y="5942880"/>
                  <a:chExt cx="2199240" cy="2376000"/>
                </a:xfrm>
              </p:grpSpPr>
              <p:pic>
                <p:nvPicPr>
                  <p:cNvPr id="198" name="Picture 478" descr=""/>
                  <p:cNvPicPr/>
                  <p:nvPr/>
                </p:nvPicPr>
                <p:blipFill>
                  <a:blip r:embed="rId1"/>
                  <a:srcRect l="3522" t="46885" r="21465" b="0"/>
                  <a:stretch/>
                </p:blipFill>
                <p:spPr>
                  <a:xfrm>
                    <a:off x="1687680" y="6279120"/>
                    <a:ext cx="1971720" cy="1917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199" name="Rectangle 493"/>
                  <p:cNvSpPr/>
                  <p:nvPr/>
                </p:nvSpPr>
                <p:spPr>
                  <a:xfrm>
                    <a:off x="1700280" y="6407280"/>
                    <a:ext cx="1956960" cy="1278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Text Box 508"/>
                  <p:cNvSpPr/>
                  <p:nvPr/>
                </p:nvSpPr>
                <p:spPr>
                  <a:xfrm rot="16200000">
                    <a:off x="1174320" y="6915960"/>
                    <a:ext cx="981360" cy="21564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800" spc="-1" strike="noStrike">
                        <a:solidFill>
                          <a:srgbClr val="000000"/>
                        </a:solidFill>
                        <a:latin typeface="Arial"/>
                      </a:rPr>
                      <a:t>Cell cycle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1" name="Rectangle 514"/>
                  <p:cNvSpPr/>
                  <p:nvPr/>
                </p:nvSpPr>
                <p:spPr>
                  <a:xfrm rot="19341000">
                    <a:off x="1557360" y="7854480"/>
                    <a:ext cx="574920" cy="846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7800" bIns="37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2" name="Rectangle 515"/>
                  <p:cNvSpPr/>
                  <p:nvPr/>
                </p:nvSpPr>
                <p:spPr>
                  <a:xfrm rot="18754200">
                    <a:off x="1856880" y="7810200"/>
                    <a:ext cx="513000" cy="1429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Rectangle 516"/>
                  <p:cNvSpPr/>
                  <p:nvPr/>
                </p:nvSpPr>
                <p:spPr>
                  <a:xfrm rot="19341000">
                    <a:off x="2955960" y="7807680"/>
                    <a:ext cx="574920" cy="1296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4" name="Rectangle 517"/>
                  <p:cNvSpPr/>
                  <p:nvPr/>
                </p:nvSpPr>
                <p:spPr>
                  <a:xfrm rot="19341000">
                    <a:off x="2463120" y="7854480"/>
                    <a:ext cx="574920" cy="846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7800" bIns="37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5" name="Rectangle 518"/>
                  <p:cNvSpPr/>
                  <p:nvPr/>
                </p:nvSpPr>
                <p:spPr>
                  <a:xfrm rot="19341000">
                    <a:off x="2718000" y="7809480"/>
                    <a:ext cx="574920" cy="1278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Rectangle 520"/>
                  <p:cNvSpPr/>
                  <p:nvPr/>
                </p:nvSpPr>
                <p:spPr>
                  <a:xfrm rot="19341000">
                    <a:off x="1795320" y="8067240"/>
                    <a:ext cx="574920" cy="846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7800" bIns="37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7" name="Rectangle 521"/>
                  <p:cNvSpPr/>
                  <p:nvPr/>
                </p:nvSpPr>
                <p:spPr>
                  <a:xfrm rot="19341000">
                    <a:off x="2049840" y="7807680"/>
                    <a:ext cx="574920" cy="1296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8" name="Text Box 511"/>
                  <p:cNvSpPr/>
                  <p:nvPr/>
                </p:nvSpPr>
                <p:spPr>
                  <a:xfrm>
                    <a:off x="1940760" y="7772400"/>
                    <a:ext cx="1719000" cy="40068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800" spc="-1" strike="noStrike">
                        <a:solidFill>
                          <a:srgbClr val="000000"/>
                        </a:solidFill>
                        <a:latin typeface="Arial"/>
                      </a:rPr>
                      <a:t>Drug dose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µg/ml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9" name="Text Box 522"/>
                  <p:cNvSpPr/>
                  <p:nvPr/>
                </p:nvSpPr>
                <p:spPr>
                  <a:xfrm>
                    <a:off x="1986840" y="6664680"/>
                    <a:ext cx="76248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800" spc="-1" strike="noStrike">
                        <a:solidFill>
                          <a:srgbClr val="000000"/>
                        </a:solidFill>
                        <a:latin typeface="Arial"/>
                      </a:rPr>
                      <a:t>6 hours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0" name="Text Box 525"/>
                  <p:cNvSpPr/>
                  <p:nvPr/>
                </p:nvSpPr>
                <p:spPr>
                  <a:xfrm>
                    <a:off x="2848680" y="6664680"/>
                    <a:ext cx="9079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800" spc="-1" strike="noStrike">
                        <a:solidFill>
                          <a:srgbClr val="000000"/>
                        </a:solidFill>
                        <a:latin typeface="Arial"/>
                      </a:rPr>
                      <a:t>24 hours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11" name="Group 542"/>
                  <p:cNvGrpSpPr/>
                  <p:nvPr/>
                </p:nvGrpSpPr>
                <p:grpSpPr>
                  <a:xfrm>
                    <a:off x="2418840" y="5942880"/>
                    <a:ext cx="768600" cy="471240"/>
                    <a:chOff x="2418840" y="5942880"/>
                    <a:chExt cx="768600" cy="471240"/>
                  </a:xfrm>
                </p:grpSpPr>
                <p:sp>
                  <p:nvSpPr>
                    <p:cNvPr id="212" name="Rectangle 530"/>
                    <p:cNvSpPr/>
                    <p:nvPr/>
                  </p:nvSpPr>
                  <p:spPr>
                    <a:xfrm>
                      <a:off x="2418840" y="6002640"/>
                      <a:ext cx="142920" cy="10728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3" name="Rectangle 531"/>
                    <p:cNvSpPr/>
                    <p:nvPr/>
                  </p:nvSpPr>
                  <p:spPr>
                    <a:xfrm>
                      <a:off x="2418840" y="6130800"/>
                      <a:ext cx="142920" cy="107280"/>
                    </a:xfrm>
                    <a:prstGeom prst="rect">
                      <a:avLst/>
                    </a:prstGeom>
                    <a:solidFill>
                      <a:srgbClr val="dddddd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4" name="Rectangle 532"/>
                    <p:cNvSpPr/>
                    <p:nvPr/>
                  </p:nvSpPr>
                  <p:spPr>
                    <a:xfrm>
                      <a:off x="2418840" y="6258600"/>
                      <a:ext cx="142920" cy="107280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5" name="Text Box 533"/>
                    <p:cNvSpPr/>
                    <p:nvPr/>
                  </p:nvSpPr>
                  <p:spPr>
                    <a:xfrm>
                      <a:off x="2467440" y="5942880"/>
                      <a:ext cx="7200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 G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6" name="Text Box 534"/>
                    <p:cNvSpPr/>
                    <p:nvPr/>
                  </p:nvSpPr>
                  <p:spPr>
                    <a:xfrm>
                      <a:off x="2418840" y="6070680"/>
                      <a:ext cx="7200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 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7" name="Text Box 535"/>
                    <p:cNvSpPr/>
                    <p:nvPr/>
                  </p:nvSpPr>
                  <p:spPr>
                    <a:xfrm>
                      <a:off x="2467440" y="6198480"/>
                      <a:ext cx="7200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 G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</p:grpSp>
        <p:sp>
          <p:nvSpPr>
            <p:cNvPr id="218" name="Text Box 522"/>
            <p:cNvSpPr/>
            <p:nvPr/>
          </p:nvSpPr>
          <p:spPr>
            <a:xfrm>
              <a:off x="1654200" y="4968720"/>
              <a:ext cx="76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6 hou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 Box 525"/>
            <p:cNvSpPr/>
            <p:nvPr/>
          </p:nvSpPr>
          <p:spPr>
            <a:xfrm>
              <a:off x="3852000" y="4970520"/>
              <a:ext cx="90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4 hou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0" name="PlaceHolder 1"/>
          <p:cNvSpPr>
            <a:spLocks noGrp="1"/>
          </p:cNvSpPr>
          <p:nvPr>
            <p:ph type="title"/>
          </p:nvPr>
        </p:nvSpPr>
        <p:spPr>
          <a:xfrm>
            <a:off x="333360" y="286920"/>
            <a:ext cx="5688000" cy="79236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2000"/>
            </a:b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Additional File 2: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Cell cycle analysis of adult human skin fibroblasts after treatment with bleomycin sulphate</a:t>
            </a:r>
            <a:br>
              <a:rPr sz="1000"/>
            </a:b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2"/>
          <p:cNvSpPr>
            <a:spLocks noGrp="1"/>
          </p:cNvSpPr>
          <p:nvPr>
            <p:ph/>
          </p:nvPr>
        </p:nvSpPr>
        <p:spPr>
          <a:xfrm>
            <a:off x="404280" y="971640"/>
            <a:ext cx="5688360" cy="1836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Fibroblasts were plated at a density of 2 x 10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cells in a T25 cm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flask and treated after 1 day in culture with medium alone (control), or with 10 μg/ml or 50 μg/ml bleomycin sulphate for 6 hours or 24 hours as indicated. After 4 days in culture, cells were stained with propidium iodide and analysed by fluorescence activated cell sorting (FACS); a) representative FACS profiles, b) the percentage of cells in each phase of the cell cycle determined using the Watson Pragmatic model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Both doses resulted in accumulation of fibroblasts with 4N-DNA content and therefore the lower dose (10 µg/ml, 6 hours) was used for the treatment of all the experimental sampl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25T09:47:26Z</dcterms:created>
  <dc:creator>localadmin</dc:creator>
  <dc:description/>
  <dc:language>en-US</dc:language>
  <cp:lastModifiedBy>rmgzcbw</cp:lastModifiedBy>
  <dcterms:modified xsi:type="dcterms:W3CDTF">2011-02-15T10:11:25Z</dcterms:modified>
  <cp:revision>26</cp:revision>
  <dc:subject/>
  <dc:title>Slide 1</dc:title>
</cp:coreProperties>
</file>